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2496" y="-1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48B4A4-DAFE-448A-B694-B0838980386A}" type="datetimeFigureOut">
              <a:rPr lang="fr-CH" smtClean="0"/>
              <a:t>10.10.19</a:t>
            </a:fld>
            <a:endParaRPr lang="fr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DD5CE7-A097-4BA5-AE5D-C286992FB25A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46353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DD5CE7-A097-4BA5-AE5D-C286992FB25A}" type="slidenum">
              <a:rPr lang="fr-CH" smtClean="0"/>
              <a:t>1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81869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50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134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384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155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38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247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066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759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08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932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201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398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tiff"/><Relationship Id="rId12" Type="http://schemas.openxmlformats.org/officeDocument/2006/relationships/image" Target="../media/image10.tiff"/><Relationship Id="rId13" Type="http://schemas.openxmlformats.org/officeDocument/2006/relationships/image" Target="../media/image11.tiff"/><Relationship Id="rId14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f"/><Relationship Id="rId7" Type="http://schemas.openxmlformats.org/officeDocument/2006/relationships/image" Target="../media/image5.tiff"/><Relationship Id="rId8" Type="http://schemas.openxmlformats.org/officeDocument/2006/relationships/image" Target="../media/image6.tiff"/><Relationship Id="rId9" Type="http://schemas.openxmlformats.org/officeDocument/2006/relationships/image" Target="../media/image7.tiff"/><Relationship Id="rId10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4523" y="1998124"/>
            <a:ext cx="1594056" cy="1135806"/>
          </a:xfrm>
          <a:prstGeom prst="rect">
            <a:avLst/>
          </a:prstGeom>
        </p:spPr>
      </p:pic>
      <p:sp>
        <p:nvSpPr>
          <p:cNvPr id="65" name="Rectangle 64"/>
          <p:cNvSpPr/>
          <p:nvPr/>
        </p:nvSpPr>
        <p:spPr>
          <a:xfrm>
            <a:off x="4417848" y="3037836"/>
            <a:ext cx="185214" cy="7504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9" name="Straight Connector 38"/>
          <p:cNvCxnSpPr/>
          <p:nvPr/>
        </p:nvCxnSpPr>
        <p:spPr>
          <a:xfrm>
            <a:off x="4428905" y="3089573"/>
            <a:ext cx="169747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63" name="Group 62"/>
          <p:cNvGrpSpPr/>
          <p:nvPr/>
        </p:nvGrpSpPr>
        <p:grpSpPr>
          <a:xfrm>
            <a:off x="3064523" y="6991470"/>
            <a:ext cx="1594057" cy="1119943"/>
            <a:chOff x="3678122" y="7576314"/>
            <a:chExt cx="1594057" cy="1119943"/>
          </a:xfrm>
        </p:grpSpPr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3" r="31141" b="16816"/>
            <a:stretch/>
          </p:blipFill>
          <p:spPr>
            <a:xfrm>
              <a:off x="3678122" y="7576314"/>
              <a:ext cx="1594057" cy="1119943"/>
            </a:xfrm>
            <a:prstGeom prst="rect">
              <a:avLst/>
            </a:prstGeom>
          </p:spPr>
        </p:pic>
        <p:sp>
          <p:nvSpPr>
            <p:cNvPr id="58" name="Rectangle 57"/>
            <p:cNvSpPr/>
            <p:nvPr/>
          </p:nvSpPr>
          <p:spPr>
            <a:xfrm>
              <a:off x="3689566" y="7612034"/>
              <a:ext cx="379555" cy="1193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" name="Rectangle 38"/>
          <p:cNvSpPr>
            <a:spLocks noChangeArrowheads="1"/>
          </p:cNvSpPr>
          <p:nvPr/>
        </p:nvSpPr>
        <p:spPr bwMode="auto">
          <a:xfrm>
            <a:off x="343564" y="381000"/>
            <a:ext cx="74396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S4</a:t>
            </a:r>
            <a:r>
              <a:rPr kumimoji="0" lang="en-US" sz="1200" b="1" i="0" u="none" strike="noStrike" cap="none" normalizeH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Figure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6" name="Rectangle 38"/>
          <p:cNvSpPr>
            <a:spLocks noChangeArrowheads="1"/>
          </p:cNvSpPr>
          <p:nvPr/>
        </p:nvSpPr>
        <p:spPr bwMode="auto">
          <a:xfrm>
            <a:off x="343564" y="5651327"/>
            <a:ext cx="11113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C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16" name="Rectangle 38"/>
          <p:cNvSpPr>
            <a:spLocks noChangeArrowheads="1"/>
          </p:cNvSpPr>
          <p:nvPr/>
        </p:nvSpPr>
        <p:spPr bwMode="auto">
          <a:xfrm>
            <a:off x="343564" y="567918"/>
            <a:ext cx="1481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A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4523" y="826061"/>
            <a:ext cx="1594056" cy="1135806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527" y="826060"/>
            <a:ext cx="1594056" cy="1135806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527" y="1998124"/>
            <a:ext cx="1594056" cy="1135806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89" t="24568" r="35283" b="36124"/>
          <a:stretch/>
        </p:blipFill>
        <p:spPr>
          <a:xfrm>
            <a:off x="1425740" y="4517027"/>
            <a:ext cx="1590843" cy="1116111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6" t="31456" r="33980" b="24564"/>
          <a:stretch/>
        </p:blipFill>
        <p:spPr>
          <a:xfrm>
            <a:off x="3064524" y="3341483"/>
            <a:ext cx="1594056" cy="1116110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8" t="31183" r="34845" b="24837"/>
          <a:stretch/>
        </p:blipFill>
        <p:spPr>
          <a:xfrm>
            <a:off x="1425740" y="3341481"/>
            <a:ext cx="1590843" cy="1116111"/>
          </a:xfrm>
          <a:prstGeom prst="rect">
            <a:avLst/>
          </a:prstGeom>
        </p:spPr>
      </p:pic>
      <p:grpSp>
        <p:nvGrpSpPr>
          <p:cNvPr id="24" name="Group 23"/>
          <p:cNvGrpSpPr/>
          <p:nvPr/>
        </p:nvGrpSpPr>
        <p:grpSpPr>
          <a:xfrm>
            <a:off x="3064523" y="4517028"/>
            <a:ext cx="1594057" cy="1121210"/>
            <a:chOff x="3474289" y="4935962"/>
            <a:chExt cx="1409994" cy="991746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44" t="25068" r="34514" b="35445"/>
            <a:stretch/>
          </p:blipFill>
          <p:spPr>
            <a:xfrm>
              <a:off x="3474289" y="4935962"/>
              <a:ext cx="1409994" cy="991746"/>
            </a:xfrm>
            <a:prstGeom prst="rect">
              <a:avLst/>
            </a:prstGeom>
          </p:spPr>
        </p:pic>
        <p:cxnSp>
          <p:nvCxnSpPr>
            <p:cNvPr id="32" name="Straight Connector 31"/>
            <p:cNvCxnSpPr/>
            <p:nvPr/>
          </p:nvCxnSpPr>
          <p:spPr>
            <a:xfrm>
              <a:off x="4575637" y="5880030"/>
              <a:ext cx="259538" cy="0"/>
            </a:xfrm>
            <a:prstGeom prst="line">
              <a:avLst/>
            </a:prstGeom>
            <a:ln w="19050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TextBox 32"/>
          <p:cNvSpPr txBox="1"/>
          <p:nvPr/>
        </p:nvSpPr>
        <p:spPr>
          <a:xfrm>
            <a:off x="4150758" y="5358050"/>
            <a:ext cx="6727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329697" y="597905"/>
            <a:ext cx="936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3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2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970592" y="597905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38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22848" y="752584"/>
            <a:ext cx="1014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F anti-IL-3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147074" y="2868746"/>
            <a:ext cx="5581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fr-CH" sz="1000" dirty="0" smtClean="0">
                <a:solidFill>
                  <a:schemeClr val="bg1"/>
                </a:solidFill>
              </a:rPr>
              <a:t>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38"/>
          <p:cNvSpPr>
            <a:spLocks noChangeArrowheads="1"/>
          </p:cNvSpPr>
          <p:nvPr/>
        </p:nvSpPr>
        <p:spPr bwMode="auto">
          <a:xfrm>
            <a:off x="343564" y="3162110"/>
            <a:ext cx="11113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B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22848" y="1942900"/>
            <a:ext cx="11769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</a:p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22848" y="3286258"/>
            <a:ext cx="1014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F anti-IL-3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22848" y="4452793"/>
            <a:ext cx="11084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F anti-IL38 &amp;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c IL-3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22848" y="5781886"/>
            <a:ext cx="1014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F anti-IL-3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22848" y="6931534"/>
            <a:ext cx="11769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</a:p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166510" y="7845540"/>
            <a:ext cx="6727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" name="Group 59"/>
          <p:cNvGrpSpPr/>
          <p:nvPr/>
        </p:nvGrpSpPr>
        <p:grpSpPr>
          <a:xfrm>
            <a:off x="1419104" y="5835993"/>
            <a:ext cx="1597479" cy="1116110"/>
            <a:chOff x="1560853" y="6326267"/>
            <a:chExt cx="1597479" cy="1116110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51" r="8216"/>
            <a:stretch/>
          </p:blipFill>
          <p:spPr>
            <a:xfrm>
              <a:off x="1560853" y="6326267"/>
              <a:ext cx="1597479" cy="1116110"/>
            </a:xfrm>
            <a:prstGeom prst="rect">
              <a:avLst/>
            </a:prstGeom>
          </p:spPr>
        </p:pic>
        <p:sp>
          <p:nvSpPr>
            <p:cNvPr id="31" name="Rectangle 30"/>
            <p:cNvSpPr/>
            <p:nvPr/>
          </p:nvSpPr>
          <p:spPr>
            <a:xfrm>
              <a:off x="1575357" y="6389991"/>
              <a:ext cx="373855" cy="1193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3064537" y="5835990"/>
            <a:ext cx="1594061" cy="2234442"/>
            <a:chOff x="3678137" y="6326264"/>
            <a:chExt cx="1594061" cy="2234442"/>
          </a:xfrm>
        </p:grpSpPr>
        <p:grpSp>
          <p:nvGrpSpPr>
            <p:cNvPr id="30" name="Group 29"/>
            <p:cNvGrpSpPr/>
            <p:nvPr/>
          </p:nvGrpSpPr>
          <p:grpSpPr>
            <a:xfrm>
              <a:off x="3678137" y="6326264"/>
              <a:ext cx="1594061" cy="2234442"/>
              <a:chOff x="3684839" y="7324569"/>
              <a:chExt cx="1737347" cy="2435299"/>
            </a:xfrm>
          </p:grpSpPr>
          <p:pic>
            <p:nvPicPr>
              <p:cNvPr id="46" name="Picture 45"/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18" r="8039"/>
              <a:stretch/>
            </p:blipFill>
            <p:spPr>
              <a:xfrm>
                <a:off x="3684839" y="7324569"/>
                <a:ext cx="1737347" cy="1216438"/>
              </a:xfrm>
              <a:prstGeom prst="rect">
                <a:avLst/>
              </a:prstGeom>
            </p:spPr>
          </p:pic>
          <p:cxnSp>
            <p:nvCxnSpPr>
              <p:cNvPr id="55" name="Straight Connector 54"/>
              <p:cNvCxnSpPr/>
              <p:nvPr/>
            </p:nvCxnSpPr>
            <p:spPr>
              <a:xfrm>
                <a:off x="5036304" y="9759868"/>
                <a:ext cx="342673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7" name="Rectangle 56"/>
            <p:cNvSpPr/>
            <p:nvPr/>
          </p:nvSpPr>
          <p:spPr>
            <a:xfrm>
              <a:off x="3689696" y="6346573"/>
              <a:ext cx="342070" cy="1193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1419105" y="6991469"/>
            <a:ext cx="1597478" cy="1117821"/>
            <a:chOff x="1560854" y="7576313"/>
            <a:chExt cx="1597478" cy="1117821"/>
          </a:xfrm>
        </p:grpSpPr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9" r="31273" b="16974"/>
            <a:stretch/>
          </p:blipFill>
          <p:spPr>
            <a:xfrm>
              <a:off x="1560854" y="7576313"/>
              <a:ext cx="1597478" cy="1117821"/>
            </a:xfrm>
            <a:prstGeom prst="rect">
              <a:avLst/>
            </a:prstGeom>
          </p:spPr>
        </p:pic>
        <p:sp>
          <p:nvSpPr>
            <p:cNvPr id="59" name="Rectangle 58"/>
            <p:cNvSpPr/>
            <p:nvPr/>
          </p:nvSpPr>
          <p:spPr>
            <a:xfrm>
              <a:off x="1571979" y="7612034"/>
              <a:ext cx="341313" cy="1193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Freeform 2"/>
          <p:cNvSpPr/>
          <p:nvPr/>
        </p:nvSpPr>
        <p:spPr>
          <a:xfrm>
            <a:off x="1425575" y="6102350"/>
            <a:ext cx="1587500" cy="812800"/>
          </a:xfrm>
          <a:custGeom>
            <a:avLst/>
            <a:gdLst>
              <a:gd name="connsiteX0" fmla="*/ 0 w 1587500"/>
              <a:gd name="connsiteY0" fmla="*/ 812800 h 812800"/>
              <a:gd name="connsiteX1" fmla="*/ 9525 w 1587500"/>
              <a:gd name="connsiteY1" fmla="*/ 796925 h 812800"/>
              <a:gd name="connsiteX2" fmla="*/ 19050 w 1587500"/>
              <a:gd name="connsiteY2" fmla="*/ 790575 h 812800"/>
              <a:gd name="connsiteX3" fmla="*/ 34925 w 1587500"/>
              <a:gd name="connsiteY3" fmla="*/ 762000 h 812800"/>
              <a:gd name="connsiteX4" fmla="*/ 44450 w 1587500"/>
              <a:gd name="connsiteY4" fmla="*/ 755650 h 812800"/>
              <a:gd name="connsiteX5" fmla="*/ 63500 w 1587500"/>
              <a:gd name="connsiteY5" fmla="*/ 749300 h 812800"/>
              <a:gd name="connsiteX6" fmla="*/ 73025 w 1587500"/>
              <a:gd name="connsiteY6" fmla="*/ 746125 h 812800"/>
              <a:gd name="connsiteX7" fmla="*/ 82550 w 1587500"/>
              <a:gd name="connsiteY7" fmla="*/ 742950 h 812800"/>
              <a:gd name="connsiteX8" fmla="*/ 95250 w 1587500"/>
              <a:gd name="connsiteY8" fmla="*/ 739775 h 812800"/>
              <a:gd name="connsiteX9" fmla="*/ 123825 w 1587500"/>
              <a:gd name="connsiteY9" fmla="*/ 723900 h 812800"/>
              <a:gd name="connsiteX10" fmla="*/ 133350 w 1587500"/>
              <a:gd name="connsiteY10" fmla="*/ 717550 h 812800"/>
              <a:gd name="connsiteX11" fmla="*/ 142875 w 1587500"/>
              <a:gd name="connsiteY11" fmla="*/ 711200 h 812800"/>
              <a:gd name="connsiteX12" fmla="*/ 149225 w 1587500"/>
              <a:gd name="connsiteY12" fmla="*/ 701675 h 812800"/>
              <a:gd name="connsiteX13" fmla="*/ 155575 w 1587500"/>
              <a:gd name="connsiteY13" fmla="*/ 676275 h 812800"/>
              <a:gd name="connsiteX14" fmla="*/ 152400 w 1587500"/>
              <a:gd name="connsiteY14" fmla="*/ 647700 h 812800"/>
              <a:gd name="connsiteX15" fmla="*/ 146050 w 1587500"/>
              <a:gd name="connsiteY15" fmla="*/ 615950 h 812800"/>
              <a:gd name="connsiteX16" fmla="*/ 149225 w 1587500"/>
              <a:gd name="connsiteY16" fmla="*/ 584200 h 812800"/>
              <a:gd name="connsiteX17" fmla="*/ 155575 w 1587500"/>
              <a:gd name="connsiteY17" fmla="*/ 574675 h 812800"/>
              <a:gd name="connsiteX18" fmla="*/ 168275 w 1587500"/>
              <a:gd name="connsiteY18" fmla="*/ 546100 h 812800"/>
              <a:gd name="connsiteX19" fmla="*/ 177800 w 1587500"/>
              <a:gd name="connsiteY19" fmla="*/ 539750 h 812800"/>
              <a:gd name="connsiteX20" fmla="*/ 180975 w 1587500"/>
              <a:gd name="connsiteY20" fmla="*/ 530225 h 812800"/>
              <a:gd name="connsiteX21" fmla="*/ 200025 w 1587500"/>
              <a:gd name="connsiteY21" fmla="*/ 517525 h 812800"/>
              <a:gd name="connsiteX22" fmla="*/ 219075 w 1587500"/>
              <a:gd name="connsiteY22" fmla="*/ 479425 h 812800"/>
              <a:gd name="connsiteX23" fmla="*/ 225425 w 1587500"/>
              <a:gd name="connsiteY23" fmla="*/ 469900 h 812800"/>
              <a:gd name="connsiteX24" fmla="*/ 231775 w 1587500"/>
              <a:gd name="connsiteY24" fmla="*/ 460375 h 812800"/>
              <a:gd name="connsiteX25" fmla="*/ 250825 w 1587500"/>
              <a:gd name="connsiteY25" fmla="*/ 450850 h 812800"/>
              <a:gd name="connsiteX26" fmla="*/ 260350 w 1587500"/>
              <a:gd name="connsiteY26" fmla="*/ 419100 h 812800"/>
              <a:gd name="connsiteX27" fmla="*/ 263525 w 1587500"/>
              <a:gd name="connsiteY27" fmla="*/ 403225 h 812800"/>
              <a:gd name="connsiteX28" fmla="*/ 266700 w 1587500"/>
              <a:gd name="connsiteY28" fmla="*/ 393700 h 812800"/>
              <a:gd name="connsiteX29" fmla="*/ 285750 w 1587500"/>
              <a:gd name="connsiteY29" fmla="*/ 381000 h 812800"/>
              <a:gd name="connsiteX30" fmla="*/ 307975 w 1587500"/>
              <a:gd name="connsiteY30" fmla="*/ 355600 h 812800"/>
              <a:gd name="connsiteX31" fmla="*/ 333375 w 1587500"/>
              <a:gd name="connsiteY31" fmla="*/ 339725 h 812800"/>
              <a:gd name="connsiteX32" fmla="*/ 342900 w 1587500"/>
              <a:gd name="connsiteY32" fmla="*/ 336550 h 812800"/>
              <a:gd name="connsiteX33" fmla="*/ 352425 w 1587500"/>
              <a:gd name="connsiteY33" fmla="*/ 333375 h 812800"/>
              <a:gd name="connsiteX34" fmla="*/ 358775 w 1587500"/>
              <a:gd name="connsiteY34" fmla="*/ 342900 h 812800"/>
              <a:gd name="connsiteX35" fmla="*/ 374650 w 1587500"/>
              <a:gd name="connsiteY35" fmla="*/ 346075 h 812800"/>
              <a:gd name="connsiteX36" fmla="*/ 422275 w 1587500"/>
              <a:gd name="connsiteY36" fmla="*/ 342900 h 812800"/>
              <a:gd name="connsiteX37" fmla="*/ 431800 w 1587500"/>
              <a:gd name="connsiteY37" fmla="*/ 336550 h 812800"/>
              <a:gd name="connsiteX38" fmla="*/ 438150 w 1587500"/>
              <a:gd name="connsiteY38" fmla="*/ 327025 h 812800"/>
              <a:gd name="connsiteX39" fmla="*/ 447675 w 1587500"/>
              <a:gd name="connsiteY39" fmla="*/ 323850 h 812800"/>
              <a:gd name="connsiteX40" fmla="*/ 469900 w 1587500"/>
              <a:gd name="connsiteY40" fmla="*/ 298450 h 812800"/>
              <a:gd name="connsiteX41" fmla="*/ 476250 w 1587500"/>
              <a:gd name="connsiteY41" fmla="*/ 288925 h 812800"/>
              <a:gd name="connsiteX42" fmla="*/ 495300 w 1587500"/>
              <a:gd name="connsiteY42" fmla="*/ 276225 h 812800"/>
              <a:gd name="connsiteX43" fmla="*/ 501650 w 1587500"/>
              <a:gd name="connsiteY43" fmla="*/ 266700 h 812800"/>
              <a:gd name="connsiteX44" fmla="*/ 511175 w 1587500"/>
              <a:gd name="connsiteY44" fmla="*/ 263525 h 812800"/>
              <a:gd name="connsiteX45" fmla="*/ 530225 w 1587500"/>
              <a:gd name="connsiteY45" fmla="*/ 234950 h 812800"/>
              <a:gd name="connsiteX46" fmla="*/ 546100 w 1587500"/>
              <a:gd name="connsiteY46" fmla="*/ 219075 h 812800"/>
              <a:gd name="connsiteX47" fmla="*/ 561975 w 1587500"/>
              <a:gd name="connsiteY47" fmla="*/ 215900 h 812800"/>
              <a:gd name="connsiteX48" fmla="*/ 571500 w 1587500"/>
              <a:gd name="connsiteY48" fmla="*/ 209550 h 812800"/>
              <a:gd name="connsiteX49" fmla="*/ 574675 w 1587500"/>
              <a:gd name="connsiteY49" fmla="*/ 200025 h 812800"/>
              <a:gd name="connsiteX50" fmla="*/ 596900 w 1587500"/>
              <a:gd name="connsiteY50" fmla="*/ 174625 h 812800"/>
              <a:gd name="connsiteX51" fmla="*/ 603250 w 1587500"/>
              <a:gd name="connsiteY51" fmla="*/ 165100 h 812800"/>
              <a:gd name="connsiteX52" fmla="*/ 638175 w 1587500"/>
              <a:gd name="connsiteY52" fmla="*/ 171450 h 812800"/>
              <a:gd name="connsiteX53" fmla="*/ 647700 w 1587500"/>
              <a:gd name="connsiteY53" fmla="*/ 177800 h 812800"/>
              <a:gd name="connsiteX54" fmla="*/ 654050 w 1587500"/>
              <a:gd name="connsiteY54" fmla="*/ 187325 h 812800"/>
              <a:gd name="connsiteX55" fmla="*/ 660400 w 1587500"/>
              <a:gd name="connsiteY55" fmla="*/ 206375 h 812800"/>
              <a:gd name="connsiteX56" fmla="*/ 669925 w 1587500"/>
              <a:gd name="connsiteY56" fmla="*/ 225425 h 812800"/>
              <a:gd name="connsiteX57" fmla="*/ 676275 w 1587500"/>
              <a:gd name="connsiteY57" fmla="*/ 234950 h 812800"/>
              <a:gd name="connsiteX58" fmla="*/ 682625 w 1587500"/>
              <a:gd name="connsiteY58" fmla="*/ 254000 h 812800"/>
              <a:gd name="connsiteX59" fmla="*/ 698500 w 1587500"/>
              <a:gd name="connsiteY59" fmla="*/ 269875 h 812800"/>
              <a:gd name="connsiteX60" fmla="*/ 717550 w 1587500"/>
              <a:gd name="connsiteY60" fmla="*/ 276225 h 812800"/>
              <a:gd name="connsiteX61" fmla="*/ 727075 w 1587500"/>
              <a:gd name="connsiteY61" fmla="*/ 285750 h 812800"/>
              <a:gd name="connsiteX62" fmla="*/ 746125 w 1587500"/>
              <a:gd name="connsiteY62" fmla="*/ 292100 h 812800"/>
              <a:gd name="connsiteX63" fmla="*/ 755650 w 1587500"/>
              <a:gd name="connsiteY63" fmla="*/ 298450 h 812800"/>
              <a:gd name="connsiteX64" fmla="*/ 758825 w 1587500"/>
              <a:gd name="connsiteY64" fmla="*/ 307975 h 812800"/>
              <a:gd name="connsiteX65" fmla="*/ 777875 w 1587500"/>
              <a:gd name="connsiteY65" fmla="*/ 314325 h 812800"/>
              <a:gd name="connsiteX66" fmla="*/ 796925 w 1587500"/>
              <a:gd name="connsiteY66" fmla="*/ 327025 h 812800"/>
              <a:gd name="connsiteX67" fmla="*/ 806450 w 1587500"/>
              <a:gd name="connsiteY67" fmla="*/ 323850 h 812800"/>
              <a:gd name="connsiteX68" fmla="*/ 844550 w 1587500"/>
              <a:gd name="connsiteY68" fmla="*/ 327025 h 812800"/>
              <a:gd name="connsiteX69" fmla="*/ 847725 w 1587500"/>
              <a:gd name="connsiteY69" fmla="*/ 336550 h 812800"/>
              <a:gd name="connsiteX70" fmla="*/ 854075 w 1587500"/>
              <a:gd name="connsiteY70" fmla="*/ 346075 h 812800"/>
              <a:gd name="connsiteX71" fmla="*/ 873125 w 1587500"/>
              <a:gd name="connsiteY71" fmla="*/ 352425 h 812800"/>
              <a:gd name="connsiteX72" fmla="*/ 882650 w 1587500"/>
              <a:gd name="connsiteY72" fmla="*/ 349250 h 812800"/>
              <a:gd name="connsiteX73" fmla="*/ 885825 w 1587500"/>
              <a:gd name="connsiteY73" fmla="*/ 339725 h 812800"/>
              <a:gd name="connsiteX74" fmla="*/ 882650 w 1587500"/>
              <a:gd name="connsiteY74" fmla="*/ 311150 h 812800"/>
              <a:gd name="connsiteX75" fmla="*/ 876300 w 1587500"/>
              <a:gd name="connsiteY75" fmla="*/ 260350 h 812800"/>
              <a:gd name="connsiteX76" fmla="*/ 869950 w 1587500"/>
              <a:gd name="connsiteY76" fmla="*/ 250825 h 812800"/>
              <a:gd name="connsiteX77" fmla="*/ 857250 w 1587500"/>
              <a:gd name="connsiteY77" fmla="*/ 247650 h 812800"/>
              <a:gd name="connsiteX78" fmla="*/ 847725 w 1587500"/>
              <a:gd name="connsiteY78" fmla="*/ 244475 h 812800"/>
              <a:gd name="connsiteX79" fmla="*/ 841375 w 1587500"/>
              <a:gd name="connsiteY79" fmla="*/ 234950 h 812800"/>
              <a:gd name="connsiteX80" fmla="*/ 831850 w 1587500"/>
              <a:gd name="connsiteY80" fmla="*/ 231775 h 812800"/>
              <a:gd name="connsiteX81" fmla="*/ 825500 w 1587500"/>
              <a:gd name="connsiteY81" fmla="*/ 212725 h 812800"/>
              <a:gd name="connsiteX82" fmla="*/ 803275 w 1587500"/>
              <a:gd name="connsiteY82" fmla="*/ 187325 h 812800"/>
              <a:gd name="connsiteX83" fmla="*/ 793750 w 1587500"/>
              <a:gd name="connsiteY83" fmla="*/ 184150 h 812800"/>
              <a:gd name="connsiteX84" fmla="*/ 781050 w 1587500"/>
              <a:gd name="connsiteY84" fmla="*/ 155575 h 812800"/>
              <a:gd name="connsiteX85" fmla="*/ 777875 w 1587500"/>
              <a:gd name="connsiteY85" fmla="*/ 146050 h 812800"/>
              <a:gd name="connsiteX86" fmla="*/ 784225 w 1587500"/>
              <a:gd name="connsiteY86" fmla="*/ 101600 h 812800"/>
              <a:gd name="connsiteX87" fmla="*/ 793750 w 1587500"/>
              <a:gd name="connsiteY87" fmla="*/ 79375 h 812800"/>
              <a:gd name="connsiteX88" fmla="*/ 803275 w 1587500"/>
              <a:gd name="connsiteY88" fmla="*/ 76200 h 812800"/>
              <a:gd name="connsiteX89" fmla="*/ 809625 w 1587500"/>
              <a:gd name="connsiteY89" fmla="*/ 50800 h 812800"/>
              <a:gd name="connsiteX90" fmla="*/ 812800 w 1587500"/>
              <a:gd name="connsiteY90" fmla="*/ 41275 h 812800"/>
              <a:gd name="connsiteX91" fmla="*/ 822325 w 1587500"/>
              <a:gd name="connsiteY91" fmla="*/ 38100 h 812800"/>
              <a:gd name="connsiteX92" fmla="*/ 841375 w 1587500"/>
              <a:gd name="connsiteY92" fmla="*/ 25400 h 812800"/>
              <a:gd name="connsiteX93" fmla="*/ 860425 w 1587500"/>
              <a:gd name="connsiteY93" fmla="*/ 19050 h 812800"/>
              <a:gd name="connsiteX94" fmla="*/ 889000 w 1587500"/>
              <a:gd name="connsiteY94" fmla="*/ 22225 h 812800"/>
              <a:gd name="connsiteX95" fmla="*/ 895350 w 1587500"/>
              <a:gd name="connsiteY95" fmla="*/ 12700 h 812800"/>
              <a:gd name="connsiteX96" fmla="*/ 898525 w 1587500"/>
              <a:gd name="connsiteY96" fmla="*/ 3175 h 812800"/>
              <a:gd name="connsiteX97" fmla="*/ 908050 w 1587500"/>
              <a:gd name="connsiteY97" fmla="*/ 0 h 812800"/>
              <a:gd name="connsiteX98" fmla="*/ 927100 w 1587500"/>
              <a:gd name="connsiteY98" fmla="*/ 3175 h 812800"/>
              <a:gd name="connsiteX99" fmla="*/ 936625 w 1587500"/>
              <a:gd name="connsiteY99" fmla="*/ 9525 h 812800"/>
              <a:gd name="connsiteX100" fmla="*/ 946150 w 1587500"/>
              <a:gd name="connsiteY100" fmla="*/ 12700 h 812800"/>
              <a:gd name="connsiteX101" fmla="*/ 965200 w 1587500"/>
              <a:gd name="connsiteY101" fmla="*/ 6350 h 812800"/>
              <a:gd name="connsiteX102" fmla="*/ 1000125 w 1587500"/>
              <a:gd name="connsiteY102" fmla="*/ 15875 h 812800"/>
              <a:gd name="connsiteX103" fmla="*/ 1009650 w 1587500"/>
              <a:gd name="connsiteY103" fmla="*/ 22225 h 812800"/>
              <a:gd name="connsiteX104" fmla="*/ 1019175 w 1587500"/>
              <a:gd name="connsiteY104" fmla="*/ 41275 h 812800"/>
              <a:gd name="connsiteX105" fmla="*/ 1060450 w 1587500"/>
              <a:gd name="connsiteY105" fmla="*/ 50800 h 812800"/>
              <a:gd name="connsiteX106" fmla="*/ 1073150 w 1587500"/>
              <a:gd name="connsiteY106" fmla="*/ 53975 h 812800"/>
              <a:gd name="connsiteX107" fmla="*/ 1082675 w 1587500"/>
              <a:gd name="connsiteY107" fmla="*/ 63500 h 812800"/>
              <a:gd name="connsiteX108" fmla="*/ 1092200 w 1587500"/>
              <a:gd name="connsiteY108" fmla="*/ 69850 h 812800"/>
              <a:gd name="connsiteX109" fmla="*/ 1108075 w 1587500"/>
              <a:gd name="connsiteY109" fmla="*/ 85725 h 812800"/>
              <a:gd name="connsiteX110" fmla="*/ 1123950 w 1587500"/>
              <a:gd name="connsiteY110" fmla="*/ 101600 h 812800"/>
              <a:gd name="connsiteX111" fmla="*/ 1130300 w 1587500"/>
              <a:gd name="connsiteY111" fmla="*/ 111125 h 812800"/>
              <a:gd name="connsiteX112" fmla="*/ 1149350 w 1587500"/>
              <a:gd name="connsiteY112" fmla="*/ 123825 h 812800"/>
              <a:gd name="connsiteX113" fmla="*/ 1158875 w 1587500"/>
              <a:gd name="connsiteY113" fmla="*/ 130175 h 812800"/>
              <a:gd name="connsiteX114" fmla="*/ 1184275 w 1587500"/>
              <a:gd name="connsiteY114" fmla="*/ 136525 h 812800"/>
              <a:gd name="connsiteX115" fmla="*/ 1212850 w 1587500"/>
              <a:gd name="connsiteY115" fmla="*/ 139700 h 812800"/>
              <a:gd name="connsiteX116" fmla="*/ 1241425 w 1587500"/>
              <a:gd name="connsiteY116" fmla="*/ 146050 h 812800"/>
              <a:gd name="connsiteX117" fmla="*/ 1270000 w 1587500"/>
              <a:gd name="connsiteY117" fmla="*/ 152400 h 812800"/>
              <a:gd name="connsiteX118" fmla="*/ 1276350 w 1587500"/>
              <a:gd name="connsiteY118" fmla="*/ 161925 h 812800"/>
              <a:gd name="connsiteX119" fmla="*/ 1282700 w 1587500"/>
              <a:gd name="connsiteY119" fmla="*/ 180975 h 812800"/>
              <a:gd name="connsiteX120" fmla="*/ 1285875 w 1587500"/>
              <a:gd name="connsiteY120" fmla="*/ 190500 h 812800"/>
              <a:gd name="connsiteX121" fmla="*/ 1289050 w 1587500"/>
              <a:gd name="connsiteY121" fmla="*/ 200025 h 812800"/>
              <a:gd name="connsiteX122" fmla="*/ 1292225 w 1587500"/>
              <a:gd name="connsiteY122" fmla="*/ 212725 h 812800"/>
              <a:gd name="connsiteX123" fmla="*/ 1301750 w 1587500"/>
              <a:gd name="connsiteY123" fmla="*/ 231775 h 812800"/>
              <a:gd name="connsiteX124" fmla="*/ 1304925 w 1587500"/>
              <a:gd name="connsiteY124" fmla="*/ 241300 h 812800"/>
              <a:gd name="connsiteX125" fmla="*/ 1323975 w 1587500"/>
              <a:gd name="connsiteY125" fmla="*/ 247650 h 812800"/>
              <a:gd name="connsiteX126" fmla="*/ 1352550 w 1587500"/>
              <a:gd name="connsiteY126" fmla="*/ 257175 h 812800"/>
              <a:gd name="connsiteX127" fmla="*/ 1362075 w 1587500"/>
              <a:gd name="connsiteY127" fmla="*/ 260350 h 812800"/>
              <a:gd name="connsiteX128" fmla="*/ 1371600 w 1587500"/>
              <a:gd name="connsiteY128" fmla="*/ 263525 h 812800"/>
              <a:gd name="connsiteX129" fmla="*/ 1400175 w 1587500"/>
              <a:gd name="connsiteY129" fmla="*/ 282575 h 812800"/>
              <a:gd name="connsiteX130" fmla="*/ 1409700 w 1587500"/>
              <a:gd name="connsiteY130" fmla="*/ 288925 h 812800"/>
              <a:gd name="connsiteX131" fmla="*/ 1435100 w 1587500"/>
              <a:gd name="connsiteY131" fmla="*/ 304800 h 812800"/>
              <a:gd name="connsiteX132" fmla="*/ 1444625 w 1587500"/>
              <a:gd name="connsiteY132" fmla="*/ 307975 h 812800"/>
              <a:gd name="connsiteX133" fmla="*/ 1482725 w 1587500"/>
              <a:gd name="connsiteY133" fmla="*/ 301625 h 812800"/>
              <a:gd name="connsiteX134" fmla="*/ 1501775 w 1587500"/>
              <a:gd name="connsiteY134" fmla="*/ 292100 h 812800"/>
              <a:gd name="connsiteX135" fmla="*/ 1527175 w 1587500"/>
              <a:gd name="connsiteY135" fmla="*/ 276225 h 812800"/>
              <a:gd name="connsiteX136" fmla="*/ 1536700 w 1587500"/>
              <a:gd name="connsiteY136" fmla="*/ 273050 h 812800"/>
              <a:gd name="connsiteX137" fmla="*/ 1543050 w 1587500"/>
              <a:gd name="connsiteY137" fmla="*/ 263525 h 812800"/>
              <a:gd name="connsiteX138" fmla="*/ 1524000 w 1587500"/>
              <a:gd name="connsiteY138" fmla="*/ 247650 h 812800"/>
              <a:gd name="connsiteX139" fmla="*/ 1504950 w 1587500"/>
              <a:gd name="connsiteY139" fmla="*/ 234950 h 812800"/>
              <a:gd name="connsiteX140" fmla="*/ 1479550 w 1587500"/>
              <a:gd name="connsiteY140" fmla="*/ 196850 h 812800"/>
              <a:gd name="connsiteX141" fmla="*/ 1473200 w 1587500"/>
              <a:gd name="connsiteY141" fmla="*/ 187325 h 812800"/>
              <a:gd name="connsiteX142" fmla="*/ 1466850 w 1587500"/>
              <a:gd name="connsiteY142" fmla="*/ 168275 h 812800"/>
              <a:gd name="connsiteX143" fmla="*/ 1482725 w 1587500"/>
              <a:gd name="connsiteY143" fmla="*/ 142875 h 812800"/>
              <a:gd name="connsiteX144" fmla="*/ 1501775 w 1587500"/>
              <a:gd name="connsiteY144" fmla="*/ 136525 h 812800"/>
              <a:gd name="connsiteX145" fmla="*/ 1511300 w 1587500"/>
              <a:gd name="connsiteY145" fmla="*/ 139700 h 812800"/>
              <a:gd name="connsiteX146" fmla="*/ 1530350 w 1587500"/>
              <a:gd name="connsiteY146" fmla="*/ 133350 h 812800"/>
              <a:gd name="connsiteX147" fmla="*/ 1539875 w 1587500"/>
              <a:gd name="connsiteY147" fmla="*/ 130175 h 812800"/>
              <a:gd name="connsiteX148" fmla="*/ 1587500 w 1587500"/>
              <a:gd name="connsiteY148" fmla="*/ 127000 h 812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</a:cxnLst>
            <a:rect l="l" t="t" r="r" b="b"/>
            <a:pathLst>
              <a:path w="1587500" h="812800">
                <a:moveTo>
                  <a:pt x="0" y="812800"/>
                </a:moveTo>
                <a:cubicBezTo>
                  <a:pt x="3175" y="807508"/>
                  <a:pt x="5509" y="801610"/>
                  <a:pt x="9525" y="796925"/>
                </a:cubicBezTo>
                <a:cubicBezTo>
                  <a:pt x="12008" y="794028"/>
                  <a:pt x="16666" y="793555"/>
                  <a:pt x="19050" y="790575"/>
                </a:cubicBezTo>
                <a:cubicBezTo>
                  <a:pt x="32284" y="774032"/>
                  <a:pt x="2933" y="783328"/>
                  <a:pt x="34925" y="762000"/>
                </a:cubicBezTo>
                <a:cubicBezTo>
                  <a:pt x="38100" y="759883"/>
                  <a:pt x="40963" y="757200"/>
                  <a:pt x="44450" y="755650"/>
                </a:cubicBezTo>
                <a:cubicBezTo>
                  <a:pt x="50567" y="752932"/>
                  <a:pt x="57150" y="751417"/>
                  <a:pt x="63500" y="749300"/>
                </a:cubicBezTo>
                <a:lnTo>
                  <a:pt x="73025" y="746125"/>
                </a:lnTo>
                <a:cubicBezTo>
                  <a:pt x="76200" y="745067"/>
                  <a:pt x="79303" y="743762"/>
                  <a:pt x="82550" y="742950"/>
                </a:cubicBezTo>
                <a:cubicBezTo>
                  <a:pt x="86783" y="741892"/>
                  <a:pt x="91054" y="740974"/>
                  <a:pt x="95250" y="739775"/>
                </a:cubicBezTo>
                <a:cubicBezTo>
                  <a:pt x="109919" y="735584"/>
                  <a:pt x="106769" y="735271"/>
                  <a:pt x="123825" y="723900"/>
                </a:cubicBezTo>
                <a:lnTo>
                  <a:pt x="133350" y="717550"/>
                </a:lnTo>
                <a:lnTo>
                  <a:pt x="142875" y="711200"/>
                </a:lnTo>
                <a:cubicBezTo>
                  <a:pt x="144992" y="708025"/>
                  <a:pt x="147518" y="705088"/>
                  <a:pt x="149225" y="701675"/>
                </a:cubicBezTo>
                <a:cubicBezTo>
                  <a:pt x="152479" y="695166"/>
                  <a:pt x="154367" y="682313"/>
                  <a:pt x="155575" y="676275"/>
                </a:cubicBezTo>
                <a:cubicBezTo>
                  <a:pt x="154517" y="666750"/>
                  <a:pt x="153895" y="657166"/>
                  <a:pt x="152400" y="647700"/>
                </a:cubicBezTo>
                <a:cubicBezTo>
                  <a:pt x="150717" y="637039"/>
                  <a:pt x="146050" y="615950"/>
                  <a:pt x="146050" y="615950"/>
                </a:cubicBezTo>
                <a:cubicBezTo>
                  <a:pt x="147108" y="605367"/>
                  <a:pt x="146833" y="594564"/>
                  <a:pt x="149225" y="584200"/>
                </a:cubicBezTo>
                <a:cubicBezTo>
                  <a:pt x="150083" y="580482"/>
                  <a:pt x="154025" y="578162"/>
                  <a:pt x="155575" y="574675"/>
                </a:cubicBezTo>
                <a:cubicBezTo>
                  <a:pt x="160605" y="563357"/>
                  <a:pt x="159652" y="554723"/>
                  <a:pt x="168275" y="546100"/>
                </a:cubicBezTo>
                <a:cubicBezTo>
                  <a:pt x="170973" y="543402"/>
                  <a:pt x="174625" y="541867"/>
                  <a:pt x="177800" y="539750"/>
                </a:cubicBezTo>
                <a:cubicBezTo>
                  <a:pt x="178858" y="536575"/>
                  <a:pt x="178608" y="532592"/>
                  <a:pt x="180975" y="530225"/>
                </a:cubicBezTo>
                <a:cubicBezTo>
                  <a:pt x="186371" y="524829"/>
                  <a:pt x="200025" y="517525"/>
                  <a:pt x="200025" y="517525"/>
                </a:cubicBezTo>
                <a:cubicBezTo>
                  <a:pt x="208788" y="491235"/>
                  <a:pt x="202662" y="504044"/>
                  <a:pt x="219075" y="479425"/>
                </a:cubicBezTo>
                <a:lnTo>
                  <a:pt x="225425" y="469900"/>
                </a:lnTo>
                <a:cubicBezTo>
                  <a:pt x="227542" y="466725"/>
                  <a:pt x="228155" y="461582"/>
                  <a:pt x="231775" y="460375"/>
                </a:cubicBezTo>
                <a:cubicBezTo>
                  <a:pt x="244920" y="455993"/>
                  <a:pt x="238515" y="459056"/>
                  <a:pt x="250825" y="450850"/>
                </a:cubicBezTo>
                <a:cubicBezTo>
                  <a:pt x="261747" y="434467"/>
                  <a:pt x="255810" y="446341"/>
                  <a:pt x="260350" y="419100"/>
                </a:cubicBezTo>
                <a:cubicBezTo>
                  <a:pt x="261237" y="413777"/>
                  <a:pt x="262216" y="408460"/>
                  <a:pt x="263525" y="403225"/>
                </a:cubicBezTo>
                <a:cubicBezTo>
                  <a:pt x="264337" y="399978"/>
                  <a:pt x="264333" y="396067"/>
                  <a:pt x="266700" y="393700"/>
                </a:cubicBezTo>
                <a:cubicBezTo>
                  <a:pt x="272096" y="388304"/>
                  <a:pt x="285750" y="381000"/>
                  <a:pt x="285750" y="381000"/>
                </a:cubicBezTo>
                <a:cubicBezTo>
                  <a:pt x="300567" y="358775"/>
                  <a:pt x="292100" y="366183"/>
                  <a:pt x="307975" y="355600"/>
                </a:cubicBezTo>
                <a:cubicBezTo>
                  <a:pt x="318038" y="340506"/>
                  <a:pt x="310705" y="347282"/>
                  <a:pt x="333375" y="339725"/>
                </a:cubicBezTo>
                <a:lnTo>
                  <a:pt x="342900" y="336550"/>
                </a:lnTo>
                <a:lnTo>
                  <a:pt x="352425" y="333375"/>
                </a:lnTo>
                <a:cubicBezTo>
                  <a:pt x="354542" y="336550"/>
                  <a:pt x="355462" y="341007"/>
                  <a:pt x="358775" y="342900"/>
                </a:cubicBezTo>
                <a:cubicBezTo>
                  <a:pt x="363460" y="345577"/>
                  <a:pt x="369254" y="346075"/>
                  <a:pt x="374650" y="346075"/>
                </a:cubicBezTo>
                <a:cubicBezTo>
                  <a:pt x="390560" y="346075"/>
                  <a:pt x="406400" y="343958"/>
                  <a:pt x="422275" y="342900"/>
                </a:cubicBezTo>
                <a:cubicBezTo>
                  <a:pt x="425450" y="340783"/>
                  <a:pt x="429102" y="339248"/>
                  <a:pt x="431800" y="336550"/>
                </a:cubicBezTo>
                <a:cubicBezTo>
                  <a:pt x="434498" y="333852"/>
                  <a:pt x="435170" y="329409"/>
                  <a:pt x="438150" y="327025"/>
                </a:cubicBezTo>
                <a:cubicBezTo>
                  <a:pt x="440763" y="324934"/>
                  <a:pt x="444500" y="324908"/>
                  <a:pt x="447675" y="323850"/>
                </a:cubicBezTo>
                <a:cubicBezTo>
                  <a:pt x="462492" y="301625"/>
                  <a:pt x="454025" y="309033"/>
                  <a:pt x="469900" y="298450"/>
                </a:cubicBezTo>
                <a:cubicBezTo>
                  <a:pt x="472017" y="295275"/>
                  <a:pt x="473378" y="291438"/>
                  <a:pt x="476250" y="288925"/>
                </a:cubicBezTo>
                <a:cubicBezTo>
                  <a:pt x="481993" y="283899"/>
                  <a:pt x="495300" y="276225"/>
                  <a:pt x="495300" y="276225"/>
                </a:cubicBezTo>
                <a:cubicBezTo>
                  <a:pt x="497417" y="273050"/>
                  <a:pt x="498670" y="269084"/>
                  <a:pt x="501650" y="266700"/>
                </a:cubicBezTo>
                <a:cubicBezTo>
                  <a:pt x="504263" y="264609"/>
                  <a:pt x="508808" y="265892"/>
                  <a:pt x="511175" y="263525"/>
                </a:cubicBezTo>
                <a:lnTo>
                  <a:pt x="530225" y="234950"/>
                </a:lnTo>
                <a:cubicBezTo>
                  <a:pt x="535399" y="227189"/>
                  <a:pt x="536693" y="222603"/>
                  <a:pt x="546100" y="219075"/>
                </a:cubicBezTo>
                <a:cubicBezTo>
                  <a:pt x="551153" y="217180"/>
                  <a:pt x="556683" y="216958"/>
                  <a:pt x="561975" y="215900"/>
                </a:cubicBezTo>
                <a:cubicBezTo>
                  <a:pt x="565150" y="213783"/>
                  <a:pt x="569116" y="212530"/>
                  <a:pt x="571500" y="209550"/>
                </a:cubicBezTo>
                <a:cubicBezTo>
                  <a:pt x="573591" y="206937"/>
                  <a:pt x="573050" y="202951"/>
                  <a:pt x="574675" y="200025"/>
                </a:cubicBezTo>
                <a:cubicBezTo>
                  <a:pt x="585570" y="180415"/>
                  <a:pt x="582986" y="183901"/>
                  <a:pt x="596900" y="174625"/>
                </a:cubicBezTo>
                <a:cubicBezTo>
                  <a:pt x="599017" y="171450"/>
                  <a:pt x="599508" y="165848"/>
                  <a:pt x="603250" y="165100"/>
                </a:cubicBezTo>
                <a:cubicBezTo>
                  <a:pt x="607941" y="164162"/>
                  <a:pt x="629981" y="167353"/>
                  <a:pt x="638175" y="171450"/>
                </a:cubicBezTo>
                <a:cubicBezTo>
                  <a:pt x="641588" y="173157"/>
                  <a:pt x="644525" y="175683"/>
                  <a:pt x="647700" y="177800"/>
                </a:cubicBezTo>
                <a:cubicBezTo>
                  <a:pt x="649817" y="180975"/>
                  <a:pt x="652500" y="183838"/>
                  <a:pt x="654050" y="187325"/>
                </a:cubicBezTo>
                <a:cubicBezTo>
                  <a:pt x="656768" y="193442"/>
                  <a:pt x="656687" y="200806"/>
                  <a:pt x="660400" y="206375"/>
                </a:cubicBezTo>
                <a:cubicBezTo>
                  <a:pt x="678598" y="233672"/>
                  <a:pt x="656780" y="199135"/>
                  <a:pt x="669925" y="225425"/>
                </a:cubicBezTo>
                <a:cubicBezTo>
                  <a:pt x="671632" y="228838"/>
                  <a:pt x="674725" y="231463"/>
                  <a:pt x="676275" y="234950"/>
                </a:cubicBezTo>
                <a:cubicBezTo>
                  <a:pt x="678993" y="241067"/>
                  <a:pt x="678912" y="248431"/>
                  <a:pt x="682625" y="254000"/>
                </a:cubicBezTo>
                <a:cubicBezTo>
                  <a:pt x="688418" y="262689"/>
                  <a:pt x="688474" y="265419"/>
                  <a:pt x="698500" y="269875"/>
                </a:cubicBezTo>
                <a:cubicBezTo>
                  <a:pt x="704617" y="272593"/>
                  <a:pt x="717550" y="276225"/>
                  <a:pt x="717550" y="276225"/>
                </a:cubicBezTo>
                <a:cubicBezTo>
                  <a:pt x="720725" y="279400"/>
                  <a:pt x="723150" y="283569"/>
                  <a:pt x="727075" y="285750"/>
                </a:cubicBezTo>
                <a:cubicBezTo>
                  <a:pt x="732926" y="289001"/>
                  <a:pt x="740556" y="288387"/>
                  <a:pt x="746125" y="292100"/>
                </a:cubicBezTo>
                <a:lnTo>
                  <a:pt x="755650" y="298450"/>
                </a:lnTo>
                <a:cubicBezTo>
                  <a:pt x="756708" y="301625"/>
                  <a:pt x="756102" y="306030"/>
                  <a:pt x="758825" y="307975"/>
                </a:cubicBezTo>
                <a:cubicBezTo>
                  <a:pt x="764272" y="311866"/>
                  <a:pt x="777875" y="314325"/>
                  <a:pt x="777875" y="314325"/>
                </a:cubicBezTo>
                <a:cubicBezTo>
                  <a:pt x="783602" y="320052"/>
                  <a:pt x="787735" y="327025"/>
                  <a:pt x="796925" y="327025"/>
                </a:cubicBezTo>
                <a:cubicBezTo>
                  <a:pt x="800272" y="327025"/>
                  <a:pt x="803275" y="324908"/>
                  <a:pt x="806450" y="323850"/>
                </a:cubicBezTo>
                <a:cubicBezTo>
                  <a:pt x="819150" y="324908"/>
                  <a:pt x="832370" y="323277"/>
                  <a:pt x="844550" y="327025"/>
                </a:cubicBezTo>
                <a:cubicBezTo>
                  <a:pt x="847749" y="328009"/>
                  <a:pt x="846228" y="333557"/>
                  <a:pt x="847725" y="336550"/>
                </a:cubicBezTo>
                <a:cubicBezTo>
                  <a:pt x="849432" y="339963"/>
                  <a:pt x="850839" y="344053"/>
                  <a:pt x="854075" y="346075"/>
                </a:cubicBezTo>
                <a:cubicBezTo>
                  <a:pt x="859751" y="349623"/>
                  <a:pt x="873125" y="352425"/>
                  <a:pt x="873125" y="352425"/>
                </a:cubicBezTo>
                <a:cubicBezTo>
                  <a:pt x="876300" y="351367"/>
                  <a:pt x="880283" y="351617"/>
                  <a:pt x="882650" y="349250"/>
                </a:cubicBezTo>
                <a:cubicBezTo>
                  <a:pt x="885017" y="346883"/>
                  <a:pt x="885825" y="343072"/>
                  <a:pt x="885825" y="339725"/>
                </a:cubicBezTo>
                <a:cubicBezTo>
                  <a:pt x="885825" y="330141"/>
                  <a:pt x="883518" y="320694"/>
                  <a:pt x="882650" y="311150"/>
                </a:cubicBezTo>
                <a:cubicBezTo>
                  <a:pt x="881909" y="303003"/>
                  <a:pt x="883186" y="274122"/>
                  <a:pt x="876300" y="260350"/>
                </a:cubicBezTo>
                <a:cubicBezTo>
                  <a:pt x="874593" y="256937"/>
                  <a:pt x="873125" y="252942"/>
                  <a:pt x="869950" y="250825"/>
                </a:cubicBezTo>
                <a:cubicBezTo>
                  <a:pt x="866319" y="248404"/>
                  <a:pt x="861446" y="248849"/>
                  <a:pt x="857250" y="247650"/>
                </a:cubicBezTo>
                <a:cubicBezTo>
                  <a:pt x="854032" y="246731"/>
                  <a:pt x="850900" y="245533"/>
                  <a:pt x="847725" y="244475"/>
                </a:cubicBezTo>
                <a:cubicBezTo>
                  <a:pt x="845608" y="241300"/>
                  <a:pt x="844355" y="237334"/>
                  <a:pt x="841375" y="234950"/>
                </a:cubicBezTo>
                <a:cubicBezTo>
                  <a:pt x="838762" y="232859"/>
                  <a:pt x="833795" y="234498"/>
                  <a:pt x="831850" y="231775"/>
                </a:cubicBezTo>
                <a:cubicBezTo>
                  <a:pt x="827959" y="226328"/>
                  <a:pt x="829213" y="218294"/>
                  <a:pt x="825500" y="212725"/>
                </a:cubicBezTo>
                <a:cubicBezTo>
                  <a:pt x="815975" y="198438"/>
                  <a:pt x="816504" y="193940"/>
                  <a:pt x="803275" y="187325"/>
                </a:cubicBezTo>
                <a:cubicBezTo>
                  <a:pt x="800282" y="185828"/>
                  <a:pt x="796925" y="185208"/>
                  <a:pt x="793750" y="184150"/>
                </a:cubicBezTo>
                <a:cubicBezTo>
                  <a:pt x="783687" y="169056"/>
                  <a:pt x="788607" y="178245"/>
                  <a:pt x="781050" y="155575"/>
                </a:cubicBezTo>
                <a:lnTo>
                  <a:pt x="777875" y="146050"/>
                </a:lnTo>
                <a:cubicBezTo>
                  <a:pt x="786468" y="103083"/>
                  <a:pt x="774169" y="166963"/>
                  <a:pt x="784225" y="101600"/>
                </a:cubicBezTo>
                <a:cubicBezTo>
                  <a:pt x="785295" y="94643"/>
                  <a:pt x="787629" y="84272"/>
                  <a:pt x="793750" y="79375"/>
                </a:cubicBezTo>
                <a:cubicBezTo>
                  <a:pt x="796363" y="77284"/>
                  <a:pt x="800100" y="77258"/>
                  <a:pt x="803275" y="76200"/>
                </a:cubicBezTo>
                <a:cubicBezTo>
                  <a:pt x="810533" y="54427"/>
                  <a:pt x="801962" y="81451"/>
                  <a:pt x="809625" y="50800"/>
                </a:cubicBezTo>
                <a:cubicBezTo>
                  <a:pt x="810437" y="47553"/>
                  <a:pt x="810433" y="43642"/>
                  <a:pt x="812800" y="41275"/>
                </a:cubicBezTo>
                <a:cubicBezTo>
                  <a:pt x="815167" y="38908"/>
                  <a:pt x="819399" y="39725"/>
                  <a:pt x="822325" y="38100"/>
                </a:cubicBezTo>
                <a:cubicBezTo>
                  <a:pt x="828996" y="34394"/>
                  <a:pt x="834135" y="27813"/>
                  <a:pt x="841375" y="25400"/>
                </a:cubicBezTo>
                <a:lnTo>
                  <a:pt x="860425" y="19050"/>
                </a:lnTo>
                <a:cubicBezTo>
                  <a:pt x="882650" y="26458"/>
                  <a:pt x="873125" y="27517"/>
                  <a:pt x="889000" y="22225"/>
                </a:cubicBezTo>
                <a:cubicBezTo>
                  <a:pt x="891117" y="19050"/>
                  <a:pt x="893643" y="16113"/>
                  <a:pt x="895350" y="12700"/>
                </a:cubicBezTo>
                <a:cubicBezTo>
                  <a:pt x="896847" y="9707"/>
                  <a:pt x="896158" y="5542"/>
                  <a:pt x="898525" y="3175"/>
                </a:cubicBezTo>
                <a:cubicBezTo>
                  <a:pt x="900892" y="808"/>
                  <a:pt x="904875" y="1058"/>
                  <a:pt x="908050" y="0"/>
                </a:cubicBezTo>
                <a:cubicBezTo>
                  <a:pt x="914400" y="1058"/>
                  <a:pt x="920993" y="1139"/>
                  <a:pt x="927100" y="3175"/>
                </a:cubicBezTo>
                <a:cubicBezTo>
                  <a:pt x="930720" y="4382"/>
                  <a:pt x="933212" y="7818"/>
                  <a:pt x="936625" y="9525"/>
                </a:cubicBezTo>
                <a:cubicBezTo>
                  <a:pt x="939618" y="11022"/>
                  <a:pt x="942975" y="11642"/>
                  <a:pt x="946150" y="12700"/>
                </a:cubicBezTo>
                <a:cubicBezTo>
                  <a:pt x="952500" y="10583"/>
                  <a:pt x="958636" y="5037"/>
                  <a:pt x="965200" y="6350"/>
                </a:cubicBezTo>
                <a:cubicBezTo>
                  <a:pt x="973720" y="8054"/>
                  <a:pt x="993219" y="11271"/>
                  <a:pt x="1000125" y="15875"/>
                </a:cubicBezTo>
                <a:lnTo>
                  <a:pt x="1009650" y="22225"/>
                </a:lnTo>
                <a:cubicBezTo>
                  <a:pt x="1011380" y="27415"/>
                  <a:pt x="1013992" y="38036"/>
                  <a:pt x="1019175" y="41275"/>
                </a:cubicBezTo>
                <a:cubicBezTo>
                  <a:pt x="1030384" y="48280"/>
                  <a:pt x="1048303" y="48591"/>
                  <a:pt x="1060450" y="50800"/>
                </a:cubicBezTo>
                <a:cubicBezTo>
                  <a:pt x="1064743" y="51581"/>
                  <a:pt x="1068917" y="52917"/>
                  <a:pt x="1073150" y="53975"/>
                </a:cubicBezTo>
                <a:cubicBezTo>
                  <a:pt x="1076325" y="57150"/>
                  <a:pt x="1079226" y="60625"/>
                  <a:pt x="1082675" y="63500"/>
                </a:cubicBezTo>
                <a:cubicBezTo>
                  <a:pt x="1085606" y="65943"/>
                  <a:pt x="1089502" y="67152"/>
                  <a:pt x="1092200" y="69850"/>
                </a:cubicBezTo>
                <a:cubicBezTo>
                  <a:pt x="1113367" y="91017"/>
                  <a:pt x="1082675" y="68792"/>
                  <a:pt x="1108075" y="85725"/>
                </a:cubicBezTo>
                <a:cubicBezTo>
                  <a:pt x="1125008" y="111125"/>
                  <a:pt x="1102783" y="80433"/>
                  <a:pt x="1123950" y="101600"/>
                </a:cubicBezTo>
                <a:cubicBezTo>
                  <a:pt x="1126648" y="104298"/>
                  <a:pt x="1127428" y="108612"/>
                  <a:pt x="1130300" y="111125"/>
                </a:cubicBezTo>
                <a:cubicBezTo>
                  <a:pt x="1136043" y="116151"/>
                  <a:pt x="1143000" y="119592"/>
                  <a:pt x="1149350" y="123825"/>
                </a:cubicBezTo>
                <a:cubicBezTo>
                  <a:pt x="1152525" y="125942"/>
                  <a:pt x="1155255" y="128968"/>
                  <a:pt x="1158875" y="130175"/>
                </a:cubicBezTo>
                <a:cubicBezTo>
                  <a:pt x="1169955" y="133868"/>
                  <a:pt x="1170865" y="134609"/>
                  <a:pt x="1184275" y="136525"/>
                </a:cubicBezTo>
                <a:cubicBezTo>
                  <a:pt x="1193762" y="137880"/>
                  <a:pt x="1203325" y="138642"/>
                  <a:pt x="1212850" y="139700"/>
                </a:cubicBezTo>
                <a:cubicBezTo>
                  <a:pt x="1226440" y="143097"/>
                  <a:pt x="1226645" y="143363"/>
                  <a:pt x="1241425" y="146050"/>
                </a:cubicBezTo>
                <a:cubicBezTo>
                  <a:pt x="1266011" y="150520"/>
                  <a:pt x="1253206" y="146802"/>
                  <a:pt x="1270000" y="152400"/>
                </a:cubicBezTo>
                <a:cubicBezTo>
                  <a:pt x="1272117" y="155575"/>
                  <a:pt x="1274800" y="158438"/>
                  <a:pt x="1276350" y="161925"/>
                </a:cubicBezTo>
                <a:cubicBezTo>
                  <a:pt x="1279068" y="168042"/>
                  <a:pt x="1280583" y="174625"/>
                  <a:pt x="1282700" y="180975"/>
                </a:cubicBezTo>
                <a:lnTo>
                  <a:pt x="1285875" y="190500"/>
                </a:lnTo>
                <a:cubicBezTo>
                  <a:pt x="1286933" y="193675"/>
                  <a:pt x="1288238" y="196778"/>
                  <a:pt x="1289050" y="200025"/>
                </a:cubicBezTo>
                <a:cubicBezTo>
                  <a:pt x="1290108" y="204258"/>
                  <a:pt x="1291026" y="208529"/>
                  <a:pt x="1292225" y="212725"/>
                </a:cubicBezTo>
                <a:cubicBezTo>
                  <a:pt x="1297545" y="231346"/>
                  <a:pt x="1292473" y="213222"/>
                  <a:pt x="1301750" y="231775"/>
                </a:cubicBezTo>
                <a:cubicBezTo>
                  <a:pt x="1303247" y="234768"/>
                  <a:pt x="1302202" y="239355"/>
                  <a:pt x="1304925" y="241300"/>
                </a:cubicBezTo>
                <a:cubicBezTo>
                  <a:pt x="1310372" y="245191"/>
                  <a:pt x="1317625" y="245533"/>
                  <a:pt x="1323975" y="247650"/>
                </a:cubicBezTo>
                <a:lnTo>
                  <a:pt x="1352550" y="257175"/>
                </a:lnTo>
                <a:lnTo>
                  <a:pt x="1362075" y="260350"/>
                </a:lnTo>
                <a:cubicBezTo>
                  <a:pt x="1365250" y="261408"/>
                  <a:pt x="1368815" y="261669"/>
                  <a:pt x="1371600" y="263525"/>
                </a:cubicBezTo>
                <a:lnTo>
                  <a:pt x="1400175" y="282575"/>
                </a:lnTo>
                <a:lnTo>
                  <a:pt x="1409700" y="288925"/>
                </a:lnTo>
                <a:cubicBezTo>
                  <a:pt x="1419763" y="304019"/>
                  <a:pt x="1412430" y="297243"/>
                  <a:pt x="1435100" y="304800"/>
                </a:cubicBezTo>
                <a:lnTo>
                  <a:pt x="1444625" y="307975"/>
                </a:lnTo>
                <a:cubicBezTo>
                  <a:pt x="1466955" y="300532"/>
                  <a:pt x="1440190" y="308714"/>
                  <a:pt x="1482725" y="301625"/>
                </a:cubicBezTo>
                <a:cubicBezTo>
                  <a:pt x="1491488" y="300164"/>
                  <a:pt x="1494461" y="296976"/>
                  <a:pt x="1501775" y="292100"/>
                </a:cubicBezTo>
                <a:cubicBezTo>
                  <a:pt x="1511838" y="277006"/>
                  <a:pt x="1504505" y="283782"/>
                  <a:pt x="1527175" y="276225"/>
                </a:cubicBezTo>
                <a:lnTo>
                  <a:pt x="1536700" y="273050"/>
                </a:lnTo>
                <a:cubicBezTo>
                  <a:pt x="1538817" y="269875"/>
                  <a:pt x="1543050" y="267341"/>
                  <a:pt x="1543050" y="263525"/>
                </a:cubicBezTo>
                <a:cubicBezTo>
                  <a:pt x="1543050" y="254148"/>
                  <a:pt x="1528980" y="250638"/>
                  <a:pt x="1524000" y="247650"/>
                </a:cubicBezTo>
                <a:cubicBezTo>
                  <a:pt x="1517456" y="243723"/>
                  <a:pt x="1504950" y="234950"/>
                  <a:pt x="1504950" y="234950"/>
                </a:cubicBezTo>
                <a:cubicBezTo>
                  <a:pt x="1489851" y="189654"/>
                  <a:pt x="1511261" y="244416"/>
                  <a:pt x="1479550" y="196850"/>
                </a:cubicBezTo>
                <a:cubicBezTo>
                  <a:pt x="1477433" y="193675"/>
                  <a:pt x="1474750" y="190812"/>
                  <a:pt x="1473200" y="187325"/>
                </a:cubicBezTo>
                <a:cubicBezTo>
                  <a:pt x="1470482" y="181208"/>
                  <a:pt x="1466850" y="168275"/>
                  <a:pt x="1466850" y="168275"/>
                </a:cubicBezTo>
                <a:cubicBezTo>
                  <a:pt x="1472104" y="152512"/>
                  <a:pt x="1468943" y="149000"/>
                  <a:pt x="1482725" y="142875"/>
                </a:cubicBezTo>
                <a:cubicBezTo>
                  <a:pt x="1488842" y="140157"/>
                  <a:pt x="1501775" y="136525"/>
                  <a:pt x="1501775" y="136525"/>
                </a:cubicBezTo>
                <a:cubicBezTo>
                  <a:pt x="1504950" y="137583"/>
                  <a:pt x="1507974" y="140070"/>
                  <a:pt x="1511300" y="139700"/>
                </a:cubicBezTo>
                <a:cubicBezTo>
                  <a:pt x="1517953" y="138961"/>
                  <a:pt x="1524000" y="135467"/>
                  <a:pt x="1530350" y="133350"/>
                </a:cubicBezTo>
                <a:cubicBezTo>
                  <a:pt x="1533525" y="132292"/>
                  <a:pt x="1536554" y="130590"/>
                  <a:pt x="1539875" y="130175"/>
                </a:cubicBezTo>
                <a:cubicBezTo>
                  <a:pt x="1572626" y="126081"/>
                  <a:pt x="1556742" y="127000"/>
                  <a:pt x="1587500" y="127000"/>
                </a:cubicBezTo>
              </a:path>
            </a:pathLst>
          </a:custGeom>
          <a:ln w="6350" cmpd="sng">
            <a:solidFill>
              <a:srgbClr val="FFFFFF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Freeform 3"/>
          <p:cNvSpPr/>
          <p:nvPr/>
        </p:nvSpPr>
        <p:spPr>
          <a:xfrm>
            <a:off x="1454150" y="7327900"/>
            <a:ext cx="1562100" cy="752475"/>
          </a:xfrm>
          <a:custGeom>
            <a:avLst/>
            <a:gdLst>
              <a:gd name="connsiteX0" fmla="*/ 34925 w 1562100"/>
              <a:gd name="connsiteY0" fmla="*/ 752475 h 752475"/>
              <a:gd name="connsiteX1" fmla="*/ 31750 w 1562100"/>
              <a:gd name="connsiteY1" fmla="*/ 711200 h 752475"/>
              <a:gd name="connsiteX2" fmla="*/ 28575 w 1562100"/>
              <a:gd name="connsiteY2" fmla="*/ 688975 h 752475"/>
              <a:gd name="connsiteX3" fmla="*/ 22225 w 1562100"/>
              <a:gd name="connsiteY3" fmla="*/ 638175 h 752475"/>
              <a:gd name="connsiteX4" fmla="*/ 15875 w 1562100"/>
              <a:gd name="connsiteY4" fmla="*/ 574675 h 752475"/>
              <a:gd name="connsiteX5" fmla="*/ 9525 w 1562100"/>
              <a:gd name="connsiteY5" fmla="*/ 555625 h 752475"/>
              <a:gd name="connsiteX6" fmla="*/ 0 w 1562100"/>
              <a:gd name="connsiteY6" fmla="*/ 536575 h 752475"/>
              <a:gd name="connsiteX7" fmla="*/ 3175 w 1562100"/>
              <a:gd name="connsiteY7" fmla="*/ 476250 h 752475"/>
              <a:gd name="connsiteX8" fmla="*/ 12700 w 1562100"/>
              <a:gd name="connsiteY8" fmla="*/ 438150 h 752475"/>
              <a:gd name="connsiteX9" fmla="*/ 19050 w 1562100"/>
              <a:gd name="connsiteY9" fmla="*/ 428625 h 752475"/>
              <a:gd name="connsiteX10" fmla="*/ 38100 w 1562100"/>
              <a:gd name="connsiteY10" fmla="*/ 415925 h 752475"/>
              <a:gd name="connsiteX11" fmla="*/ 47625 w 1562100"/>
              <a:gd name="connsiteY11" fmla="*/ 409575 h 752475"/>
              <a:gd name="connsiteX12" fmla="*/ 76200 w 1562100"/>
              <a:gd name="connsiteY12" fmla="*/ 400050 h 752475"/>
              <a:gd name="connsiteX13" fmla="*/ 85725 w 1562100"/>
              <a:gd name="connsiteY13" fmla="*/ 396875 h 752475"/>
              <a:gd name="connsiteX14" fmla="*/ 98425 w 1562100"/>
              <a:gd name="connsiteY14" fmla="*/ 393700 h 752475"/>
              <a:gd name="connsiteX15" fmla="*/ 234950 w 1562100"/>
              <a:gd name="connsiteY15" fmla="*/ 396875 h 752475"/>
              <a:gd name="connsiteX16" fmla="*/ 244475 w 1562100"/>
              <a:gd name="connsiteY16" fmla="*/ 403225 h 752475"/>
              <a:gd name="connsiteX17" fmla="*/ 260350 w 1562100"/>
              <a:gd name="connsiteY17" fmla="*/ 431800 h 752475"/>
              <a:gd name="connsiteX18" fmla="*/ 266700 w 1562100"/>
              <a:gd name="connsiteY18" fmla="*/ 441325 h 752475"/>
              <a:gd name="connsiteX19" fmla="*/ 269875 w 1562100"/>
              <a:gd name="connsiteY19" fmla="*/ 450850 h 752475"/>
              <a:gd name="connsiteX20" fmla="*/ 282575 w 1562100"/>
              <a:gd name="connsiteY20" fmla="*/ 469900 h 752475"/>
              <a:gd name="connsiteX21" fmla="*/ 285750 w 1562100"/>
              <a:gd name="connsiteY21" fmla="*/ 479425 h 752475"/>
              <a:gd name="connsiteX22" fmla="*/ 292100 w 1562100"/>
              <a:gd name="connsiteY22" fmla="*/ 488950 h 752475"/>
              <a:gd name="connsiteX23" fmla="*/ 298450 w 1562100"/>
              <a:gd name="connsiteY23" fmla="*/ 508000 h 752475"/>
              <a:gd name="connsiteX24" fmla="*/ 301625 w 1562100"/>
              <a:gd name="connsiteY24" fmla="*/ 517525 h 752475"/>
              <a:gd name="connsiteX25" fmla="*/ 304800 w 1562100"/>
              <a:gd name="connsiteY25" fmla="*/ 527050 h 752475"/>
              <a:gd name="connsiteX26" fmla="*/ 307975 w 1562100"/>
              <a:gd name="connsiteY26" fmla="*/ 536575 h 752475"/>
              <a:gd name="connsiteX27" fmla="*/ 311150 w 1562100"/>
              <a:gd name="connsiteY27" fmla="*/ 587375 h 752475"/>
              <a:gd name="connsiteX28" fmla="*/ 314325 w 1562100"/>
              <a:gd name="connsiteY28" fmla="*/ 596900 h 752475"/>
              <a:gd name="connsiteX29" fmla="*/ 323850 w 1562100"/>
              <a:gd name="connsiteY29" fmla="*/ 603250 h 752475"/>
              <a:gd name="connsiteX30" fmla="*/ 381000 w 1562100"/>
              <a:gd name="connsiteY30" fmla="*/ 600075 h 752475"/>
              <a:gd name="connsiteX31" fmla="*/ 409575 w 1562100"/>
              <a:gd name="connsiteY31" fmla="*/ 593725 h 752475"/>
              <a:gd name="connsiteX32" fmla="*/ 419100 w 1562100"/>
              <a:gd name="connsiteY32" fmla="*/ 587375 h 752475"/>
              <a:gd name="connsiteX33" fmla="*/ 428625 w 1562100"/>
              <a:gd name="connsiteY33" fmla="*/ 555625 h 752475"/>
              <a:gd name="connsiteX34" fmla="*/ 428625 w 1562100"/>
              <a:gd name="connsiteY34" fmla="*/ 377825 h 752475"/>
              <a:gd name="connsiteX35" fmla="*/ 425450 w 1562100"/>
              <a:gd name="connsiteY35" fmla="*/ 358775 h 752475"/>
              <a:gd name="connsiteX36" fmla="*/ 415925 w 1562100"/>
              <a:gd name="connsiteY36" fmla="*/ 327025 h 752475"/>
              <a:gd name="connsiteX37" fmla="*/ 412750 w 1562100"/>
              <a:gd name="connsiteY37" fmla="*/ 317500 h 752475"/>
              <a:gd name="connsiteX38" fmla="*/ 409575 w 1562100"/>
              <a:gd name="connsiteY38" fmla="*/ 307975 h 752475"/>
              <a:gd name="connsiteX39" fmla="*/ 409575 w 1562100"/>
              <a:gd name="connsiteY39" fmla="*/ 238125 h 752475"/>
              <a:gd name="connsiteX40" fmla="*/ 419100 w 1562100"/>
              <a:gd name="connsiteY40" fmla="*/ 234950 h 752475"/>
              <a:gd name="connsiteX41" fmla="*/ 438150 w 1562100"/>
              <a:gd name="connsiteY41" fmla="*/ 241300 h 752475"/>
              <a:gd name="connsiteX42" fmla="*/ 466725 w 1562100"/>
              <a:gd name="connsiteY42" fmla="*/ 257175 h 752475"/>
              <a:gd name="connsiteX43" fmla="*/ 479425 w 1562100"/>
              <a:gd name="connsiteY43" fmla="*/ 276225 h 752475"/>
              <a:gd name="connsiteX44" fmla="*/ 485775 w 1562100"/>
              <a:gd name="connsiteY44" fmla="*/ 295275 h 752475"/>
              <a:gd name="connsiteX45" fmla="*/ 488950 w 1562100"/>
              <a:gd name="connsiteY45" fmla="*/ 304800 h 752475"/>
              <a:gd name="connsiteX46" fmla="*/ 492125 w 1562100"/>
              <a:gd name="connsiteY46" fmla="*/ 317500 h 752475"/>
              <a:gd name="connsiteX47" fmla="*/ 498475 w 1562100"/>
              <a:gd name="connsiteY47" fmla="*/ 336550 h 752475"/>
              <a:gd name="connsiteX48" fmla="*/ 501650 w 1562100"/>
              <a:gd name="connsiteY48" fmla="*/ 346075 h 752475"/>
              <a:gd name="connsiteX49" fmla="*/ 511175 w 1562100"/>
              <a:gd name="connsiteY49" fmla="*/ 355600 h 752475"/>
              <a:gd name="connsiteX50" fmla="*/ 517525 w 1562100"/>
              <a:gd name="connsiteY50" fmla="*/ 365125 h 752475"/>
              <a:gd name="connsiteX51" fmla="*/ 536575 w 1562100"/>
              <a:gd name="connsiteY51" fmla="*/ 377825 h 752475"/>
              <a:gd name="connsiteX52" fmla="*/ 555625 w 1562100"/>
              <a:gd name="connsiteY52" fmla="*/ 384175 h 752475"/>
              <a:gd name="connsiteX53" fmla="*/ 565150 w 1562100"/>
              <a:gd name="connsiteY53" fmla="*/ 387350 h 752475"/>
              <a:gd name="connsiteX54" fmla="*/ 574675 w 1562100"/>
              <a:gd name="connsiteY54" fmla="*/ 393700 h 752475"/>
              <a:gd name="connsiteX55" fmla="*/ 584200 w 1562100"/>
              <a:gd name="connsiteY55" fmla="*/ 396875 h 752475"/>
              <a:gd name="connsiteX56" fmla="*/ 603250 w 1562100"/>
              <a:gd name="connsiteY56" fmla="*/ 409575 h 752475"/>
              <a:gd name="connsiteX57" fmla="*/ 628650 w 1562100"/>
              <a:gd name="connsiteY57" fmla="*/ 415925 h 752475"/>
              <a:gd name="connsiteX58" fmla="*/ 638175 w 1562100"/>
              <a:gd name="connsiteY58" fmla="*/ 419100 h 752475"/>
              <a:gd name="connsiteX59" fmla="*/ 666750 w 1562100"/>
              <a:gd name="connsiteY59" fmla="*/ 425450 h 752475"/>
              <a:gd name="connsiteX60" fmla="*/ 695325 w 1562100"/>
              <a:gd name="connsiteY60" fmla="*/ 422275 h 752475"/>
              <a:gd name="connsiteX61" fmla="*/ 708025 w 1562100"/>
              <a:gd name="connsiteY61" fmla="*/ 419100 h 752475"/>
              <a:gd name="connsiteX62" fmla="*/ 714375 w 1562100"/>
              <a:gd name="connsiteY62" fmla="*/ 409575 h 752475"/>
              <a:gd name="connsiteX63" fmla="*/ 720725 w 1562100"/>
              <a:gd name="connsiteY63" fmla="*/ 390525 h 752475"/>
              <a:gd name="connsiteX64" fmla="*/ 720725 w 1562100"/>
              <a:gd name="connsiteY64" fmla="*/ 371475 h 752475"/>
              <a:gd name="connsiteX65" fmla="*/ 727075 w 1562100"/>
              <a:gd name="connsiteY65" fmla="*/ 327025 h 752475"/>
              <a:gd name="connsiteX66" fmla="*/ 733425 w 1562100"/>
              <a:gd name="connsiteY66" fmla="*/ 307975 h 752475"/>
              <a:gd name="connsiteX67" fmla="*/ 730250 w 1562100"/>
              <a:gd name="connsiteY67" fmla="*/ 241300 h 752475"/>
              <a:gd name="connsiteX68" fmla="*/ 720725 w 1562100"/>
              <a:gd name="connsiteY68" fmla="*/ 222250 h 752475"/>
              <a:gd name="connsiteX69" fmla="*/ 717550 w 1562100"/>
              <a:gd name="connsiteY69" fmla="*/ 212725 h 752475"/>
              <a:gd name="connsiteX70" fmla="*/ 711200 w 1562100"/>
              <a:gd name="connsiteY70" fmla="*/ 184150 h 752475"/>
              <a:gd name="connsiteX71" fmla="*/ 708025 w 1562100"/>
              <a:gd name="connsiteY71" fmla="*/ 174625 h 752475"/>
              <a:gd name="connsiteX72" fmla="*/ 701675 w 1562100"/>
              <a:gd name="connsiteY72" fmla="*/ 165100 h 752475"/>
              <a:gd name="connsiteX73" fmla="*/ 692150 w 1562100"/>
              <a:gd name="connsiteY73" fmla="*/ 146050 h 752475"/>
              <a:gd name="connsiteX74" fmla="*/ 682625 w 1562100"/>
              <a:gd name="connsiteY74" fmla="*/ 142875 h 752475"/>
              <a:gd name="connsiteX75" fmla="*/ 676275 w 1562100"/>
              <a:gd name="connsiteY75" fmla="*/ 133350 h 752475"/>
              <a:gd name="connsiteX76" fmla="*/ 666750 w 1562100"/>
              <a:gd name="connsiteY76" fmla="*/ 127000 h 752475"/>
              <a:gd name="connsiteX77" fmla="*/ 654050 w 1562100"/>
              <a:gd name="connsiteY77" fmla="*/ 107950 h 752475"/>
              <a:gd name="connsiteX78" fmla="*/ 657225 w 1562100"/>
              <a:gd name="connsiteY78" fmla="*/ 60325 h 752475"/>
              <a:gd name="connsiteX79" fmla="*/ 669925 w 1562100"/>
              <a:gd name="connsiteY79" fmla="*/ 31750 h 752475"/>
              <a:gd name="connsiteX80" fmla="*/ 688975 w 1562100"/>
              <a:gd name="connsiteY80" fmla="*/ 25400 h 752475"/>
              <a:gd name="connsiteX81" fmla="*/ 720725 w 1562100"/>
              <a:gd name="connsiteY81" fmla="*/ 19050 h 752475"/>
              <a:gd name="connsiteX82" fmla="*/ 752475 w 1562100"/>
              <a:gd name="connsiteY82" fmla="*/ 15875 h 752475"/>
              <a:gd name="connsiteX83" fmla="*/ 784225 w 1562100"/>
              <a:gd name="connsiteY83" fmla="*/ 9525 h 752475"/>
              <a:gd name="connsiteX84" fmla="*/ 803275 w 1562100"/>
              <a:gd name="connsiteY84" fmla="*/ 3175 h 752475"/>
              <a:gd name="connsiteX85" fmla="*/ 815975 w 1562100"/>
              <a:gd name="connsiteY85" fmla="*/ 0 h 752475"/>
              <a:gd name="connsiteX86" fmla="*/ 869950 w 1562100"/>
              <a:gd name="connsiteY86" fmla="*/ 6350 h 752475"/>
              <a:gd name="connsiteX87" fmla="*/ 889000 w 1562100"/>
              <a:gd name="connsiteY87" fmla="*/ 12700 h 752475"/>
              <a:gd name="connsiteX88" fmla="*/ 908050 w 1562100"/>
              <a:gd name="connsiteY88" fmla="*/ 25400 h 752475"/>
              <a:gd name="connsiteX89" fmla="*/ 917575 w 1562100"/>
              <a:gd name="connsiteY89" fmla="*/ 31750 h 752475"/>
              <a:gd name="connsiteX90" fmla="*/ 936625 w 1562100"/>
              <a:gd name="connsiteY90" fmla="*/ 38100 h 752475"/>
              <a:gd name="connsiteX91" fmla="*/ 946150 w 1562100"/>
              <a:gd name="connsiteY91" fmla="*/ 41275 h 752475"/>
              <a:gd name="connsiteX92" fmla="*/ 955675 w 1562100"/>
              <a:gd name="connsiteY92" fmla="*/ 47625 h 752475"/>
              <a:gd name="connsiteX93" fmla="*/ 977900 w 1562100"/>
              <a:gd name="connsiteY93" fmla="*/ 73025 h 752475"/>
              <a:gd name="connsiteX94" fmla="*/ 984250 w 1562100"/>
              <a:gd name="connsiteY94" fmla="*/ 82550 h 752475"/>
              <a:gd name="connsiteX95" fmla="*/ 1012825 w 1562100"/>
              <a:gd name="connsiteY95" fmla="*/ 101600 h 752475"/>
              <a:gd name="connsiteX96" fmla="*/ 1022350 w 1562100"/>
              <a:gd name="connsiteY96" fmla="*/ 107950 h 752475"/>
              <a:gd name="connsiteX97" fmla="*/ 1031875 w 1562100"/>
              <a:gd name="connsiteY97" fmla="*/ 114300 h 752475"/>
              <a:gd name="connsiteX98" fmla="*/ 1047750 w 1562100"/>
              <a:gd name="connsiteY98" fmla="*/ 127000 h 752475"/>
              <a:gd name="connsiteX99" fmla="*/ 1066800 w 1562100"/>
              <a:gd name="connsiteY99" fmla="*/ 142875 h 752475"/>
              <a:gd name="connsiteX100" fmla="*/ 1085850 w 1562100"/>
              <a:gd name="connsiteY100" fmla="*/ 149225 h 752475"/>
              <a:gd name="connsiteX101" fmla="*/ 1152525 w 1562100"/>
              <a:gd name="connsiteY101" fmla="*/ 146050 h 752475"/>
              <a:gd name="connsiteX102" fmla="*/ 1171575 w 1562100"/>
              <a:gd name="connsiteY102" fmla="*/ 139700 h 752475"/>
              <a:gd name="connsiteX103" fmla="*/ 1190625 w 1562100"/>
              <a:gd name="connsiteY103" fmla="*/ 136525 h 752475"/>
              <a:gd name="connsiteX104" fmla="*/ 1238250 w 1562100"/>
              <a:gd name="connsiteY104" fmla="*/ 139700 h 752475"/>
              <a:gd name="connsiteX105" fmla="*/ 1279525 w 1562100"/>
              <a:gd name="connsiteY105" fmla="*/ 146050 h 752475"/>
              <a:gd name="connsiteX106" fmla="*/ 1295400 w 1562100"/>
              <a:gd name="connsiteY106" fmla="*/ 193675 h 752475"/>
              <a:gd name="connsiteX107" fmla="*/ 1298575 w 1562100"/>
              <a:gd name="connsiteY107" fmla="*/ 203200 h 752475"/>
              <a:gd name="connsiteX108" fmla="*/ 1301750 w 1562100"/>
              <a:gd name="connsiteY108" fmla="*/ 212725 h 752475"/>
              <a:gd name="connsiteX109" fmla="*/ 1308100 w 1562100"/>
              <a:gd name="connsiteY109" fmla="*/ 222250 h 752475"/>
              <a:gd name="connsiteX110" fmla="*/ 1311275 w 1562100"/>
              <a:gd name="connsiteY110" fmla="*/ 231775 h 752475"/>
              <a:gd name="connsiteX111" fmla="*/ 1317625 w 1562100"/>
              <a:gd name="connsiteY111" fmla="*/ 241300 h 752475"/>
              <a:gd name="connsiteX112" fmla="*/ 1336675 w 1562100"/>
              <a:gd name="connsiteY112" fmla="*/ 260350 h 752475"/>
              <a:gd name="connsiteX113" fmla="*/ 1349375 w 1562100"/>
              <a:gd name="connsiteY113" fmla="*/ 276225 h 752475"/>
              <a:gd name="connsiteX114" fmla="*/ 1365250 w 1562100"/>
              <a:gd name="connsiteY114" fmla="*/ 292100 h 752475"/>
              <a:gd name="connsiteX115" fmla="*/ 1374775 w 1562100"/>
              <a:gd name="connsiteY115" fmla="*/ 314325 h 752475"/>
              <a:gd name="connsiteX116" fmla="*/ 1381125 w 1562100"/>
              <a:gd name="connsiteY116" fmla="*/ 333375 h 752475"/>
              <a:gd name="connsiteX117" fmla="*/ 1387475 w 1562100"/>
              <a:gd name="connsiteY117" fmla="*/ 352425 h 752475"/>
              <a:gd name="connsiteX118" fmla="*/ 1390650 w 1562100"/>
              <a:gd name="connsiteY118" fmla="*/ 361950 h 752475"/>
              <a:gd name="connsiteX119" fmla="*/ 1393825 w 1562100"/>
              <a:gd name="connsiteY119" fmla="*/ 374650 h 752475"/>
              <a:gd name="connsiteX120" fmla="*/ 1409700 w 1562100"/>
              <a:gd name="connsiteY120" fmla="*/ 403225 h 752475"/>
              <a:gd name="connsiteX121" fmla="*/ 1438275 w 1562100"/>
              <a:gd name="connsiteY121" fmla="*/ 412750 h 752475"/>
              <a:gd name="connsiteX122" fmla="*/ 1447800 w 1562100"/>
              <a:gd name="connsiteY122" fmla="*/ 415925 h 752475"/>
              <a:gd name="connsiteX123" fmla="*/ 1454150 w 1562100"/>
              <a:gd name="connsiteY123" fmla="*/ 425450 h 752475"/>
              <a:gd name="connsiteX124" fmla="*/ 1473200 w 1562100"/>
              <a:gd name="connsiteY124" fmla="*/ 431800 h 752475"/>
              <a:gd name="connsiteX125" fmla="*/ 1492250 w 1562100"/>
              <a:gd name="connsiteY125" fmla="*/ 428625 h 752475"/>
              <a:gd name="connsiteX126" fmla="*/ 1517650 w 1562100"/>
              <a:gd name="connsiteY126" fmla="*/ 425450 h 752475"/>
              <a:gd name="connsiteX127" fmla="*/ 1536700 w 1562100"/>
              <a:gd name="connsiteY127" fmla="*/ 415925 h 752475"/>
              <a:gd name="connsiteX128" fmla="*/ 1562100 w 1562100"/>
              <a:gd name="connsiteY128" fmla="*/ 412750 h 7524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</a:cxnLst>
            <a:rect l="l" t="t" r="r" b="b"/>
            <a:pathLst>
              <a:path w="1562100" h="752475">
                <a:moveTo>
                  <a:pt x="34925" y="752475"/>
                </a:moveTo>
                <a:cubicBezTo>
                  <a:pt x="33867" y="738717"/>
                  <a:pt x="33123" y="724930"/>
                  <a:pt x="31750" y="711200"/>
                </a:cubicBezTo>
                <a:cubicBezTo>
                  <a:pt x="31005" y="703754"/>
                  <a:pt x="29401" y="696413"/>
                  <a:pt x="28575" y="688975"/>
                </a:cubicBezTo>
                <a:cubicBezTo>
                  <a:pt x="23080" y="639517"/>
                  <a:pt x="28538" y="669741"/>
                  <a:pt x="22225" y="638175"/>
                </a:cubicBezTo>
                <a:cubicBezTo>
                  <a:pt x="21184" y="623595"/>
                  <a:pt x="20369" y="592650"/>
                  <a:pt x="15875" y="574675"/>
                </a:cubicBezTo>
                <a:cubicBezTo>
                  <a:pt x="14252" y="568181"/>
                  <a:pt x="13238" y="561194"/>
                  <a:pt x="9525" y="555625"/>
                </a:cubicBezTo>
                <a:cubicBezTo>
                  <a:pt x="1319" y="543315"/>
                  <a:pt x="4382" y="549720"/>
                  <a:pt x="0" y="536575"/>
                </a:cubicBezTo>
                <a:cubicBezTo>
                  <a:pt x="1058" y="516467"/>
                  <a:pt x="1569" y="496322"/>
                  <a:pt x="3175" y="476250"/>
                </a:cubicBezTo>
                <a:cubicBezTo>
                  <a:pt x="3824" y="468135"/>
                  <a:pt x="8085" y="445073"/>
                  <a:pt x="12700" y="438150"/>
                </a:cubicBezTo>
                <a:cubicBezTo>
                  <a:pt x="14817" y="434975"/>
                  <a:pt x="16178" y="431138"/>
                  <a:pt x="19050" y="428625"/>
                </a:cubicBezTo>
                <a:cubicBezTo>
                  <a:pt x="24793" y="423599"/>
                  <a:pt x="31750" y="420158"/>
                  <a:pt x="38100" y="415925"/>
                </a:cubicBezTo>
                <a:cubicBezTo>
                  <a:pt x="41275" y="413808"/>
                  <a:pt x="44005" y="410782"/>
                  <a:pt x="47625" y="409575"/>
                </a:cubicBezTo>
                <a:lnTo>
                  <a:pt x="76200" y="400050"/>
                </a:lnTo>
                <a:cubicBezTo>
                  <a:pt x="79375" y="398992"/>
                  <a:pt x="82478" y="397687"/>
                  <a:pt x="85725" y="396875"/>
                </a:cubicBezTo>
                <a:lnTo>
                  <a:pt x="98425" y="393700"/>
                </a:lnTo>
                <a:cubicBezTo>
                  <a:pt x="143933" y="394758"/>
                  <a:pt x="189526" y="393913"/>
                  <a:pt x="234950" y="396875"/>
                </a:cubicBezTo>
                <a:cubicBezTo>
                  <a:pt x="238758" y="397123"/>
                  <a:pt x="241962" y="400353"/>
                  <a:pt x="244475" y="403225"/>
                </a:cubicBezTo>
                <a:cubicBezTo>
                  <a:pt x="267834" y="429921"/>
                  <a:pt x="250902" y="412903"/>
                  <a:pt x="260350" y="431800"/>
                </a:cubicBezTo>
                <a:cubicBezTo>
                  <a:pt x="262057" y="435213"/>
                  <a:pt x="264993" y="437912"/>
                  <a:pt x="266700" y="441325"/>
                </a:cubicBezTo>
                <a:cubicBezTo>
                  <a:pt x="268197" y="444318"/>
                  <a:pt x="268250" y="447924"/>
                  <a:pt x="269875" y="450850"/>
                </a:cubicBezTo>
                <a:cubicBezTo>
                  <a:pt x="273581" y="457521"/>
                  <a:pt x="280162" y="462660"/>
                  <a:pt x="282575" y="469900"/>
                </a:cubicBezTo>
                <a:cubicBezTo>
                  <a:pt x="283633" y="473075"/>
                  <a:pt x="284253" y="476432"/>
                  <a:pt x="285750" y="479425"/>
                </a:cubicBezTo>
                <a:cubicBezTo>
                  <a:pt x="287457" y="482838"/>
                  <a:pt x="290550" y="485463"/>
                  <a:pt x="292100" y="488950"/>
                </a:cubicBezTo>
                <a:cubicBezTo>
                  <a:pt x="294818" y="495067"/>
                  <a:pt x="296333" y="501650"/>
                  <a:pt x="298450" y="508000"/>
                </a:cubicBezTo>
                <a:lnTo>
                  <a:pt x="301625" y="517525"/>
                </a:lnTo>
                <a:lnTo>
                  <a:pt x="304800" y="527050"/>
                </a:lnTo>
                <a:lnTo>
                  <a:pt x="307975" y="536575"/>
                </a:lnTo>
                <a:cubicBezTo>
                  <a:pt x="309033" y="553508"/>
                  <a:pt x="309374" y="570502"/>
                  <a:pt x="311150" y="587375"/>
                </a:cubicBezTo>
                <a:cubicBezTo>
                  <a:pt x="311500" y="590703"/>
                  <a:pt x="312234" y="594287"/>
                  <a:pt x="314325" y="596900"/>
                </a:cubicBezTo>
                <a:cubicBezTo>
                  <a:pt x="316709" y="599880"/>
                  <a:pt x="320675" y="601133"/>
                  <a:pt x="323850" y="603250"/>
                </a:cubicBezTo>
                <a:cubicBezTo>
                  <a:pt x="342900" y="602192"/>
                  <a:pt x="361992" y="601728"/>
                  <a:pt x="381000" y="600075"/>
                </a:cubicBezTo>
                <a:cubicBezTo>
                  <a:pt x="387181" y="599538"/>
                  <a:pt x="402939" y="595384"/>
                  <a:pt x="409575" y="593725"/>
                </a:cubicBezTo>
                <a:cubicBezTo>
                  <a:pt x="412750" y="591608"/>
                  <a:pt x="417078" y="590611"/>
                  <a:pt x="419100" y="587375"/>
                </a:cubicBezTo>
                <a:cubicBezTo>
                  <a:pt x="422321" y="582222"/>
                  <a:pt x="426766" y="563060"/>
                  <a:pt x="428625" y="555625"/>
                </a:cubicBezTo>
                <a:cubicBezTo>
                  <a:pt x="434768" y="475760"/>
                  <a:pt x="433845" y="505725"/>
                  <a:pt x="428625" y="377825"/>
                </a:cubicBezTo>
                <a:cubicBezTo>
                  <a:pt x="428362" y="371393"/>
                  <a:pt x="426713" y="365088"/>
                  <a:pt x="425450" y="358775"/>
                </a:cubicBezTo>
                <a:cubicBezTo>
                  <a:pt x="423051" y="346779"/>
                  <a:pt x="419975" y="339174"/>
                  <a:pt x="415925" y="327025"/>
                </a:cubicBezTo>
                <a:lnTo>
                  <a:pt x="412750" y="317500"/>
                </a:lnTo>
                <a:lnTo>
                  <a:pt x="409575" y="307975"/>
                </a:lnTo>
                <a:cubicBezTo>
                  <a:pt x="406453" y="283000"/>
                  <a:pt x="402492" y="264686"/>
                  <a:pt x="409575" y="238125"/>
                </a:cubicBezTo>
                <a:cubicBezTo>
                  <a:pt x="410437" y="234891"/>
                  <a:pt x="415925" y="236008"/>
                  <a:pt x="419100" y="234950"/>
                </a:cubicBezTo>
                <a:cubicBezTo>
                  <a:pt x="425450" y="237067"/>
                  <a:pt x="432581" y="237587"/>
                  <a:pt x="438150" y="241300"/>
                </a:cubicBezTo>
                <a:cubicBezTo>
                  <a:pt x="459985" y="255856"/>
                  <a:pt x="449960" y="251587"/>
                  <a:pt x="466725" y="257175"/>
                </a:cubicBezTo>
                <a:cubicBezTo>
                  <a:pt x="470958" y="263525"/>
                  <a:pt x="477012" y="268985"/>
                  <a:pt x="479425" y="276225"/>
                </a:cubicBezTo>
                <a:lnTo>
                  <a:pt x="485775" y="295275"/>
                </a:lnTo>
                <a:cubicBezTo>
                  <a:pt x="486833" y="298450"/>
                  <a:pt x="488138" y="301553"/>
                  <a:pt x="488950" y="304800"/>
                </a:cubicBezTo>
                <a:cubicBezTo>
                  <a:pt x="490008" y="309033"/>
                  <a:pt x="490871" y="313320"/>
                  <a:pt x="492125" y="317500"/>
                </a:cubicBezTo>
                <a:cubicBezTo>
                  <a:pt x="494048" y="323911"/>
                  <a:pt x="496358" y="330200"/>
                  <a:pt x="498475" y="336550"/>
                </a:cubicBezTo>
                <a:cubicBezTo>
                  <a:pt x="499533" y="339725"/>
                  <a:pt x="499283" y="343708"/>
                  <a:pt x="501650" y="346075"/>
                </a:cubicBezTo>
                <a:cubicBezTo>
                  <a:pt x="504825" y="349250"/>
                  <a:pt x="508300" y="352151"/>
                  <a:pt x="511175" y="355600"/>
                </a:cubicBezTo>
                <a:cubicBezTo>
                  <a:pt x="513618" y="358531"/>
                  <a:pt x="514653" y="362612"/>
                  <a:pt x="517525" y="365125"/>
                </a:cubicBezTo>
                <a:cubicBezTo>
                  <a:pt x="523268" y="370151"/>
                  <a:pt x="529335" y="375412"/>
                  <a:pt x="536575" y="377825"/>
                </a:cubicBezTo>
                <a:lnTo>
                  <a:pt x="555625" y="384175"/>
                </a:lnTo>
                <a:cubicBezTo>
                  <a:pt x="558800" y="385233"/>
                  <a:pt x="562365" y="385494"/>
                  <a:pt x="565150" y="387350"/>
                </a:cubicBezTo>
                <a:cubicBezTo>
                  <a:pt x="568325" y="389467"/>
                  <a:pt x="571262" y="391993"/>
                  <a:pt x="574675" y="393700"/>
                </a:cubicBezTo>
                <a:cubicBezTo>
                  <a:pt x="577668" y="395197"/>
                  <a:pt x="581274" y="395250"/>
                  <a:pt x="584200" y="396875"/>
                </a:cubicBezTo>
                <a:cubicBezTo>
                  <a:pt x="590871" y="400581"/>
                  <a:pt x="595846" y="407724"/>
                  <a:pt x="603250" y="409575"/>
                </a:cubicBezTo>
                <a:cubicBezTo>
                  <a:pt x="611717" y="411692"/>
                  <a:pt x="620371" y="413165"/>
                  <a:pt x="628650" y="415925"/>
                </a:cubicBezTo>
                <a:cubicBezTo>
                  <a:pt x="631825" y="416983"/>
                  <a:pt x="634957" y="418181"/>
                  <a:pt x="638175" y="419100"/>
                </a:cubicBezTo>
                <a:cubicBezTo>
                  <a:pt x="648637" y="422089"/>
                  <a:pt x="655838" y="423268"/>
                  <a:pt x="666750" y="425450"/>
                </a:cubicBezTo>
                <a:cubicBezTo>
                  <a:pt x="676275" y="424392"/>
                  <a:pt x="685853" y="423732"/>
                  <a:pt x="695325" y="422275"/>
                </a:cubicBezTo>
                <a:cubicBezTo>
                  <a:pt x="699638" y="421611"/>
                  <a:pt x="704394" y="421521"/>
                  <a:pt x="708025" y="419100"/>
                </a:cubicBezTo>
                <a:cubicBezTo>
                  <a:pt x="711200" y="416983"/>
                  <a:pt x="712825" y="413062"/>
                  <a:pt x="714375" y="409575"/>
                </a:cubicBezTo>
                <a:cubicBezTo>
                  <a:pt x="717093" y="403458"/>
                  <a:pt x="720725" y="390525"/>
                  <a:pt x="720725" y="390525"/>
                </a:cubicBezTo>
                <a:cubicBezTo>
                  <a:pt x="715081" y="373592"/>
                  <a:pt x="717903" y="388408"/>
                  <a:pt x="720725" y="371475"/>
                </a:cubicBezTo>
                <a:cubicBezTo>
                  <a:pt x="724215" y="350535"/>
                  <a:pt x="722179" y="344978"/>
                  <a:pt x="727075" y="327025"/>
                </a:cubicBezTo>
                <a:cubicBezTo>
                  <a:pt x="728836" y="320567"/>
                  <a:pt x="733425" y="307975"/>
                  <a:pt x="733425" y="307975"/>
                </a:cubicBezTo>
                <a:cubicBezTo>
                  <a:pt x="732367" y="285750"/>
                  <a:pt x="732098" y="263473"/>
                  <a:pt x="730250" y="241300"/>
                </a:cubicBezTo>
                <a:cubicBezTo>
                  <a:pt x="729452" y="231723"/>
                  <a:pt x="724845" y="230491"/>
                  <a:pt x="720725" y="222250"/>
                </a:cubicBezTo>
                <a:cubicBezTo>
                  <a:pt x="719228" y="219257"/>
                  <a:pt x="718362" y="215972"/>
                  <a:pt x="717550" y="212725"/>
                </a:cubicBezTo>
                <a:cubicBezTo>
                  <a:pt x="711003" y="186536"/>
                  <a:pt x="717719" y="206965"/>
                  <a:pt x="711200" y="184150"/>
                </a:cubicBezTo>
                <a:cubicBezTo>
                  <a:pt x="710281" y="180932"/>
                  <a:pt x="709522" y="177618"/>
                  <a:pt x="708025" y="174625"/>
                </a:cubicBezTo>
                <a:cubicBezTo>
                  <a:pt x="706318" y="171212"/>
                  <a:pt x="703382" y="168513"/>
                  <a:pt x="701675" y="165100"/>
                </a:cubicBezTo>
                <a:cubicBezTo>
                  <a:pt x="697840" y="157431"/>
                  <a:pt x="699733" y="152116"/>
                  <a:pt x="692150" y="146050"/>
                </a:cubicBezTo>
                <a:cubicBezTo>
                  <a:pt x="689537" y="143959"/>
                  <a:pt x="685800" y="143933"/>
                  <a:pt x="682625" y="142875"/>
                </a:cubicBezTo>
                <a:cubicBezTo>
                  <a:pt x="680508" y="139700"/>
                  <a:pt x="678973" y="136048"/>
                  <a:pt x="676275" y="133350"/>
                </a:cubicBezTo>
                <a:cubicBezTo>
                  <a:pt x="673577" y="130652"/>
                  <a:pt x="669263" y="129872"/>
                  <a:pt x="666750" y="127000"/>
                </a:cubicBezTo>
                <a:cubicBezTo>
                  <a:pt x="661724" y="121257"/>
                  <a:pt x="654050" y="107950"/>
                  <a:pt x="654050" y="107950"/>
                </a:cubicBezTo>
                <a:cubicBezTo>
                  <a:pt x="655108" y="92075"/>
                  <a:pt x="654975" y="76075"/>
                  <a:pt x="657225" y="60325"/>
                </a:cubicBezTo>
                <a:cubicBezTo>
                  <a:pt x="657617" y="57578"/>
                  <a:pt x="663946" y="35487"/>
                  <a:pt x="669925" y="31750"/>
                </a:cubicBezTo>
                <a:cubicBezTo>
                  <a:pt x="675601" y="28202"/>
                  <a:pt x="682481" y="27023"/>
                  <a:pt x="688975" y="25400"/>
                </a:cubicBezTo>
                <a:cubicBezTo>
                  <a:pt x="702644" y="21983"/>
                  <a:pt x="705156" y="20996"/>
                  <a:pt x="720725" y="19050"/>
                </a:cubicBezTo>
                <a:cubicBezTo>
                  <a:pt x="731279" y="17731"/>
                  <a:pt x="741892" y="16933"/>
                  <a:pt x="752475" y="15875"/>
                </a:cubicBezTo>
                <a:cubicBezTo>
                  <a:pt x="778889" y="7070"/>
                  <a:pt x="736797" y="20470"/>
                  <a:pt x="784225" y="9525"/>
                </a:cubicBezTo>
                <a:cubicBezTo>
                  <a:pt x="790747" y="8020"/>
                  <a:pt x="796781" y="4798"/>
                  <a:pt x="803275" y="3175"/>
                </a:cubicBezTo>
                <a:lnTo>
                  <a:pt x="815975" y="0"/>
                </a:lnTo>
                <a:cubicBezTo>
                  <a:pt x="833724" y="1479"/>
                  <a:pt x="852473" y="1584"/>
                  <a:pt x="869950" y="6350"/>
                </a:cubicBezTo>
                <a:cubicBezTo>
                  <a:pt x="876408" y="8111"/>
                  <a:pt x="883431" y="8987"/>
                  <a:pt x="889000" y="12700"/>
                </a:cubicBezTo>
                <a:lnTo>
                  <a:pt x="908050" y="25400"/>
                </a:lnTo>
                <a:cubicBezTo>
                  <a:pt x="911225" y="27517"/>
                  <a:pt x="913955" y="30543"/>
                  <a:pt x="917575" y="31750"/>
                </a:cubicBezTo>
                <a:lnTo>
                  <a:pt x="936625" y="38100"/>
                </a:lnTo>
                <a:cubicBezTo>
                  <a:pt x="939800" y="39158"/>
                  <a:pt x="943365" y="39419"/>
                  <a:pt x="946150" y="41275"/>
                </a:cubicBezTo>
                <a:lnTo>
                  <a:pt x="955675" y="47625"/>
                </a:lnTo>
                <a:cubicBezTo>
                  <a:pt x="970492" y="69850"/>
                  <a:pt x="962025" y="62442"/>
                  <a:pt x="977900" y="73025"/>
                </a:cubicBezTo>
                <a:cubicBezTo>
                  <a:pt x="980017" y="76200"/>
                  <a:pt x="981378" y="80037"/>
                  <a:pt x="984250" y="82550"/>
                </a:cubicBezTo>
                <a:lnTo>
                  <a:pt x="1012825" y="101600"/>
                </a:lnTo>
                <a:lnTo>
                  <a:pt x="1022350" y="107950"/>
                </a:lnTo>
                <a:lnTo>
                  <a:pt x="1031875" y="114300"/>
                </a:lnTo>
                <a:cubicBezTo>
                  <a:pt x="1046077" y="135602"/>
                  <a:pt x="1029347" y="114731"/>
                  <a:pt x="1047750" y="127000"/>
                </a:cubicBezTo>
                <a:cubicBezTo>
                  <a:pt x="1062704" y="136969"/>
                  <a:pt x="1051218" y="135950"/>
                  <a:pt x="1066800" y="142875"/>
                </a:cubicBezTo>
                <a:cubicBezTo>
                  <a:pt x="1072917" y="145593"/>
                  <a:pt x="1085850" y="149225"/>
                  <a:pt x="1085850" y="149225"/>
                </a:cubicBezTo>
                <a:cubicBezTo>
                  <a:pt x="1108075" y="148167"/>
                  <a:pt x="1130411" y="148507"/>
                  <a:pt x="1152525" y="146050"/>
                </a:cubicBezTo>
                <a:cubicBezTo>
                  <a:pt x="1159178" y="145311"/>
                  <a:pt x="1164973" y="140800"/>
                  <a:pt x="1171575" y="139700"/>
                </a:cubicBezTo>
                <a:lnTo>
                  <a:pt x="1190625" y="136525"/>
                </a:lnTo>
                <a:lnTo>
                  <a:pt x="1238250" y="139700"/>
                </a:lnTo>
                <a:cubicBezTo>
                  <a:pt x="1270561" y="142285"/>
                  <a:pt x="1260781" y="139802"/>
                  <a:pt x="1279525" y="146050"/>
                </a:cubicBezTo>
                <a:lnTo>
                  <a:pt x="1295400" y="193675"/>
                </a:lnTo>
                <a:lnTo>
                  <a:pt x="1298575" y="203200"/>
                </a:lnTo>
                <a:cubicBezTo>
                  <a:pt x="1299633" y="206375"/>
                  <a:pt x="1299894" y="209940"/>
                  <a:pt x="1301750" y="212725"/>
                </a:cubicBezTo>
                <a:cubicBezTo>
                  <a:pt x="1303867" y="215900"/>
                  <a:pt x="1306393" y="218837"/>
                  <a:pt x="1308100" y="222250"/>
                </a:cubicBezTo>
                <a:cubicBezTo>
                  <a:pt x="1309597" y="225243"/>
                  <a:pt x="1309778" y="228782"/>
                  <a:pt x="1311275" y="231775"/>
                </a:cubicBezTo>
                <a:cubicBezTo>
                  <a:pt x="1312982" y="235188"/>
                  <a:pt x="1315090" y="238448"/>
                  <a:pt x="1317625" y="241300"/>
                </a:cubicBezTo>
                <a:cubicBezTo>
                  <a:pt x="1323591" y="248012"/>
                  <a:pt x="1336675" y="260350"/>
                  <a:pt x="1336675" y="260350"/>
                </a:cubicBezTo>
                <a:cubicBezTo>
                  <a:pt x="1342856" y="278893"/>
                  <a:pt x="1335014" y="261864"/>
                  <a:pt x="1349375" y="276225"/>
                </a:cubicBezTo>
                <a:cubicBezTo>
                  <a:pt x="1370542" y="297392"/>
                  <a:pt x="1339850" y="275167"/>
                  <a:pt x="1365250" y="292100"/>
                </a:cubicBezTo>
                <a:cubicBezTo>
                  <a:pt x="1375470" y="322761"/>
                  <a:pt x="1359082" y="275091"/>
                  <a:pt x="1374775" y="314325"/>
                </a:cubicBezTo>
                <a:cubicBezTo>
                  <a:pt x="1377261" y="320540"/>
                  <a:pt x="1379008" y="327025"/>
                  <a:pt x="1381125" y="333375"/>
                </a:cubicBezTo>
                <a:lnTo>
                  <a:pt x="1387475" y="352425"/>
                </a:lnTo>
                <a:cubicBezTo>
                  <a:pt x="1388533" y="355600"/>
                  <a:pt x="1389838" y="358703"/>
                  <a:pt x="1390650" y="361950"/>
                </a:cubicBezTo>
                <a:cubicBezTo>
                  <a:pt x="1391708" y="366183"/>
                  <a:pt x="1392626" y="370454"/>
                  <a:pt x="1393825" y="374650"/>
                </a:cubicBezTo>
                <a:cubicBezTo>
                  <a:pt x="1396179" y="382890"/>
                  <a:pt x="1402519" y="400831"/>
                  <a:pt x="1409700" y="403225"/>
                </a:cubicBezTo>
                <a:lnTo>
                  <a:pt x="1438275" y="412750"/>
                </a:lnTo>
                <a:lnTo>
                  <a:pt x="1447800" y="415925"/>
                </a:lnTo>
                <a:cubicBezTo>
                  <a:pt x="1449917" y="419100"/>
                  <a:pt x="1450914" y="423428"/>
                  <a:pt x="1454150" y="425450"/>
                </a:cubicBezTo>
                <a:cubicBezTo>
                  <a:pt x="1459826" y="428998"/>
                  <a:pt x="1473200" y="431800"/>
                  <a:pt x="1473200" y="431800"/>
                </a:cubicBezTo>
                <a:cubicBezTo>
                  <a:pt x="1479550" y="430742"/>
                  <a:pt x="1485877" y="429535"/>
                  <a:pt x="1492250" y="428625"/>
                </a:cubicBezTo>
                <a:cubicBezTo>
                  <a:pt x="1500697" y="427418"/>
                  <a:pt x="1509255" y="426976"/>
                  <a:pt x="1517650" y="425450"/>
                </a:cubicBezTo>
                <a:cubicBezTo>
                  <a:pt x="1530191" y="423170"/>
                  <a:pt x="1525079" y="421735"/>
                  <a:pt x="1536700" y="415925"/>
                </a:cubicBezTo>
                <a:cubicBezTo>
                  <a:pt x="1546397" y="411077"/>
                  <a:pt x="1550544" y="412750"/>
                  <a:pt x="1562100" y="412750"/>
                </a:cubicBezTo>
              </a:path>
            </a:pathLst>
          </a:custGeom>
          <a:ln w="6350" cmpd="sng">
            <a:solidFill>
              <a:srgbClr val="FFFFFF"/>
            </a:solidFill>
            <a:prstDash val="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Freeform 63"/>
          <p:cNvSpPr/>
          <p:nvPr/>
        </p:nvSpPr>
        <p:spPr>
          <a:xfrm>
            <a:off x="3071098" y="6102350"/>
            <a:ext cx="1587500" cy="812800"/>
          </a:xfrm>
          <a:custGeom>
            <a:avLst/>
            <a:gdLst>
              <a:gd name="connsiteX0" fmla="*/ 0 w 1587500"/>
              <a:gd name="connsiteY0" fmla="*/ 812800 h 812800"/>
              <a:gd name="connsiteX1" fmla="*/ 9525 w 1587500"/>
              <a:gd name="connsiteY1" fmla="*/ 796925 h 812800"/>
              <a:gd name="connsiteX2" fmla="*/ 19050 w 1587500"/>
              <a:gd name="connsiteY2" fmla="*/ 790575 h 812800"/>
              <a:gd name="connsiteX3" fmla="*/ 34925 w 1587500"/>
              <a:gd name="connsiteY3" fmla="*/ 762000 h 812800"/>
              <a:gd name="connsiteX4" fmla="*/ 44450 w 1587500"/>
              <a:gd name="connsiteY4" fmla="*/ 755650 h 812800"/>
              <a:gd name="connsiteX5" fmla="*/ 63500 w 1587500"/>
              <a:gd name="connsiteY5" fmla="*/ 749300 h 812800"/>
              <a:gd name="connsiteX6" fmla="*/ 73025 w 1587500"/>
              <a:gd name="connsiteY6" fmla="*/ 746125 h 812800"/>
              <a:gd name="connsiteX7" fmla="*/ 82550 w 1587500"/>
              <a:gd name="connsiteY7" fmla="*/ 742950 h 812800"/>
              <a:gd name="connsiteX8" fmla="*/ 95250 w 1587500"/>
              <a:gd name="connsiteY8" fmla="*/ 739775 h 812800"/>
              <a:gd name="connsiteX9" fmla="*/ 123825 w 1587500"/>
              <a:gd name="connsiteY9" fmla="*/ 723900 h 812800"/>
              <a:gd name="connsiteX10" fmla="*/ 133350 w 1587500"/>
              <a:gd name="connsiteY10" fmla="*/ 717550 h 812800"/>
              <a:gd name="connsiteX11" fmla="*/ 142875 w 1587500"/>
              <a:gd name="connsiteY11" fmla="*/ 711200 h 812800"/>
              <a:gd name="connsiteX12" fmla="*/ 149225 w 1587500"/>
              <a:gd name="connsiteY12" fmla="*/ 701675 h 812800"/>
              <a:gd name="connsiteX13" fmla="*/ 155575 w 1587500"/>
              <a:gd name="connsiteY13" fmla="*/ 676275 h 812800"/>
              <a:gd name="connsiteX14" fmla="*/ 152400 w 1587500"/>
              <a:gd name="connsiteY14" fmla="*/ 647700 h 812800"/>
              <a:gd name="connsiteX15" fmla="*/ 146050 w 1587500"/>
              <a:gd name="connsiteY15" fmla="*/ 615950 h 812800"/>
              <a:gd name="connsiteX16" fmla="*/ 149225 w 1587500"/>
              <a:gd name="connsiteY16" fmla="*/ 584200 h 812800"/>
              <a:gd name="connsiteX17" fmla="*/ 155575 w 1587500"/>
              <a:gd name="connsiteY17" fmla="*/ 574675 h 812800"/>
              <a:gd name="connsiteX18" fmla="*/ 168275 w 1587500"/>
              <a:gd name="connsiteY18" fmla="*/ 546100 h 812800"/>
              <a:gd name="connsiteX19" fmla="*/ 177800 w 1587500"/>
              <a:gd name="connsiteY19" fmla="*/ 539750 h 812800"/>
              <a:gd name="connsiteX20" fmla="*/ 180975 w 1587500"/>
              <a:gd name="connsiteY20" fmla="*/ 530225 h 812800"/>
              <a:gd name="connsiteX21" fmla="*/ 200025 w 1587500"/>
              <a:gd name="connsiteY21" fmla="*/ 517525 h 812800"/>
              <a:gd name="connsiteX22" fmla="*/ 219075 w 1587500"/>
              <a:gd name="connsiteY22" fmla="*/ 479425 h 812800"/>
              <a:gd name="connsiteX23" fmla="*/ 225425 w 1587500"/>
              <a:gd name="connsiteY23" fmla="*/ 469900 h 812800"/>
              <a:gd name="connsiteX24" fmla="*/ 231775 w 1587500"/>
              <a:gd name="connsiteY24" fmla="*/ 460375 h 812800"/>
              <a:gd name="connsiteX25" fmla="*/ 250825 w 1587500"/>
              <a:gd name="connsiteY25" fmla="*/ 450850 h 812800"/>
              <a:gd name="connsiteX26" fmla="*/ 260350 w 1587500"/>
              <a:gd name="connsiteY26" fmla="*/ 419100 h 812800"/>
              <a:gd name="connsiteX27" fmla="*/ 263525 w 1587500"/>
              <a:gd name="connsiteY27" fmla="*/ 403225 h 812800"/>
              <a:gd name="connsiteX28" fmla="*/ 266700 w 1587500"/>
              <a:gd name="connsiteY28" fmla="*/ 393700 h 812800"/>
              <a:gd name="connsiteX29" fmla="*/ 285750 w 1587500"/>
              <a:gd name="connsiteY29" fmla="*/ 381000 h 812800"/>
              <a:gd name="connsiteX30" fmla="*/ 307975 w 1587500"/>
              <a:gd name="connsiteY30" fmla="*/ 355600 h 812800"/>
              <a:gd name="connsiteX31" fmla="*/ 333375 w 1587500"/>
              <a:gd name="connsiteY31" fmla="*/ 339725 h 812800"/>
              <a:gd name="connsiteX32" fmla="*/ 342900 w 1587500"/>
              <a:gd name="connsiteY32" fmla="*/ 336550 h 812800"/>
              <a:gd name="connsiteX33" fmla="*/ 352425 w 1587500"/>
              <a:gd name="connsiteY33" fmla="*/ 333375 h 812800"/>
              <a:gd name="connsiteX34" fmla="*/ 358775 w 1587500"/>
              <a:gd name="connsiteY34" fmla="*/ 342900 h 812800"/>
              <a:gd name="connsiteX35" fmla="*/ 374650 w 1587500"/>
              <a:gd name="connsiteY35" fmla="*/ 346075 h 812800"/>
              <a:gd name="connsiteX36" fmla="*/ 422275 w 1587500"/>
              <a:gd name="connsiteY36" fmla="*/ 342900 h 812800"/>
              <a:gd name="connsiteX37" fmla="*/ 431800 w 1587500"/>
              <a:gd name="connsiteY37" fmla="*/ 336550 h 812800"/>
              <a:gd name="connsiteX38" fmla="*/ 438150 w 1587500"/>
              <a:gd name="connsiteY38" fmla="*/ 327025 h 812800"/>
              <a:gd name="connsiteX39" fmla="*/ 447675 w 1587500"/>
              <a:gd name="connsiteY39" fmla="*/ 323850 h 812800"/>
              <a:gd name="connsiteX40" fmla="*/ 469900 w 1587500"/>
              <a:gd name="connsiteY40" fmla="*/ 298450 h 812800"/>
              <a:gd name="connsiteX41" fmla="*/ 476250 w 1587500"/>
              <a:gd name="connsiteY41" fmla="*/ 288925 h 812800"/>
              <a:gd name="connsiteX42" fmla="*/ 495300 w 1587500"/>
              <a:gd name="connsiteY42" fmla="*/ 276225 h 812800"/>
              <a:gd name="connsiteX43" fmla="*/ 501650 w 1587500"/>
              <a:gd name="connsiteY43" fmla="*/ 266700 h 812800"/>
              <a:gd name="connsiteX44" fmla="*/ 511175 w 1587500"/>
              <a:gd name="connsiteY44" fmla="*/ 263525 h 812800"/>
              <a:gd name="connsiteX45" fmla="*/ 530225 w 1587500"/>
              <a:gd name="connsiteY45" fmla="*/ 234950 h 812800"/>
              <a:gd name="connsiteX46" fmla="*/ 546100 w 1587500"/>
              <a:gd name="connsiteY46" fmla="*/ 219075 h 812800"/>
              <a:gd name="connsiteX47" fmla="*/ 561975 w 1587500"/>
              <a:gd name="connsiteY47" fmla="*/ 215900 h 812800"/>
              <a:gd name="connsiteX48" fmla="*/ 571500 w 1587500"/>
              <a:gd name="connsiteY48" fmla="*/ 209550 h 812800"/>
              <a:gd name="connsiteX49" fmla="*/ 574675 w 1587500"/>
              <a:gd name="connsiteY49" fmla="*/ 200025 h 812800"/>
              <a:gd name="connsiteX50" fmla="*/ 596900 w 1587500"/>
              <a:gd name="connsiteY50" fmla="*/ 174625 h 812800"/>
              <a:gd name="connsiteX51" fmla="*/ 603250 w 1587500"/>
              <a:gd name="connsiteY51" fmla="*/ 165100 h 812800"/>
              <a:gd name="connsiteX52" fmla="*/ 638175 w 1587500"/>
              <a:gd name="connsiteY52" fmla="*/ 171450 h 812800"/>
              <a:gd name="connsiteX53" fmla="*/ 647700 w 1587500"/>
              <a:gd name="connsiteY53" fmla="*/ 177800 h 812800"/>
              <a:gd name="connsiteX54" fmla="*/ 654050 w 1587500"/>
              <a:gd name="connsiteY54" fmla="*/ 187325 h 812800"/>
              <a:gd name="connsiteX55" fmla="*/ 660400 w 1587500"/>
              <a:gd name="connsiteY55" fmla="*/ 206375 h 812800"/>
              <a:gd name="connsiteX56" fmla="*/ 669925 w 1587500"/>
              <a:gd name="connsiteY56" fmla="*/ 225425 h 812800"/>
              <a:gd name="connsiteX57" fmla="*/ 676275 w 1587500"/>
              <a:gd name="connsiteY57" fmla="*/ 234950 h 812800"/>
              <a:gd name="connsiteX58" fmla="*/ 682625 w 1587500"/>
              <a:gd name="connsiteY58" fmla="*/ 254000 h 812800"/>
              <a:gd name="connsiteX59" fmla="*/ 698500 w 1587500"/>
              <a:gd name="connsiteY59" fmla="*/ 269875 h 812800"/>
              <a:gd name="connsiteX60" fmla="*/ 717550 w 1587500"/>
              <a:gd name="connsiteY60" fmla="*/ 276225 h 812800"/>
              <a:gd name="connsiteX61" fmla="*/ 727075 w 1587500"/>
              <a:gd name="connsiteY61" fmla="*/ 285750 h 812800"/>
              <a:gd name="connsiteX62" fmla="*/ 746125 w 1587500"/>
              <a:gd name="connsiteY62" fmla="*/ 292100 h 812800"/>
              <a:gd name="connsiteX63" fmla="*/ 755650 w 1587500"/>
              <a:gd name="connsiteY63" fmla="*/ 298450 h 812800"/>
              <a:gd name="connsiteX64" fmla="*/ 758825 w 1587500"/>
              <a:gd name="connsiteY64" fmla="*/ 307975 h 812800"/>
              <a:gd name="connsiteX65" fmla="*/ 777875 w 1587500"/>
              <a:gd name="connsiteY65" fmla="*/ 314325 h 812800"/>
              <a:gd name="connsiteX66" fmla="*/ 796925 w 1587500"/>
              <a:gd name="connsiteY66" fmla="*/ 327025 h 812800"/>
              <a:gd name="connsiteX67" fmla="*/ 806450 w 1587500"/>
              <a:gd name="connsiteY67" fmla="*/ 323850 h 812800"/>
              <a:gd name="connsiteX68" fmla="*/ 844550 w 1587500"/>
              <a:gd name="connsiteY68" fmla="*/ 327025 h 812800"/>
              <a:gd name="connsiteX69" fmla="*/ 847725 w 1587500"/>
              <a:gd name="connsiteY69" fmla="*/ 336550 h 812800"/>
              <a:gd name="connsiteX70" fmla="*/ 854075 w 1587500"/>
              <a:gd name="connsiteY70" fmla="*/ 346075 h 812800"/>
              <a:gd name="connsiteX71" fmla="*/ 873125 w 1587500"/>
              <a:gd name="connsiteY71" fmla="*/ 352425 h 812800"/>
              <a:gd name="connsiteX72" fmla="*/ 882650 w 1587500"/>
              <a:gd name="connsiteY72" fmla="*/ 349250 h 812800"/>
              <a:gd name="connsiteX73" fmla="*/ 885825 w 1587500"/>
              <a:gd name="connsiteY73" fmla="*/ 339725 h 812800"/>
              <a:gd name="connsiteX74" fmla="*/ 882650 w 1587500"/>
              <a:gd name="connsiteY74" fmla="*/ 311150 h 812800"/>
              <a:gd name="connsiteX75" fmla="*/ 876300 w 1587500"/>
              <a:gd name="connsiteY75" fmla="*/ 260350 h 812800"/>
              <a:gd name="connsiteX76" fmla="*/ 869950 w 1587500"/>
              <a:gd name="connsiteY76" fmla="*/ 250825 h 812800"/>
              <a:gd name="connsiteX77" fmla="*/ 857250 w 1587500"/>
              <a:gd name="connsiteY77" fmla="*/ 247650 h 812800"/>
              <a:gd name="connsiteX78" fmla="*/ 847725 w 1587500"/>
              <a:gd name="connsiteY78" fmla="*/ 244475 h 812800"/>
              <a:gd name="connsiteX79" fmla="*/ 841375 w 1587500"/>
              <a:gd name="connsiteY79" fmla="*/ 234950 h 812800"/>
              <a:gd name="connsiteX80" fmla="*/ 831850 w 1587500"/>
              <a:gd name="connsiteY80" fmla="*/ 231775 h 812800"/>
              <a:gd name="connsiteX81" fmla="*/ 825500 w 1587500"/>
              <a:gd name="connsiteY81" fmla="*/ 212725 h 812800"/>
              <a:gd name="connsiteX82" fmla="*/ 803275 w 1587500"/>
              <a:gd name="connsiteY82" fmla="*/ 187325 h 812800"/>
              <a:gd name="connsiteX83" fmla="*/ 793750 w 1587500"/>
              <a:gd name="connsiteY83" fmla="*/ 184150 h 812800"/>
              <a:gd name="connsiteX84" fmla="*/ 781050 w 1587500"/>
              <a:gd name="connsiteY84" fmla="*/ 155575 h 812800"/>
              <a:gd name="connsiteX85" fmla="*/ 777875 w 1587500"/>
              <a:gd name="connsiteY85" fmla="*/ 146050 h 812800"/>
              <a:gd name="connsiteX86" fmla="*/ 784225 w 1587500"/>
              <a:gd name="connsiteY86" fmla="*/ 101600 h 812800"/>
              <a:gd name="connsiteX87" fmla="*/ 793750 w 1587500"/>
              <a:gd name="connsiteY87" fmla="*/ 79375 h 812800"/>
              <a:gd name="connsiteX88" fmla="*/ 803275 w 1587500"/>
              <a:gd name="connsiteY88" fmla="*/ 76200 h 812800"/>
              <a:gd name="connsiteX89" fmla="*/ 809625 w 1587500"/>
              <a:gd name="connsiteY89" fmla="*/ 50800 h 812800"/>
              <a:gd name="connsiteX90" fmla="*/ 812800 w 1587500"/>
              <a:gd name="connsiteY90" fmla="*/ 41275 h 812800"/>
              <a:gd name="connsiteX91" fmla="*/ 822325 w 1587500"/>
              <a:gd name="connsiteY91" fmla="*/ 38100 h 812800"/>
              <a:gd name="connsiteX92" fmla="*/ 841375 w 1587500"/>
              <a:gd name="connsiteY92" fmla="*/ 25400 h 812800"/>
              <a:gd name="connsiteX93" fmla="*/ 860425 w 1587500"/>
              <a:gd name="connsiteY93" fmla="*/ 19050 h 812800"/>
              <a:gd name="connsiteX94" fmla="*/ 889000 w 1587500"/>
              <a:gd name="connsiteY94" fmla="*/ 22225 h 812800"/>
              <a:gd name="connsiteX95" fmla="*/ 895350 w 1587500"/>
              <a:gd name="connsiteY95" fmla="*/ 12700 h 812800"/>
              <a:gd name="connsiteX96" fmla="*/ 898525 w 1587500"/>
              <a:gd name="connsiteY96" fmla="*/ 3175 h 812800"/>
              <a:gd name="connsiteX97" fmla="*/ 908050 w 1587500"/>
              <a:gd name="connsiteY97" fmla="*/ 0 h 812800"/>
              <a:gd name="connsiteX98" fmla="*/ 927100 w 1587500"/>
              <a:gd name="connsiteY98" fmla="*/ 3175 h 812800"/>
              <a:gd name="connsiteX99" fmla="*/ 936625 w 1587500"/>
              <a:gd name="connsiteY99" fmla="*/ 9525 h 812800"/>
              <a:gd name="connsiteX100" fmla="*/ 946150 w 1587500"/>
              <a:gd name="connsiteY100" fmla="*/ 12700 h 812800"/>
              <a:gd name="connsiteX101" fmla="*/ 965200 w 1587500"/>
              <a:gd name="connsiteY101" fmla="*/ 6350 h 812800"/>
              <a:gd name="connsiteX102" fmla="*/ 1000125 w 1587500"/>
              <a:gd name="connsiteY102" fmla="*/ 15875 h 812800"/>
              <a:gd name="connsiteX103" fmla="*/ 1009650 w 1587500"/>
              <a:gd name="connsiteY103" fmla="*/ 22225 h 812800"/>
              <a:gd name="connsiteX104" fmla="*/ 1019175 w 1587500"/>
              <a:gd name="connsiteY104" fmla="*/ 41275 h 812800"/>
              <a:gd name="connsiteX105" fmla="*/ 1060450 w 1587500"/>
              <a:gd name="connsiteY105" fmla="*/ 50800 h 812800"/>
              <a:gd name="connsiteX106" fmla="*/ 1073150 w 1587500"/>
              <a:gd name="connsiteY106" fmla="*/ 53975 h 812800"/>
              <a:gd name="connsiteX107" fmla="*/ 1082675 w 1587500"/>
              <a:gd name="connsiteY107" fmla="*/ 63500 h 812800"/>
              <a:gd name="connsiteX108" fmla="*/ 1092200 w 1587500"/>
              <a:gd name="connsiteY108" fmla="*/ 69850 h 812800"/>
              <a:gd name="connsiteX109" fmla="*/ 1108075 w 1587500"/>
              <a:gd name="connsiteY109" fmla="*/ 85725 h 812800"/>
              <a:gd name="connsiteX110" fmla="*/ 1123950 w 1587500"/>
              <a:gd name="connsiteY110" fmla="*/ 101600 h 812800"/>
              <a:gd name="connsiteX111" fmla="*/ 1130300 w 1587500"/>
              <a:gd name="connsiteY111" fmla="*/ 111125 h 812800"/>
              <a:gd name="connsiteX112" fmla="*/ 1149350 w 1587500"/>
              <a:gd name="connsiteY112" fmla="*/ 123825 h 812800"/>
              <a:gd name="connsiteX113" fmla="*/ 1158875 w 1587500"/>
              <a:gd name="connsiteY113" fmla="*/ 130175 h 812800"/>
              <a:gd name="connsiteX114" fmla="*/ 1184275 w 1587500"/>
              <a:gd name="connsiteY114" fmla="*/ 136525 h 812800"/>
              <a:gd name="connsiteX115" fmla="*/ 1212850 w 1587500"/>
              <a:gd name="connsiteY115" fmla="*/ 139700 h 812800"/>
              <a:gd name="connsiteX116" fmla="*/ 1241425 w 1587500"/>
              <a:gd name="connsiteY116" fmla="*/ 146050 h 812800"/>
              <a:gd name="connsiteX117" fmla="*/ 1270000 w 1587500"/>
              <a:gd name="connsiteY117" fmla="*/ 152400 h 812800"/>
              <a:gd name="connsiteX118" fmla="*/ 1276350 w 1587500"/>
              <a:gd name="connsiteY118" fmla="*/ 161925 h 812800"/>
              <a:gd name="connsiteX119" fmla="*/ 1282700 w 1587500"/>
              <a:gd name="connsiteY119" fmla="*/ 180975 h 812800"/>
              <a:gd name="connsiteX120" fmla="*/ 1285875 w 1587500"/>
              <a:gd name="connsiteY120" fmla="*/ 190500 h 812800"/>
              <a:gd name="connsiteX121" fmla="*/ 1289050 w 1587500"/>
              <a:gd name="connsiteY121" fmla="*/ 200025 h 812800"/>
              <a:gd name="connsiteX122" fmla="*/ 1292225 w 1587500"/>
              <a:gd name="connsiteY122" fmla="*/ 212725 h 812800"/>
              <a:gd name="connsiteX123" fmla="*/ 1301750 w 1587500"/>
              <a:gd name="connsiteY123" fmla="*/ 231775 h 812800"/>
              <a:gd name="connsiteX124" fmla="*/ 1304925 w 1587500"/>
              <a:gd name="connsiteY124" fmla="*/ 241300 h 812800"/>
              <a:gd name="connsiteX125" fmla="*/ 1323975 w 1587500"/>
              <a:gd name="connsiteY125" fmla="*/ 247650 h 812800"/>
              <a:gd name="connsiteX126" fmla="*/ 1352550 w 1587500"/>
              <a:gd name="connsiteY126" fmla="*/ 257175 h 812800"/>
              <a:gd name="connsiteX127" fmla="*/ 1362075 w 1587500"/>
              <a:gd name="connsiteY127" fmla="*/ 260350 h 812800"/>
              <a:gd name="connsiteX128" fmla="*/ 1371600 w 1587500"/>
              <a:gd name="connsiteY128" fmla="*/ 263525 h 812800"/>
              <a:gd name="connsiteX129" fmla="*/ 1400175 w 1587500"/>
              <a:gd name="connsiteY129" fmla="*/ 282575 h 812800"/>
              <a:gd name="connsiteX130" fmla="*/ 1409700 w 1587500"/>
              <a:gd name="connsiteY130" fmla="*/ 288925 h 812800"/>
              <a:gd name="connsiteX131" fmla="*/ 1435100 w 1587500"/>
              <a:gd name="connsiteY131" fmla="*/ 304800 h 812800"/>
              <a:gd name="connsiteX132" fmla="*/ 1444625 w 1587500"/>
              <a:gd name="connsiteY132" fmla="*/ 307975 h 812800"/>
              <a:gd name="connsiteX133" fmla="*/ 1482725 w 1587500"/>
              <a:gd name="connsiteY133" fmla="*/ 301625 h 812800"/>
              <a:gd name="connsiteX134" fmla="*/ 1501775 w 1587500"/>
              <a:gd name="connsiteY134" fmla="*/ 292100 h 812800"/>
              <a:gd name="connsiteX135" fmla="*/ 1527175 w 1587500"/>
              <a:gd name="connsiteY135" fmla="*/ 276225 h 812800"/>
              <a:gd name="connsiteX136" fmla="*/ 1536700 w 1587500"/>
              <a:gd name="connsiteY136" fmla="*/ 273050 h 812800"/>
              <a:gd name="connsiteX137" fmla="*/ 1543050 w 1587500"/>
              <a:gd name="connsiteY137" fmla="*/ 263525 h 812800"/>
              <a:gd name="connsiteX138" fmla="*/ 1524000 w 1587500"/>
              <a:gd name="connsiteY138" fmla="*/ 247650 h 812800"/>
              <a:gd name="connsiteX139" fmla="*/ 1504950 w 1587500"/>
              <a:gd name="connsiteY139" fmla="*/ 234950 h 812800"/>
              <a:gd name="connsiteX140" fmla="*/ 1479550 w 1587500"/>
              <a:gd name="connsiteY140" fmla="*/ 196850 h 812800"/>
              <a:gd name="connsiteX141" fmla="*/ 1473200 w 1587500"/>
              <a:gd name="connsiteY141" fmla="*/ 187325 h 812800"/>
              <a:gd name="connsiteX142" fmla="*/ 1466850 w 1587500"/>
              <a:gd name="connsiteY142" fmla="*/ 168275 h 812800"/>
              <a:gd name="connsiteX143" fmla="*/ 1482725 w 1587500"/>
              <a:gd name="connsiteY143" fmla="*/ 142875 h 812800"/>
              <a:gd name="connsiteX144" fmla="*/ 1501775 w 1587500"/>
              <a:gd name="connsiteY144" fmla="*/ 136525 h 812800"/>
              <a:gd name="connsiteX145" fmla="*/ 1511300 w 1587500"/>
              <a:gd name="connsiteY145" fmla="*/ 139700 h 812800"/>
              <a:gd name="connsiteX146" fmla="*/ 1530350 w 1587500"/>
              <a:gd name="connsiteY146" fmla="*/ 133350 h 812800"/>
              <a:gd name="connsiteX147" fmla="*/ 1539875 w 1587500"/>
              <a:gd name="connsiteY147" fmla="*/ 130175 h 812800"/>
              <a:gd name="connsiteX148" fmla="*/ 1587500 w 1587500"/>
              <a:gd name="connsiteY148" fmla="*/ 127000 h 812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</a:cxnLst>
            <a:rect l="l" t="t" r="r" b="b"/>
            <a:pathLst>
              <a:path w="1587500" h="812800">
                <a:moveTo>
                  <a:pt x="0" y="812800"/>
                </a:moveTo>
                <a:cubicBezTo>
                  <a:pt x="3175" y="807508"/>
                  <a:pt x="5509" y="801610"/>
                  <a:pt x="9525" y="796925"/>
                </a:cubicBezTo>
                <a:cubicBezTo>
                  <a:pt x="12008" y="794028"/>
                  <a:pt x="16666" y="793555"/>
                  <a:pt x="19050" y="790575"/>
                </a:cubicBezTo>
                <a:cubicBezTo>
                  <a:pt x="32284" y="774032"/>
                  <a:pt x="2933" y="783328"/>
                  <a:pt x="34925" y="762000"/>
                </a:cubicBezTo>
                <a:cubicBezTo>
                  <a:pt x="38100" y="759883"/>
                  <a:pt x="40963" y="757200"/>
                  <a:pt x="44450" y="755650"/>
                </a:cubicBezTo>
                <a:cubicBezTo>
                  <a:pt x="50567" y="752932"/>
                  <a:pt x="57150" y="751417"/>
                  <a:pt x="63500" y="749300"/>
                </a:cubicBezTo>
                <a:lnTo>
                  <a:pt x="73025" y="746125"/>
                </a:lnTo>
                <a:cubicBezTo>
                  <a:pt x="76200" y="745067"/>
                  <a:pt x="79303" y="743762"/>
                  <a:pt x="82550" y="742950"/>
                </a:cubicBezTo>
                <a:cubicBezTo>
                  <a:pt x="86783" y="741892"/>
                  <a:pt x="91054" y="740974"/>
                  <a:pt x="95250" y="739775"/>
                </a:cubicBezTo>
                <a:cubicBezTo>
                  <a:pt x="109919" y="735584"/>
                  <a:pt x="106769" y="735271"/>
                  <a:pt x="123825" y="723900"/>
                </a:cubicBezTo>
                <a:lnTo>
                  <a:pt x="133350" y="717550"/>
                </a:lnTo>
                <a:lnTo>
                  <a:pt x="142875" y="711200"/>
                </a:lnTo>
                <a:cubicBezTo>
                  <a:pt x="144992" y="708025"/>
                  <a:pt x="147518" y="705088"/>
                  <a:pt x="149225" y="701675"/>
                </a:cubicBezTo>
                <a:cubicBezTo>
                  <a:pt x="152479" y="695166"/>
                  <a:pt x="154367" y="682313"/>
                  <a:pt x="155575" y="676275"/>
                </a:cubicBezTo>
                <a:cubicBezTo>
                  <a:pt x="154517" y="666750"/>
                  <a:pt x="153895" y="657166"/>
                  <a:pt x="152400" y="647700"/>
                </a:cubicBezTo>
                <a:cubicBezTo>
                  <a:pt x="150717" y="637039"/>
                  <a:pt x="146050" y="615950"/>
                  <a:pt x="146050" y="615950"/>
                </a:cubicBezTo>
                <a:cubicBezTo>
                  <a:pt x="147108" y="605367"/>
                  <a:pt x="146833" y="594564"/>
                  <a:pt x="149225" y="584200"/>
                </a:cubicBezTo>
                <a:cubicBezTo>
                  <a:pt x="150083" y="580482"/>
                  <a:pt x="154025" y="578162"/>
                  <a:pt x="155575" y="574675"/>
                </a:cubicBezTo>
                <a:cubicBezTo>
                  <a:pt x="160605" y="563357"/>
                  <a:pt x="159652" y="554723"/>
                  <a:pt x="168275" y="546100"/>
                </a:cubicBezTo>
                <a:cubicBezTo>
                  <a:pt x="170973" y="543402"/>
                  <a:pt x="174625" y="541867"/>
                  <a:pt x="177800" y="539750"/>
                </a:cubicBezTo>
                <a:cubicBezTo>
                  <a:pt x="178858" y="536575"/>
                  <a:pt x="178608" y="532592"/>
                  <a:pt x="180975" y="530225"/>
                </a:cubicBezTo>
                <a:cubicBezTo>
                  <a:pt x="186371" y="524829"/>
                  <a:pt x="200025" y="517525"/>
                  <a:pt x="200025" y="517525"/>
                </a:cubicBezTo>
                <a:cubicBezTo>
                  <a:pt x="208788" y="491235"/>
                  <a:pt x="202662" y="504044"/>
                  <a:pt x="219075" y="479425"/>
                </a:cubicBezTo>
                <a:lnTo>
                  <a:pt x="225425" y="469900"/>
                </a:lnTo>
                <a:cubicBezTo>
                  <a:pt x="227542" y="466725"/>
                  <a:pt x="228155" y="461582"/>
                  <a:pt x="231775" y="460375"/>
                </a:cubicBezTo>
                <a:cubicBezTo>
                  <a:pt x="244920" y="455993"/>
                  <a:pt x="238515" y="459056"/>
                  <a:pt x="250825" y="450850"/>
                </a:cubicBezTo>
                <a:cubicBezTo>
                  <a:pt x="261747" y="434467"/>
                  <a:pt x="255810" y="446341"/>
                  <a:pt x="260350" y="419100"/>
                </a:cubicBezTo>
                <a:cubicBezTo>
                  <a:pt x="261237" y="413777"/>
                  <a:pt x="262216" y="408460"/>
                  <a:pt x="263525" y="403225"/>
                </a:cubicBezTo>
                <a:cubicBezTo>
                  <a:pt x="264337" y="399978"/>
                  <a:pt x="264333" y="396067"/>
                  <a:pt x="266700" y="393700"/>
                </a:cubicBezTo>
                <a:cubicBezTo>
                  <a:pt x="272096" y="388304"/>
                  <a:pt x="285750" y="381000"/>
                  <a:pt x="285750" y="381000"/>
                </a:cubicBezTo>
                <a:cubicBezTo>
                  <a:pt x="300567" y="358775"/>
                  <a:pt x="292100" y="366183"/>
                  <a:pt x="307975" y="355600"/>
                </a:cubicBezTo>
                <a:cubicBezTo>
                  <a:pt x="318038" y="340506"/>
                  <a:pt x="310705" y="347282"/>
                  <a:pt x="333375" y="339725"/>
                </a:cubicBezTo>
                <a:lnTo>
                  <a:pt x="342900" y="336550"/>
                </a:lnTo>
                <a:lnTo>
                  <a:pt x="352425" y="333375"/>
                </a:lnTo>
                <a:cubicBezTo>
                  <a:pt x="354542" y="336550"/>
                  <a:pt x="355462" y="341007"/>
                  <a:pt x="358775" y="342900"/>
                </a:cubicBezTo>
                <a:cubicBezTo>
                  <a:pt x="363460" y="345577"/>
                  <a:pt x="369254" y="346075"/>
                  <a:pt x="374650" y="346075"/>
                </a:cubicBezTo>
                <a:cubicBezTo>
                  <a:pt x="390560" y="346075"/>
                  <a:pt x="406400" y="343958"/>
                  <a:pt x="422275" y="342900"/>
                </a:cubicBezTo>
                <a:cubicBezTo>
                  <a:pt x="425450" y="340783"/>
                  <a:pt x="429102" y="339248"/>
                  <a:pt x="431800" y="336550"/>
                </a:cubicBezTo>
                <a:cubicBezTo>
                  <a:pt x="434498" y="333852"/>
                  <a:pt x="435170" y="329409"/>
                  <a:pt x="438150" y="327025"/>
                </a:cubicBezTo>
                <a:cubicBezTo>
                  <a:pt x="440763" y="324934"/>
                  <a:pt x="444500" y="324908"/>
                  <a:pt x="447675" y="323850"/>
                </a:cubicBezTo>
                <a:cubicBezTo>
                  <a:pt x="462492" y="301625"/>
                  <a:pt x="454025" y="309033"/>
                  <a:pt x="469900" y="298450"/>
                </a:cubicBezTo>
                <a:cubicBezTo>
                  <a:pt x="472017" y="295275"/>
                  <a:pt x="473378" y="291438"/>
                  <a:pt x="476250" y="288925"/>
                </a:cubicBezTo>
                <a:cubicBezTo>
                  <a:pt x="481993" y="283899"/>
                  <a:pt x="495300" y="276225"/>
                  <a:pt x="495300" y="276225"/>
                </a:cubicBezTo>
                <a:cubicBezTo>
                  <a:pt x="497417" y="273050"/>
                  <a:pt x="498670" y="269084"/>
                  <a:pt x="501650" y="266700"/>
                </a:cubicBezTo>
                <a:cubicBezTo>
                  <a:pt x="504263" y="264609"/>
                  <a:pt x="508808" y="265892"/>
                  <a:pt x="511175" y="263525"/>
                </a:cubicBezTo>
                <a:lnTo>
                  <a:pt x="530225" y="234950"/>
                </a:lnTo>
                <a:cubicBezTo>
                  <a:pt x="535399" y="227189"/>
                  <a:pt x="536693" y="222603"/>
                  <a:pt x="546100" y="219075"/>
                </a:cubicBezTo>
                <a:cubicBezTo>
                  <a:pt x="551153" y="217180"/>
                  <a:pt x="556683" y="216958"/>
                  <a:pt x="561975" y="215900"/>
                </a:cubicBezTo>
                <a:cubicBezTo>
                  <a:pt x="565150" y="213783"/>
                  <a:pt x="569116" y="212530"/>
                  <a:pt x="571500" y="209550"/>
                </a:cubicBezTo>
                <a:cubicBezTo>
                  <a:pt x="573591" y="206937"/>
                  <a:pt x="573050" y="202951"/>
                  <a:pt x="574675" y="200025"/>
                </a:cubicBezTo>
                <a:cubicBezTo>
                  <a:pt x="585570" y="180415"/>
                  <a:pt x="582986" y="183901"/>
                  <a:pt x="596900" y="174625"/>
                </a:cubicBezTo>
                <a:cubicBezTo>
                  <a:pt x="599017" y="171450"/>
                  <a:pt x="599508" y="165848"/>
                  <a:pt x="603250" y="165100"/>
                </a:cubicBezTo>
                <a:cubicBezTo>
                  <a:pt x="607941" y="164162"/>
                  <a:pt x="629981" y="167353"/>
                  <a:pt x="638175" y="171450"/>
                </a:cubicBezTo>
                <a:cubicBezTo>
                  <a:pt x="641588" y="173157"/>
                  <a:pt x="644525" y="175683"/>
                  <a:pt x="647700" y="177800"/>
                </a:cubicBezTo>
                <a:cubicBezTo>
                  <a:pt x="649817" y="180975"/>
                  <a:pt x="652500" y="183838"/>
                  <a:pt x="654050" y="187325"/>
                </a:cubicBezTo>
                <a:cubicBezTo>
                  <a:pt x="656768" y="193442"/>
                  <a:pt x="656687" y="200806"/>
                  <a:pt x="660400" y="206375"/>
                </a:cubicBezTo>
                <a:cubicBezTo>
                  <a:pt x="678598" y="233672"/>
                  <a:pt x="656780" y="199135"/>
                  <a:pt x="669925" y="225425"/>
                </a:cubicBezTo>
                <a:cubicBezTo>
                  <a:pt x="671632" y="228838"/>
                  <a:pt x="674725" y="231463"/>
                  <a:pt x="676275" y="234950"/>
                </a:cubicBezTo>
                <a:cubicBezTo>
                  <a:pt x="678993" y="241067"/>
                  <a:pt x="678912" y="248431"/>
                  <a:pt x="682625" y="254000"/>
                </a:cubicBezTo>
                <a:cubicBezTo>
                  <a:pt x="688418" y="262689"/>
                  <a:pt x="688474" y="265419"/>
                  <a:pt x="698500" y="269875"/>
                </a:cubicBezTo>
                <a:cubicBezTo>
                  <a:pt x="704617" y="272593"/>
                  <a:pt x="717550" y="276225"/>
                  <a:pt x="717550" y="276225"/>
                </a:cubicBezTo>
                <a:cubicBezTo>
                  <a:pt x="720725" y="279400"/>
                  <a:pt x="723150" y="283569"/>
                  <a:pt x="727075" y="285750"/>
                </a:cubicBezTo>
                <a:cubicBezTo>
                  <a:pt x="732926" y="289001"/>
                  <a:pt x="740556" y="288387"/>
                  <a:pt x="746125" y="292100"/>
                </a:cubicBezTo>
                <a:lnTo>
                  <a:pt x="755650" y="298450"/>
                </a:lnTo>
                <a:cubicBezTo>
                  <a:pt x="756708" y="301625"/>
                  <a:pt x="756102" y="306030"/>
                  <a:pt x="758825" y="307975"/>
                </a:cubicBezTo>
                <a:cubicBezTo>
                  <a:pt x="764272" y="311866"/>
                  <a:pt x="777875" y="314325"/>
                  <a:pt x="777875" y="314325"/>
                </a:cubicBezTo>
                <a:cubicBezTo>
                  <a:pt x="783602" y="320052"/>
                  <a:pt x="787735" y="327025"/>
                  <a:pt x="796925" y="327025"/>
                </a:cubicBezTo>
                <a:cubicBezTo>
                  <a:pt x="800272" y="327025"/>
                  <a:pt x="803275" y="324908"/>
                  <a:pt x="806450" y="323850"/>
                </a:cubicBezTo>
                <a:cubicBezTo>
                  <a:pt x="819150" y="324908"/>
                  <a:pt x="832370" y="323277"/>
                  <a:pt x="844550" y="327025"/>
                </a:cubicBezTo>
                <a:cubicBezTo>
                  <a:pt x="847749" y="328009"/>
                  <a:pt x="846228" y="333557"/>
                  <a:pt x="847725" y="336550"/>
                </a:cubicBezTo>
                <a:cubicBezTo>
                  <a:pt x="849432" y="339963"/>
                  <a:pt x="850839" y="344053"/>
                  <a:pt x="854075" y="346075"/>
                </a:cubicBezTo>
                <a:cubicBezTo>
                  <a:pt x="859751" y="349623"/>
                  <a:pt x="873125" y="352425"/>
                  <a:pt x="873125" y="352425"/>
                </a:cubicBezTo>
                <a:cubicBezTo>
                  <a:pt x="876300" y="351367"/>
                  <a:pt x="880283" y="351617"/>
                  <a:pt x="882650" y="349250"/>
                </a:cubicBezTo>
                <a:cubicBezTo>
                  <a:pt x="885017" y="346883"/>
                  <a:pt x="885825" y="343072"/>
                  <a:pt x="885825" y="339725"/>
                </a:cubicBezTo>
                <a:cubicBezTo>
                  <a:pt x="885825" y="330141"/>
                  <a:pt x="883518" y="320694"/>
                  <a:pt x="882650" y="311150"/>
                </a:cubicBezTo>
                <a:cubicBezTo>
                  <a:pt x="881909" y="303003"/>
                  <a:pt x="883186" y="274122"/>
                  <a:pt x="876300" y="260350"/>
                </a:cubicBezTo>
                <a:cubicBezTo>
                  <a:pt x="874593" y="256937"/>
                  <a:pt x="873125" y="252942"/>
                  <a:pt x="869950" y="250825"/>
                </a:cubicBezTo>
                <a:cubicBezTo>
                  <a:pt x="866319" y="248404"/>
                  <a:pt x="861446" y="248849"/>
                  <a:pt x="857250" y="247650"/>
                </a:cubicBezTo>
                <a:cubicBezTo>
                  <a:pt x="854032" y="246731"/>
                  <a:pt x="850900" y="245533"/>
                  <a:pt x="847725" y="244475"/>
                </a:cubicBezTo>
                <a:cubicBezTo>
                  <a:pt x="845608" y="241300"/>
                  <a:pt x="844355" y="237334"/>
                  <a:pt x="841375" y="234950"/>
                </a:cubicBezTo>
                <a:cubicBezTo>
                  <a:pt x="838762" y="232859"/>
                  <a:pt x="833795" y="234498"/>
                  <a:pt x="831850" y="231775"/>
                </a:cubicBezTo>
                <a:cubicBezTo>
                  <a:pt x="827959" y="226328"/>
                  <a:pt x="829213" y="218294"/>
                  <a:pt x="825500" y="212725"/>
                </a:cubicBezTo>
                <a:cubicBezTo>
                  <a:pt x="815975" y="198438"/>
                  <a:pt x="816504" y="193940"/>
                  <a:pt x="803275" y="187325"/>
                </a:cubicBezTo>
                <a:cubicBezTo>
                  <a:pt x="800282" y="185828"/>
                  <a:pt x="796925" y="185208"/>
                  <a:pt x="793750" y="184150"/>
                </a:cubicBezTo>
                <a:cubicBezTo>
                  <a:pt x="783687" y="169056"/>
                  <a:pt x="788607" y="178245"/>
                  <a:pt x="781050" y="155575"/>
                </a:cubicBezTo>
                <a:lnTo>
                  <a:pt x="777875" y="146050"/>
                </a:lnTo>
                <a:cubicBezTo>
                  <a:pt x="786468" y="103083"/>
                  <a:pt x="774169" y="166963"/>
                  <a:pt x="784225" y="101600"/>
                </a:cubicBezTo>
                <a:cubicBezTo>
                  <a:pt x="785295" y="94643"/>
                  <a:pt x="787629" y="84272"/>
                  <a:pt x="793750" y="79375"/>
                </a:cubicBezTo>
                <a:cubicBezTo>
                  <a:pt x="796363" y="77284"/>
                  <a:pt x="800100" y="77258"/>
                  <a:pt x="803275" y="76200"/>
                </a:cubicBezTo>
                <a:cubicBezTo>
                  <a:pt x="810533" y="54427"/>
                  <a:pt x="801962" y="81451"/>
                  <a:pt x="809625" y="50800"/>
                </a:cubicBezTo>
                <a:cubicBezTo>
                  <a:pt x="810437" y="47553"/>
                  <a:pt x="810433" y="43642"/>
                  <a:pt x="812800" y="41275"/>
                </a:cubicBezTo>
                <a:cubicBezTo>
                  <a:pt x="815167" y="38908"/>
                  <a:pt x="819399" y="39725"/>
                  <a:pt x="822325" y="38100"/>
                </a:cubicBezTo>
                <a:cubicBezTo>
                  <a:pt x="828996" y="34394"/>
                  <a:pt x="834135" y="27813"/>
                  <a:pt x="841375" y="25400"/>
                </a:cubicBezTo>
                <a:lnTo>
                  <a:pt x="860425" y="19050"/>
                </a:lnTo>
                <a:cubicBezTo>
                  <a:pt x="882650" y="26458"/>
                  <a:pt x="873125" y="27517"/>
                  <a:pt x="889000" y="22225"/>
                </a:cubicBezTo>
                <a:cubicBezTo>
                  <a:pt x="891117" y="19050"/>
                  <a:pt x="893643" y="16113"/>
                  <a:pt x="895350" y="12700"/>
                </a:cubicBezTo>
                <a:cubicBezTo>
                  <a:pt x="896847" y="9707"/>
                  <a:pt x="896158" y="5542"/>
                  <a:pt x="898525" y="3175"/>
                </a:cubicBezTo>
                <a:cubicBezTo>
                  <a:pt x="900892" y="808"/>
                  <a:pt x="904875" y="1058"/>
                  <a:pt x="908050" y="0"/>
                </a:cubicBezTo>
                <a:cubicBezTo>
                  <a:pt x="914400" y="1058"/>
                  <a:pt x="920993" y="1139"/>
                  <a:pt x="927100" y="3175"/>
                </a:cubicBezTo>
                <a:cubicBezTo>
                  <a:pt x="930720" y="4382"/>
                  <a:pt x="933212" y="7818"/>
                  <a:pt x="936625" y="9525"/>
                </a:cubicBezTo>
                <a:cubicBezTo>
                  <a:pt x="939618" y="11022"/>
                  <a:pt x="942975" y="11642"/>
                  <a:pt x="946150" y="12700"/>
                </a:cubicBezTo>
                <a:cubicBezTo>
                  <a:pt x="952500" y="10583"/>
                  <a:pt x="958636" y="5037"/>
                  <a:pt x="965200" y="6350"/>
                </a:cubicBezTo>
                <a:cubicBezTo>
                  <a:pt x="973720" y="8054"/>
                  <a:pt x="993219" y="11271"/>
                  <a:pt x="1000125" y="15875"/>
                </a:cubicBezTo>
                <a:lnTo>
                  <a:pt x="1009650" y="22225"/>
                </a:lnTo>
                <a:cubicBezTo>
                  <a:pt x="1011380" y="27415"/>
                  <a:pt x="1013992" y="38036"/>
                  <a:pt x="1019175" y="41275"/>
                </a:cubicBezTo>
                <a:cubicBezTo>
                  <a:pt x="1030384" y="48280"/>
                  <a:pt x="1048303" y="48591"/>
                  <a:pt x="1060450" y="50800"/>
                </a:cubicBezTo>
                <a:cubicBezTo>
                  <a:pt x="1064743" y="51581"/>
                  <a:pt x="1068917" y="52917"/>
                  <a:pt x="1073150" y="53975"/>
                </a:cubicBezTo>
                <a:cubicBezTo>
                  <a:pt x="1076325" y="57150"/>
                  <a:pt x="1079226" y="60625"/>
                  <a:pt x="1082675" y="63500"/>
                </a:cubicBezTo>
                <a:cubicBezTo>
                  <a:pt x="1085606" y="65943"/>
                  <a:pt x="1089502" y="67152"/>
                  <a:pt x="1092200" y="69850"/>
                </a:cubicBezTo>
                <a:cubicBezTo>
                  <a:pt x="1113367" y="91017"/>
                  <a:pt x="1082675" y="68792"/>
                  <a:pt x="1108075" y="85725"/>
                </a:cubicBezTo>
                <a:cubicBezTo>
                  <a:pt x="1125008" y="111125"/>
                  <a:pt x="1102783" y="80433"/>
                  <a:pt x="1123950" y="101600"/>
                </a:cubicBezTo>
                <a:cubicBezTo>
                  <a:pt x="1126648" y="104298"/>
                  <a:pt x="1127428" y="108612"/>
                  <a:pt x="1130300" y="111125"/>
                </a:cubicBezTo>
                <a:cubicBezTo>
                  <a:pt x="1136043" y="116151"/>
                  <a:pt x="1143000" y="119592"/>
                  <a:pt x="1149350" y="123825"/>
                </a:cubicBezTo>
                <a:cubicBezTo>
                  <a:pt x="1152525" y="125942"/>
                  <a:pt x="1155255" y="128968"/>
                  <a:pt x="1158875" y="130175"/>
                </a:cubicBezTo>
                <a:cubicBezTo>
                  <a:pt x="1169955" y="133868"/>
                  <a:pt x="1170865" y="134609"/>
                  <a:pt x="1184275" y="136525"/>
                </a:cubicBezTo>
                <a:cubicBezTo>
                  <a:pt x="1193762" y="137880"/>
                  <a:pt x="1203325" y="138642"/>
                  <a:pt x="1212850" y="139700"/>
                </a:cubicBezTo>
                <a:cubicBezTo>
                  <a:pt x="1226440" y="143097"/>
                  <a:pt x="1226645" y="143363"/>
                  <a:pt x="1241425" y="146050"/>
                </a:cubicBezTo>
                <a:cubicBezTo>
                  <a:pt x="1266011" y="150520"/>
                  <a:pt x="1253206" y="146802"/>
                  <a:pt x="1270000" y="152400"/>
                </a:cubicBezTo>
                <a:cubicBezTo>
                  <a:pt x="1272117" y="155575"/>
                  <a:pt x="1274800" y="158438"/>
                  <a:pt x="1276350" y="161925"/>
                </a:cubicBezTo>
                <a:cubicBezTo>
                  <a:pt x="1279068" y="168042"/>
                  <a:pt x="1280583" y="174625"/>
                  <a:pt x="1282700" y="180975"/>
                </a:cubicBezTo>
                <a:lnTo>
                  <a:pt x="1285875" y="190500"/>
                </a:lnTo>
                <a:cubicBezTo>
                  <a:pt x="1286933" y="193675"/>
                  <a:pt x="1288238" y="196778"/>
                  <a:pt x="1289050" y="200025"/>
                </a:cubicBezTo>
                <a:cubicBezTo>
                  <a:pt x="1290108" y="204258"/>
                  <a:pt x="1291026" y="208529"/>
                  <a:pt x="1292225" y="212725"/>
                </a:cubicBezTo>
                <a:cubicBezTo>
                  <a:pt x="1297545" y="231346"/>
                  <a:pt x="1292473" y="213222"/>
                  <a:pt x="1301750" y="231775"/>
                </a:cubicBezTo>
                <a:cubicBezTo>
                  <a:pt x="1303247" y="234768"/>
                  <a:pt x="1302202" y="239355"/>
                  <a:pt x="1304925" y="241300"/>
                </a:cubicBezTo>
                <a:cubicBezTo>
                  <a:pt x="1310372" y="245191"/>
                  <a:pt x="1317625" y="245533"/>
                  <a:pt x="1323975" y="247650"/>
                </a:cubicBezTo>
                <a:lnTo>
                  <a:pt x="1352550" y="257175"/>
                </a:lnTo>
                <a:lnTo>
                  <a:pt x="1362075" y="260350"/>
                </a:lnTo>
                <a:cubicBezTo>
                  <a:pt x="1365250" y="261408"/>
                  <a:pt x="1368815" y="261669"/>
                  <a:pt x="1371600" y="263525"/>
                </a:cubicBezTo>
                <a:lnTo>
                  <a:pt x="1400175" y="282575"/>
                </a:lnTo>
                <a:lnTo>
                  <a:pt x="1409700" y="288925"/>
                </a:lnTo>
                <a:cubicBezTo>
                  <a:pt x="1419763" y="304019"/>
                  <a:pt x="1412430" y="297243"/>
                  <a:pt x="1435100" y="304800"/>
                </a:cubicBezTo>
                <a:lnTo>
                  <a:pt x="1444625" y="307975"/>
                </a:lnTo>
                <a:cubicBezTo>
                  <a:pt x="1466955" y="300532"/>
                  <a:pt x="1440190" y="308714"/>
                  <a:pt x="1482725" y="301625"/>
                </a:cubicBezTo>
                <a:cubicBezTo>
                  <a:pt x="1491488" y="300164"/>
                  <a:pt x="1494461" y="296976"/>
                  <a:pt x="1501775" y="292100"/>
                </a:cubicBezTo>
                <a:cubicBezTo>
                  <a:pt x="1511838" y="277006"/>
                  <a:pt x="1504505" y="283782"/>
                  <a:pt x="1527175" y="276225"/>
                </a:cubicBezTo>
                <a:lnTo>
                  <a:pt x="1536700" y="273050"/>
                </a:lnTo>
                <a:cubicBezTo>
                  <a:pt x="1538817" y="269875"/>
                  <a:pt x="1543050" y="267341"/>
                  <a:pt x="1543050" y="263525"/>
                </a:cubicBezTo>
                <a:cubicBezTo>
                  <a:pt x="1543050" y="254148"/>
                  <a:pt x="1528980" y="250638"/>
                  <a:pt x="1524000" y="247650"/>
                </a:cubicBezTo>
                <a:cubicBezTo>
                  <a:pt x="1517456" y="243723"/>
                  <a:pt x="1504950" y="234950"/>
                  <a:pt x="1504950" y="234950"/>
                </a:cubicBezTo>
                <a:cubicBezTo>
                  <a:pt x="1489851" y="189654"/>
                  <a:pt x="1511261" y="244416"/>
                  <a:pt x="1479550" y="196850"/>
                </a:cubicBezTo>
                <a:cubicBezTo>
                  <a:pt x="1477433" y="193675"/>
                  <a:pt x="1474750" y="190812"/>
                  <a:pt x="1473200" y="187325"/>
                </a:cubicBezTo>
                <a:cubicBezTo>
                  <a:pt x="1470482" y="181208"/>
                  <a:pt x="1466850" y="168275"/>
                  <a:pt x="1466850" y="168275"/>
                </a:cubicBezTo>
                <a:cubicBezTo>
                  <a:pt x="1472104" y="152512"/>
                  <a:pt x="1468943" y="149000"/>
                  <a:pt x="1482725" y="142875"/>
                </a:cubicBezTo>
                <a:cubicBezTo>
                  <a:pt x="1488842" y="140157"/>
                  <a:pt x="1501775" y="136525"/>
                  <a:pt x="1501775" y="136525"/>
                </a:cubicBezTo>
                <a:cubicBezTo>
                  <a:pt x="1504950" y="137583"/>
                  <a:pt x="1507974" y="140070"/>
                  <a:pt x="1511300" y="139700"/>
                </a:cubicBezTo>
                <a:cubicBezTo>
                  <a:pt x="1517953" y="138961"/>
                  <a:pt x="1524000" y="135467"/>
                  <a:pt x="1530350" y="133350"/>
                </a:cubicBezTo>
                <a:cubicBezTo>
                  <a:pt x="1533525" y="132292"/>
                  <a:pt x="1536554" y="130590"/>
                  <a:pt x="1539875" y="130175"/>
                </a:cubicBezTo>
                <a:cubicBezTo>
                  <a:pt x="1572626" y="126081"/>
                  <a:pt x="1556742" y="127000"/>
                  <a:pt x="1587500" y="127000"/>
                </a:cubicBezTo>
              </a:path>
            </a:pathLst>
          </a:custGeom>
          <a:ln w="6350" cmpd="sng">
            <a:solidFill>
              <a:srgbClr val="FFFFFF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Freeform 65"/>
          <p:cNvSpPr/>
          <p:nvPr/>
        </p:nvSpPr>
        <p:spPr>
          <a:xfrm>
            <a:off x="3096480" y="7327900"/>
            <a:ext cx="1562100" cy="752475"/>
          </a:xfrm>
          <a:custGeom>
            <a:avLst/>
            <a:gdLst>
              <a:gd name="connsiteX0" fmla="*/ 34925 w 1562100"/>
              <a:gd name="connsiteY0" fmla="*/ 752475 h 752475"/>
              <a:gd name="connsiteX1" fmla="*/ 31750 w 1562100"/>
              <a:gd name="connsiteY1" fmla="*/ 711200 h 752475"/>
              <a:gd name="connsiteX2" fmla="*/ 28575 w 1562100"/>
              <a:gd name="connsiteY2" fmla="*/ 688975 h 752475"/>
              <a:gd name="connsiteX3" fmla="*/ 22225 w 1562100"/>
              <a:gd name="connsiteY3" fmla="*/ 638175 h 752475"/>
              <a:gd name="connsiteX4" fmla="*/ 15875 w 1562100"/>
              <a:gd name="connsiteY4" fmla="*/ 574675 h 752475"/>
              <a:gd name="connsiteX5" fmla="*/ 9525 w 1562100"/>
              <a:gd name="connsiteY5" fmla="*/ 555625 h 752475"/>
              <a:gd name="connsiteX6" fmla="*/ 0 w 1562100"/>
              <a:gd name="connsiteY6" fmla="*/ 536575 h 752475"/>
              <a:gd name="connsiteX7" fmla="*/ 3175 w 1562100"/>
              <a:gd name="connsiteY7" fmla="*/ 476250 h 752475"/>
              <a:gd name="connsiteX8" fmla="*/ 12700 w 1562100"/>
              <a:gd name="connsiteY8" fmla="*/ 438150 h 752475"/>
              <a:gd name="connsiteX9" fmla="*/ 19050 w 1562100"/>
              <a:gd name="connsiteY9" fmla="*/ 428625 h 752475"/>
              <a:gd name="connsiteX10" fmla="*/ 38100 w 1562100"/>
              <a:gd name="connsiteY10" fmla="*/ 415925 h 752475"/>
              <a:gd name="connsiteX11" fmla="*/ 47625 w 1562100"/>
              <a:gd name="connsiteY11" fmla="*/ 409575 h 752475"/>
              <a:gd name="connsiteX12" fmla="*/ 76200 w 1562100"/>
              <a:gd name="connsiteY12" fmla="*/ 400050 h 752475"/>
              <a:gd name="connsiteX13" fmla="*/ 85725 w 1562100"/>
              <a:gd name="connsiteY13" fmla="*/ 396875 h 752475"/>
              <a:gd name="connsiteX14" fmla="*/ 98425 w 1562100"/>
              <a:gd name="connsiteY14" fmla="*/ 393700 h 752475"/>
              <a:gd name="connsiteX15" fmla="*/ 234950 w 1562100"/>
              <a:gd name="connsiteY15" fmla="*/ 396875 h 752475"/>
              <a:gd name="connsiteX16" fmla="*/ 244475 w 1562100"/>
              <a:gd name="connsiteY16" fmla="*/ 403225 h 752475"/>
              <a:gd name="connsiteX17" fmla="*/ 260350 w 1562100"/>
              <a:gd name="connsiteY17" fmla="*/ 431800 h 752475"/>
              <a:gd name="connsiteX18" fmla="*/ 266700 w 1562100"/>
              <a:gd name="connsiteY18" fmla="*/ 441325 h 752475"/>
              <a:gd name="connsiteX19" fmla="*/ 269875 w 1562100"/>
              <a:gd name="connsiteY19" fmla="*/ 450850 h 752475"/>
              <a:gd name="connsiteX20" fmla="*/ 282575 w 1562100"/>
              <a:gd name="connsiteY20" fmla="*/ 469900 h 752475"/>
              <a:gd name="connsiteX21" fmla="*/ 285750 w 1562100"/>
              <a:gd name="connsiteY21" fmla="*/ 479425 h 752475"/>
              <a:gd name="connsiteX22" fmla="*/ 292100 w 1562100"/>
              <a:gd name="connsiteY22" fmla="*/ 488950 h 752475"/>
              <a:gd name="connsiteX23" fmla="*/ 298450 w 1562100"/>
              <a:gd name="connsiteY23" fmla="*/ 508000 h 752475"/>
              <a:gd name="connsiteX24" fmla="*/ 301625 w 1562100"/>
              <a:gd name="connsiteY24" fmla="*/ 517525 h 752475"/>
              <a:gd name="connsiteX25" fmla="*/ 304800 w 1562100"/>
              <a:gd name="connsiteY25" fmla="*/ 527050 h 752475"/>
              <a:gd name="connsiteX26" fmla="*/ 307975 w 1562100"/>
              <a:gd name="connsiteY26" fmla="*/ 536575 h 752475"/>
              <a:gd name="connsiteX27" fmla="*/ 311150 w 1562100"/>
              <a:gd name="connsiteY27" fmla="*/ 587375 h 752475"/>
              <a:gd name="connsiteX28" fmla="*/ 314325 w 1562100"/>
              <a:gd name="connsiteY28" fmla="*/ 596900 h 752475"/>
              <a:gd name="connsiteX29" fmla="*/ 323850 w 1562100"/>
              <a:gd name="connsiteY29" fmla="*/ 603250 h 752475"/>
              <a:gd name="connsiteX30" fmla="*/ 381000 w 1562100"/>
              <a:gd name="connsiteY30" fmla="*/ 600075 h 752475"/>
              <a:gd name="connsiteX31" fmla="*/ 409575 w 1562100"/>
              <a:gd name="connsiteY31" fmla="*/ 593725 h 752475"/>
              <a:gd name="connsiteX32" fmla="*/ 419100 w 1562100"/>
              <a:gd name="connsiteY32" fmla="*/ 587375 h 752475"/>
              <a:gd name="connsiteX33" fmla="*/ 428625 w 1562100"/>
              <a:gd name="connsiteY33" fmla="*/ 555625 h 752475"/>
              <a:gd name="connsiteX34" fmla="*/ 428625 w 1562100"/>
              <a:gd name="connsiteY34" fmla="*/ 377825 h 752475"/>
              <a:gd name="connsiteX35" fmla="*/ 425450 w 1562100"/>
              <a:gd name="connsiteY35" fmla="*/ 358775 h 752475"/>
              <a:gd name="connsiteX36" fmla="*/ 415925 w 1562100"/>
              <a:gd name="connsiteY36" fmla="*/ 327025 h 752475"/>
              <a:gd name="connsiteX37" fmla="*/ 412750 w 1562100"/>
              <a:gd name="connsiteY37" fmla="*/ 317500 h 752475"/>
              <a:gd name="connsiteX38" fmla="*/ 409575 w 1562100"/>
              <a:gd name="connsiteY38" fmla="*/ 307975 h 752475"/>
              <a:gd name="connsiteX39" fmla="*/ 409575 w 1562100"/>
              <a:gd name="connsiteY39" fmla="*/ 238125 h 752475"/>
              <a:gd name="connsiteX40" fmla="*/ 419100 w 1562100"/>
              <a:gd name="connsiteY40" fmla="*/ 234950 h 752475"/>
              <a:gd name="connsiteX41" fmla="*/ 438150 w 1562100"/>
              <a:gd name="connsiteY41" fmla="*/ 241300 h 752475"/>
              <a:gd name="connsiteX42" fmla="*/ 466725 w 1562100"/>
              <a:gd name="connsiteY42" fmla="*/ 257175 h 752475"/>
              <a:gd name="connsiteX43" fmla="*/ 479425 w 1562100"/>
              <a:gd name="connsiteY43" fmla="*/ 276225 h 752475"/>
              <a:gd name="connsiteX44" fmla="*/ 485775 w 1562100"/>
              <a:gd name="connsiteY44" fmla="*/ 295275 h 752475"/>
              <a:gd name="connsiteX45" fmla="*/ 488950 w 1562100"/>
              <a:gd name="connsiteY45" fmla="*/ 304800 h 752475"/>
              <a:gd name="connsiteX46" fmla="*/ 492125 w 1562100"/>
              <a:gd name="connsiteY46" fmla="*/ 317500 h 752475"/>
              <a:gd name="connsiteX47" fmla="*/ 498475 w 1562100"/>
              <a:gd name="connsiteY47" fmla="*/ 336550 h 752475"/>
              <a:gd name="connsiteX48" fmla="*/ 501650 w 1562100"/>
              <a:gd name="connsiteY48" fmla="*/ 346075 h 752475"/>
              <a:gd name="connsiteX49" fmla="*/ 511175 w 1562100"/>
              <a:gd name="connsiteY49" fmla="*/ 355600 h 752475"/>
              <a:gd name="connsiteX50" fmla="*/ 517525 w 1562100"/>
              <a:gd name="connsiteY50" fmla="*/ 365125 h 752475"/>
              <a:gd name="connsiteX51" fmla="*/ 536575 w 1562100"/>
              <a:gd name="connsiteY51" fmla="*/ 377825 h 752475"/>
              <a:gd name="connsiteX52" fmla="*/ 555625 w 1562100"/>
              <a:gd name="connsiteY52" fmla="*/ 384175 h 752475"/>
              <a:gd name="connsiteX53" fmla="*/ 565150 w 1562100"/>
              <a:gd name="connsiteY53" fmla="*/ 387350 h 752475"/>
              <a:gd name="connsiteX54" fmla="*/ 574675 w 1562100"/>
              <a:gd name="connsiteY54" fmla="*/ 393700 h 752475"/>
              <a:gd name="connsiteX55" fmla="*/ 584200 w 1562100"/>
              <a:gd name="connsiteY55" fmla="*/ 396875 h 752475"/>
              <a:gd name="connsiteX56" fmla="*/ 603250 w 1562100"/>
              <a:gd name="connsiteY56" fmla="*/ 409575 h 752475"/>
              <a:gd name="connsiteX57" fmla="*/ 628650 w 1562100"/>
              <a:gd name="connsiteY57" fmla="*/ 415925 h 752475"/>
              <a:gd name="connsiteX58" fmla="*/ 638175 w 1562100"/>
              <a:gd name="connsiteY58" fmla="*/ 419100 h 752475"/>
              <a:gd name="connsiteX59" fmla="*/ 666750 w 1562100"/>
              <a:gd name="connsiteY59" fmla="*/ 425450 h 752475"/>
              <a:gd name="connsiteX60" fmla="*/ 695325 w 1562100"/>
              <a:gd name="connsiteY60" fmla="*/ 422275 h 752475"/>
              <a:gd name="connsiteX61" fmla="*/ 708025 w 1562100"/>
              <a:gd name="connsiteY61" fmla="*/ 419100 h 752475"/>
              <a:gd name="connsiteX62" fmla="*/ 714375 w 1562100"/>
              <a:gd name="connsiteY62" fmla="*/ 409575 h 752475"/>
              <a:gd name="connsiteX63" fmla="*/ 720725 w 1562100"/>
              <a:gd name="connsiteY63" fmla="*/ 390525 h 752475"/>
              <a:gd name="connsiteX64" fmla="*/ 720725 w 1562100"/>
              <a:gd name="connsiteY64" fmla="*/ 371475 h 752475"/>
              <a:gd name="connsiteX65" fmla="*/ 727075 w 1562100"/>
              <a:gd name="connsiteY65" fmla="*/ 327025 h 752475"/>
              <a:gd name="connsiteX66" fmla="*/ 733425 w 1562100"/>
              <a:gd name="connsiteY66" fmla="*/ 307975 h 752475"/>
              <a:gd name="connsiteX67" fmla="*/ 730250 w 1562100"/>
              <a:gd name="connsiteY67" fmla="*/ 241300 h 752475"/>
              <a:gd name="connsiteX68" fmla="*/ 720725 w 1562100"/>
              <a:gd name="connsiteY68" fmla="*/ 222250 h 752475"/>
              <a:gd name="connsiteX69" fmla="*/ 717550 w 1562100"/>
              <a:gd name="connsiteY69" fmla="*/ 212725 h 752475"/>
              <a:gd name="connsiteX70" fmla="*/ 711200 w 1562100"/>
              <a:gd name="connsiteY70" fmla="*/ 184150 h 752475"/>
              <a:gd name="connsiteX71" fmla="*/ 708025 w 1562100"/>
              <a:gd name="connsiteY71" fmla="*/ 174625 h 752475"/>
              <a:gd name="connsiteX72" fmla="*/ 701675 w 1562100"/>
              <a:gd name="connsiteY72" fmla="*/ 165100 h 752475"/>
              <a:gd name="connsiteX73" fmla="*/ 692150 w 1562100"/>
              <a:gd name="connsiteY73" fmla="*/ 146050 h 752475"/>
              <a:gd name="connsiteX74" fmla="*/ 682625 w 1562100"/>
              <a:gd name="connsiteY74" fmla="*/ 142875 h 752475"/>
              <a:gd name="connsiteX75" fmla="*/ 676275 w 1562100"/>
              <a:gd name="connsiteY75" fmla="*/ 133350 h 752475"/>
              <a:gd name="connsiteX76" fmla="*/ 666750 w 1562100"/>
              <a:gd name="connsiteY76" fmla="*/ 127000 h 752475"/>
              <a:gd name="connsiteX77" fmla="*/ 654050 w 1562100"/>
              <a:gd name="connsiteY77" fmla="*/ 107950 h 752475"/>
              <a:gd name="connsiteX78" fmla="*/ 657225 w 1562100"/>
              <a:gd name="connsiteY78" fmla="*/ 60325 h 752475"/>
              <a:gd name="connsiteX79" fmla="*/ 669925 w 1562100"/>
              <a:gd name="connsiteY79" fmla="*/ 31750 h 752475"/>
              <a:gd name="connsiteX80" fmla="*/ 688975 w 1562100"/>
              <a:gd name="connsiteY80" fmla="*/ 25400 h 752475"/>
              <a:gd name="connsiteX81" fmla="*/ 720725 w 1562100"/>
              <a:gd name="connsiteY81" fmla="*/ 19050 h 752475"/>
              <a:gd name="connsiteX82" fmla="*/ 752475 w 1562100"/>
              <a:gd name="connsiteY82" fmla="*/ 15875 h 752475"/>
              <a:gd name="connsiteX83" fmla="*/ 784225 w 1562100"/>
              <a:gd name="connsiteY83" fmla="*/ 9525 h 752475"/>
              <a:gd name="connsiteX84" fmla="*/ 803275 w 1562100"/>
              <a:gd name="connsiteY84" fmla="*/ 3175 h 752475"/>
              <a:gd name="connsiteX85" fmla="*/ 815975 w 1562100"/>
              <a:gd name="connsiteY85" fmla="*/ 0 h 752475"/>
              <a:gd name="connsiteX86" fmla="*/ 869950 w 1562100"/>
              <a:gd name="connsiteY86" fmla="*/ 6350 h 752475"/>
              <a:gd name="connsiteX87" fmla="*/ 889000 w 1562100"/>
              <a:gd name="connsiteY87" fmla="*/ 12700 h 752475"/>
              <a:gd name="connsiteX88" fmla="*/ 908050 w 1562100"/>
              <a:gd name="connsiteY88" fmla="*/ 25400 h 752475"/>
              <a:gd name="connsiteX89" fmla="*/ 917575 w 1562100"/>
              <a:gd name="connsiteY89" fmla="*/ 31750 h 752475"/>
              <a:gd name="connsiteX90" fmla="*/ 936625 w 1562100"/>
              <a:gd name="connsiteY90" fmla="*/ 38100 h 752475"/>
              <a:gd name="connsiteX91" fmla="*/ 946150 w 1562100"/>
              <a:gd name="connsiteY91" fmla="*/ 41275 h 752475"/>
              <a:gd name="connsiteX92" fmla="*/ 955675 w 1562100"/>
              <a:gd name="connsiteY92" fmla="*/ 47625 h 752475"/>
              <a:gd name="connsiteX93" fmla="*/ 977900 w 1562100"/>
              <a:gd name="connsiteY93" fmla="*/ 73025 h 752475"/>
              <a:gd name="connsiteX94" fmla="*/ 984250 w 1562100"/>
              <a:gd name="connsiteY94" fmla="*/ 82550 h 752475"/>
              <a:gd name="connsiteX95" fmla="*/ 1012825 w 1562100"/>
              <a:gd name="connsiteY95" fmla="*/ 101600 h 752475"/>
              <a:gd name="connsiteX96" fmla="*/ 1022350 w 1562100"/>
              <a:gd name="connsiteY96" fmla="*/ 107950 h 752475"/>
              <a:gd name="connsiteX97" fmla="*/ 1031875 w 1562100"/>
              <a:gd name="connsiteY97" fmla="*/ 114300 h 752475"/>
              <a:gd name="connsiteX98" fmla="*/ 1047750 w 1562100"/>
              <a:gd name="connsiteY98" fmla="*/ 127000 h 752475"/>
              <a:gd name="connsiteX99" fmla="*/ 1066800 w 1562100"/>
              <a:gd name="connsiteY99" fmla="*/ 142875 h 752475"/>
              <a:gd name="connsiteX100" fmla="*/ 1085850 w 1562100"/>
              <a:gd name="connsiteY100" fmla="*/ 149225 h 752475"/>
              <a:gd name="connsiteX101" fmla="*/ 1152525 w 1562100"/>
              <a:gd name="connsiteY101" fmla="*/ 146050 h 752475"/>
              <a:gd name="connsiteX102" fmla="*/ 1171575 w 1562100"/>
              <a:gd name="connsiteY102" fmla="*/ 139700 h 752475"/>
              <a:gd name="connsiteX103" fmla="*/ 1190625 w 1562100"/>
              <a:gd name="connsiteY103" fmla="*/ 136525 h 752475"/>
              <a:gd name="connsiteX104" fmla="*/ 1238250 w 1562100"/>
              <a:gd name="connsiteY104" fmla="*/ 139700 h 752475"/>
              <a:gd name="connsiteX105" fmla="*/ 1279525 w 1562100"/>
              <a:gd name="connsiteY105" fmla="*/ 146050 h 752475"/>
              <a:gd name="connsiteX106" fmla="*/ 1295400 w 1562100"/>
              <a:gd name="connsiteY106" fmla="*/ 193675 h 752475"/>
              <a:gd name="connsiteX107" fmla="*/ 1298575 w 1562100"/>
              <a:gd name="connsiteY107" fmla="*/ 203200 h 752475"/>
              <a:gd name="connsiteX108" fmla="*/ 1301750 w 1562100"/>
              <a:gd name="connsiteY108" fmla="*/ 212725 h 752475"/>
              <a:gd name="connsiteX109" fmla="*/ 1308100 w 1562100"/>
              <a:gd name="connsiteY109" fmla="*/ 222250 h 752475"/>
              <a:gd name="connsiteX110" fmla="*/ 1311275 w 1562100"/>
              <a:gd name="connsiteY110" fmla="*/ 231775 h 752475"/>
              <a:gd name="connsiteX111" fmla="*/ 1317625 w 1562100"/>
              <a:gd name="connsiteY111" fmla="*/ 241300 h 752475"/>
              <a:gd name="connsiteX112" fmla="*/ 1336675 w 1562100"/>
              <a:gd name="connsiteY112" fmla="*/ 260350 h 752475"/>
              <a:gd name="connsiteX113" fmla="*/ 1349375 w 1562100"/>
              <a:gd name="connsiteY113" fmla="*/ 276225 h 752475"/>
              <a:gd name="connsiteX114" fmla="*/ 1365250 w 1562100"/>
              <a:gd name="connsiteY114" fmla="*/ 292100 h 752475"/>
              <a:gd name="connsiteX115" fmla="*/ 1374775 w 1562100"/>
              <a:gd name="connsiteY115" fmla="*/ 314325 h 752475"/>
              <a:gd name="connsiteX116" fmla="*/ 1381125 w 1562100"/>
              <a:gd name="connsiteY116" fmla="*/ 333375 h 752475"/>
              <a:gd name="connsiteX117" fmla="*/ 1387475 w 1562100"/>
              <a:gd name="connsiteY117" fmla="*/ 352425 h 752475"/>
              <a:gd name="connsiteX118" fmla="*/ 1390650 w 1562100"/>
              <a:gd name="connsiteY118" fmla="*/ 361950 h 752475"/>
              <a:gd name="connsiteX119" fmla="*/ 1393825 w 1562100"/>
              <a:gd name="connsiteY119" fmla="*/ 374650 h 752475"/>
              <a:gd name="connsiteX120" fmla="*/ 1409700 w 1562100"/>
              <a:gd name="connsiteY120" fmla="*/ 403225 h 752475"/>
              <a:gd name="connsiteX121" fmla="*/ 1438275 w 1562100"/>
              <a:gd name="connsiteY121" fmla="*/ 412750 h 752475"/>
              <a:gd name="connsiteX122" fmla="*/ 1447800 w 1562100"/>
              <a:gd name="connsiteY122" fmla="*/ 415925 h 752475"/>
              <a:gd name="connsiteX123" fmla="*/ 1454150 w 1562100"/>
              <a:gd name="connsiteY123" fmla="*/ 425450 h 752475"/>
              <a:gd name="connsiteX124" fmla="*/ 1473200 w 1562100"/>
              <a:gd name="connsiteY124" fmla="*/ 431800 h 752475"/>
              <a:gd name="connsiteX125" fmla="*/ 1492250 w 1562100"/>
              <a:gd name="connsiteY125" fmla="*/ 428625 h 752475"/>
              <a:gd name="connsiteX126" fmla="*/ 1517650 w 1562100"/>
              <a:gd name="connsiteY126" fmla="*/ 425450 h 752475"/>
              <a:gd name="connsiteX127" fmla="*/ 1536700 w 1562100"/>
              <a:gd name="connsiteY127" fmla="*/ 415925 h 752475"/>
              <a:gd name="connsiteX128" fmla="*/ 1562100 w 1562100"/>
              <a:gd name="connsiteY128" fmla="*/ 412750 h 7524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</a:cxnLst>
            <a:rect l="l" t="t" r="r" b="b"/>
            <a:pathLst>
              <a:path w="1562100" h="752475">
                <a:moveTo>
                  <a:pt x="34925" y="752475"/>
                </a:moveTo>
                <a:cubicBezTo>
                  <a:pt x="33867" y="738717"/>
                  <a:pt x="33123" y="724930"/>
                  <a:pt x="31750" y="711200"/>
                </a:cubicBezTo>
                <a:cubicBezTo>
                  <a:pt x="31005" y="703754"/>
                  <a:pt x="29401" y="696413"/>
                  <a:pt x="28575" y="688975"/>
                </a:cubicBezTo>
                <a:cubicBezTo>
                  <a:pt x="23080" y="639517"/>
                  <a:pt x="28538" y="669741"/>
                  <a:pt x="22225" y="638175"/>
                </a:cubicBezTo>
                <a:cubicBezTo>
                  <a:pt x="21184" y="623595"/>
                  <a:pt x="20369" y="592650"/>
                  <a:pt x="15875" y="574675"/>
                </a:cubicBezTo>
                <a:cubicBezTo>
                  <a:pt x="14252" y="568181"/>
                  <a:pt x="13238" y="561194"/>
                  <a:pt x="9525" y="555625"/>
                </a:cubicBezTo>
                <a:cubicBezTo>
                  <a:pt x="1319" y="543315"/>
                  <a:pt x="4382" y="549720"/>
                  <a:pt x="0" y="536575"/>
                </a:cubicBezTo>
                <a:cubicBezTo>
                  <a:pt x="1058" y="516467"/>
                  <a:pt x="1569" y="496322"/>
                  <a:pt x="3175" y="476250"/>
                </a:cubicBezTo>
                <a:cubicBezTo>
                  <a:pt x="3824" y="468135"/>
                  <a:pt x="8085" y="445073"/>
                  <a:pt x="12700" y="438150"/>
                </a:cubicBezTo>
                <a:cubicBezTo>
                  <a:pt x="14817" y="434975"/>
                  <a:pt x="16178" y="431138"/>
                  <a:pt x="19050" y="428625"/>
                </a:cubicBezTo>
                <a:cubicBezTo>
                  <a:pt x="24793" y="423599"/>
                  <a:pt x="31750" y="420158"/>
                  <a:pt x="38100" y="415925"/>
                </a:cubicBezTo>
                <a:cubicBezTo>
                  <a:pt x="41275" y="413808"/>
                  <a:pt x="44005" y="410782"/>
                  <a:pt x="47625" y="409575"/>
                </a:cubicBezTo>
                <a:lnTo>
                  <a:pt x="76200" y="400050"/>
                </a:lnTo>
                <a:cubicBezTo>
                  <a:pt x="79375" y="398992"/>
                  <a:pt x="82478" y="397687"/>
                  <a:pt x="85725" y="396875"/>
                </a:cubicBezTo>
                <a:lnTo>
                  <a:pt x="98425" y="393700"/>
                </a:lnTo>
                <a:cubicBezTo>
                  <a:pt x="143933" y="394758"/>
                  <a:pt x="189526" y="393913"/>
                  <a:pt x="234950" y="396875"/>
                </a:cubicBezTo>
                <a:cubicBezTo>
                  <a:pt x="238758" y="397123"/>
                  <a:pt x="241962" y="400353"/>
                  <a:pt x="244475" y="403225"/>
                </a:cubicBezTo>
                <a:cubicBezTo>
                  <a:pt x="267834" y="429921"/>
                  <a:pt x="250902" y="412903"/>
                  <a:pt x="260350" y="431800"/>
                </a:cubicBezTo>
                <a:cubicBezTo>
                  <a:pt x="262057" y="435213"/>
                  <a:pt x="264993" y="437912"/>
                  <a:pt x="266700" y="441325"/>
                </a:cubicBezTo>
                <a:cubicBezTo>
                  <a:pt x="268197" y="444318"/>
                  <a:pt x="268250" y="447924"/>
                  <a:pt x="269875" y="450850"/>
                </a:cubicBezTo>
                <a:cubicBezTo>
                  <a:pt x="273581" y="457521"/>
                  <a:pt x="280162" y="462660"/>
                  <a:pt x="282575" y="469900"/>
                </a:cubicBezTo>
                <a:cubicBezTo>
                  <a:pt x="283633" y="473075"/>
                  <a:pt x="284253" y="476432"/>
                  <a:pt x="285750" y="479425"/>
                </a:cubicBezTo>
                <a:cubicBezTo>
                  <a:pt x="287457" y="482838"/>
                  <a:pt x="290550" y="485463"/>
                  <a:pt x="292100" y="488950"/>
                </a:cubicBezTo>
                <a:cubicBezTo>
                  <a:pt x="294818" y="495067"/>
                  <a:pt x="296333" y="501650"/>
                  <a:pt x="298450" y="508000"/>
                </a:cubicBezTo>
                <a:lnTo>
                  <a:pt x="301625" y="517525"/>
                </a:lnTo>
                <a:lnTo>
                  <a:pt x="304800" y="527050"/>
                </a:lnTo>
                <a:lnTo>
                  <a:pt x="307975" y="536575"/>
                </a:lnTo>
                <a:cubicBezTo>
                  <a:pt x="309033" y="553508"/>
                  <a:pt x="309374" y="570502"/>
                  <a:pt x="311150" y="587375"/>
                </a:cubicBezTo>
                <a:cubicBezTo>
                  <a:pt x="311500" y="590703"/>
                  <a:pt x="312234" y="594287"/>
                  <a:pt x="314325" y="596900"/>
                </a:cubicBezTo>
                <a:cubicBezTo>
                  <a:pt x="316709" y="599880"/>
                  <a:pt x="320675" y="601133"/>
                  <a:pt x="323850" y="603250"/>
                </a:cubicBezTo>
                <a:cubicBezTo>
                  <a:pt x="342900" y="602192"/>
                  <a:pt x="361992" y="601728"/>
                  <a:pt x="381000" y="600075"/>
                </a:cubicBezTo>
                <a:cubicBezTo>
                  <a:pt x="387181" y="599538"/>
                  <a:pt x="402939" y="595384"/>
                  <a:pt x="409575" y="593725"/>
                </a:cubicBezTo>
                <a:cubicBezTo>
                  <a:pt x="412750" y="591608"/>
                  <a:pt x="417078" y="590611"/>
                  <a:pt x="419100" y="587375"/>
                </a:cubicBezTo>
                <a:cubicBezTo>
                  <a:pt x="422321" y="582222"/>
                  <a:pt x="426766" y="563060"/>
                  <a:pt x="428625" y="555625"/>
                </a:cubicBezTo>
                <a:cubicBezTo>
                  <a:pt x="434768" y="475760"/>
                  <a:pt x="433845" y="505725"/>
                  <a:pt x="428625" y="377825"/>
                </a:cubicBezTo>
                <a:cubicBezTo>
                  <a:pt x="428362" y="371393"/>
                  <a:pt x="426713" y="365088"/>
                  <a:pt x="425450" y="358775"/>
                </a:cubicBezTo>
                <a:cubicBezTo>
                  <a:pt x="423051" y="346779"/>
                  <a:pt x="419975" y="339174"/>
                  <a:pt x="415925" y="327025"/>
                </a:cubicBezTo>
                <a:lnTo>
                  <a:pt x="412750" y="317500"/>
                </a:lnTo>
                <a:lnTo>
                  <a:pt x="409575" y="307975"/>
                </a:lnTo>
                <a:cubicBezTo>
                  <a:pt x="406453" y="283000"/>
                  <a:pt x="402492" y="264686"/>
                  <a:pt x="409575" y="238125"/>
                </a:cubicBezTo>
                <a:cubicBezTo>
                  <a:pt x="410437" y="234891"/>
                  <a:pt x="415925" y="236008"/>
                  <a:pt x="419100" y="234950"/>
                </a:cubicBezTo>
                <a:cubicBezTo>
                  <a:pt x="425450" y="237067"/>
                  <a:pt x="432581" y="237587"/>
                  <a:pt x="438150" y="241300"/>
                </a:cubicBezTo>
                <a:cubicBezTo>
                  <a:pt x="459985" y="255856"/>
                  <a:pt x="449960" y="251587"/>
                  <a:pt x="466725" y="257175"/>
                </a:cubicBezTo>
                <a:cubicBezTo>
                  <a:pt x="470958" y="263525"/>
                  <a:pt x="477012" y="268985"/>
                  <a:pt x="479425" y="276225"/>
                </a:cubicBezTo>
                <a:lnTo>
                  <a:pt x="485775" y="295275"/>
                </a:lnTo>
                <a:cubicBezTo>
                  <a:pt x="486833" y="298450"/>
                  <a:pt x="488138" y="301553"/>
                  <a:pt x="488950" y="304800"/>
                </a:cubicBezTo>
                <a:cubicBezTo>
                  <a:pt x="490008" y="309033"/>
                  <a:pt x="490871" y="313320"/>
                  <a:pt x="492125" y="317500"/>
                </a:cubicBezTo>
                <a:cubicBezTo>
                  <a:pt x="494048" y="323911"/>
                  <a:pt x="496358" y="330200"/>
                  <a:pt x="498475" y="336550"/>
                </a:cubicBezTo>
                <a:cubicBezTo>
                  <a:pt x="499533" y="339725"/>
                  <a:pt x="499283" y="343708"/>
                  <a:pt x="501650" y="346075"/>
                </a:cubicBezTo>
                <a:cubicBezTo>
                  <a:pt x="504825" y="349250"/>
                  <a:pt x="508300" y="352151"/>
                  <a:pt x="511175" y="355600"/>
                </a:cubicBezTo>
                <a:cubicBezTo>
                  <a:pt x="513618" y="358531"/>
                  <a:pt x="514653" y="362612"/>
                  <a:pt x="517525" y="365125"/>
                </a:cubicBezTo>
                <a:cubicBezTo>
                  <a:pt x="523268" y="370151"/>
                  <a:pt x="529335" y="375412"/>
                  <a:pt x="536575" y="377825"/>
                </a:cubicBezTo>
                <a:lnTo>
                  <a:pt x="555625" y="384175"/>
                </a:lnTo>
                <a:cubicBezTo>
                  <a:pt x="558800" y="385233"/>
                  <a:pt x="562365" y="385494"/>
                  <a:pt x="565150" y="387350"/>
                </a:cubicBezTo>
                <a:cubicBezTo>
                  <a:pt x="568325" y="389467"/>
                  <a:pt x="571262" y="391993"/>
                  <a:pt x="574675" y="393700"/>
                </a:cubicBezTo>
                <a:cubicBezTo>
                  <a:pt x="577668" y="395197"/>
                  <a:pt x="581274" y="395250"/>
                  <a:pt x="584200" y="396875"/>
                </a:cubicBezTo>
                <a:cubicBezTo>
                  <a:pt x="590871" y="400581"/>
                  <a:pt x="595846" y="407724"/>
                  <a:pt x="603250" y="409575"/>
                </a:cubicBezTo>
                <a:cubicBezTo>
                  <a:pt x="611717" y="411692"/>
                  <a:pt x="620371" y="413165"/>
                  <a:pt x="628650" y="415925"/>
                </a:cubicBezTo>
                <a:cubicBezTo>
                  <a:pt x="631825" y="416983"/>
                  <a:pt x="634957" y="418181"/>
                  <a:pt x="638175" y="419100"/>
                </a:cubicBezTo>
                <a:cubicBezTo>
                  <a:pt x="648637" y="422089"/>
                  <a:pt x="655838" y="423268"/>
                  <a:pt x="666750" y="425450"/>
                </a:cubicBezTo>
                <a:cubicBezTo>
                  <a:pt x="676275" y="424392"/>
                  <a:pt x="685853" y="423732"/>
                  <a:pt x="695325" y="422275"/>
                </a:cubicBezTo>
                <a:cubicBezTo>
                  <a:pt x="699638" y="421611"/>
                  <a:pt x="704394" y="421521"/>
                  <a:pt x="708025" y="419100"/>
                </a:cubicBezTo>
                <a:cubicBezTo>
                  <a:pt x="711200" y="416983"/>
                  <a:pt x="712825" y="413062"/>
                  <a:pt x="714375" y="409575"/>
                </a:cubicBezTo>
                <a:cubicBezTo>
                  <a:pt x="717093" y="403458"/>
                  <a:pt x="720725" y="390525"/>
                  <a:pt x="720725" y="390525"/>
                </a:cubicBezTo>
                <a:cubicBezTo>
                  <a:pt x="715081" y="373592"/>
                  <a:pt x="717903" y="388408"/>
                  <a:pt x="720725" y="371475"/>
                </a:cubicBezTo>
                <a:cubicBezTo>
                  <a:pt x="724215" y="350535"/>
                  <a:pt x="722179" y="344978"/>
                  <a:pt x="727075" y="327025"/>
                </a:cubicBezTo>
                <a:cubicBezTo>
                  <a:pt x="728836" y="320567"/>
                  <a:pt x="733425" y="307975"/>
                  <a:pt x="733425" y="307975"/>
                </a:cubicBezTo>
                <a:cubicBezTo>
                  <a:pt x="732367" y="285750"/>
                  <a:pt x="732098" y="263473"/>
                  <a:pt x="730250" y="241300"/>
                </a:cubicBezTo>
                <a:cubicBezTo>
                  <a:pt x="729452" y="231723"/>
                  <a:pt x="724845" y="230491"/>
                  <a:pt x="720725" y="222250"/>
                </a:cubicBezTo>
                <a:cubicBezTo>
                  <a:pt x="719228" y="219257"/>
                  <a:pt x="718362" y="215972"/>
                  <a:pt x="717550" y="212725"/>
                </a:cubicBezTo>
                <a:cubicBezTo>
                  <a:pt x="711003" y="186536"/>
                  <a:pt x="717719" y="206965"/>
                  <a:pt x="711200" y="184150"/>
                </a:cubicBezTo>
                <a:cubicBezTo>
                  <a:pt x="710281" y="180932"/>
                  <a:pt x="709522" y="177618"/>
                  <a:pt x="708025" y="174625"/>
                </a:cubicBezTo>
                <a:cubicBezTo>
                  <a:pt x="706318" y="171212"/>
                  <a:pt x="703382" y="168513"/>
                  <a:pt x="701675" y="165100"/>
                </a:cubicBezTo>
                <a:cubicBezTo>
                  <a:pt x="697840" y="157431"/>
                  <a:pt x="699733" y="152116"/>
                  <a:pt x="692150" y="146050"/>
                </a:cubicBezTo>
                <a:cubicBezTo>
                  <a:pt x="689537" y="143959"/>
                  <a:pt x="685800" y="143933"/>
                  <a:pt x="682625" y="142875"/>
                </a:cubicBezTo>
                <a:cubicBezTo>
                  <a:pt x="680508" y="139700"/>
                  <a:pt x="678973" y="136048"/>
                  <a:pt x="676275" y="133350"/>
                </a:cubicBezTo>
                <a:cubicBezTo>
                  <a:pt x="673577" y="130652"/>
                  <a:pt x="669263" y="129872"/>
                  <a:pt x="666750" y="127000"/>
                </a:cubicBezTo>
                <a:cubicBezTo>
                  <a:pt x="661724" y="121257"/>
                  <a:pt x="654050" y="107950"/>
                  <a:pt x="654050" y="107950"/>
                </a:cubicBezTo>
                <a:cubicBezTo>
                  <a:pt x="655108" y="92075"/>
                  <a:pt x="654975" y="76075"/>
                  <a:pt x="657225" y="60325"/>
                </a:cubicBezTo>
                <a:cubicBezTo>
                  <a:pt x="657617" y="57578"/>
                  <a:pt x="663946" y="35487"/>
                  <a:pt x="669925" y="31750"/>
                </a:cubicBezTo>
                <a:cubicBezTo>
                  <a:pt x="675601" y="28202"/>
                  <a:pt x="682481" y="27023"/>
                  <a:pt x="688975" y="25400"/>
                </a:cubicBezTo>
                <a:cubicBezTo>
                  <a:pt x="702644" y="21983"/>
                  <a:pt x="705156" y="20996"/>
                  <a:pt x="720725" y="19050"/>
                </a:cubicBezTo>
                <a:cubicBezTo>
                  <a:pt x="731279" y="17731"/>
                  <a:pt x="741892" y="16933"/>
                  <a:pt x="752475" y="15875"/>
                </a:cubicBezTo>
                <a:cubicBezTo>
                  <a:pt x="778889" y="7070"/>
                  <a:pt x="736797" y="20470"/>
                  <a:pt x="784225" y="9525"/>
                </a:cubicBezTo>
                <a:cubicBezTo>
                  <a:pt x="790747" y="8020"/>
                  <a:pt x="796781" y="4798"/>
                  <a:pt x="803275" y="3175"/>
                </a:cubicBezTo>
                <a:lnTo>
                  <a:pt x="815975" y="0"/>
                </a:lnTo>
                <a:cubicBezTo>
                  <a:pt x="833724" y="1479"/>
                  <a:pt x="852473" y="1584"/>
                  <a:pt x="869950" y="6350"/>
                </a:cubicBezTo>
                <a:cubicBezTo>
                  <a:pt x="876408" y="8111"/>
                  <a:pt x="883431" y="8987"/>
                  <a:pt x="889000" y="12700"/>
                </a:cubicBezTo>
                <a:lnTo>
                  <a:pt x="908050" y="25400"/>
                </a:lnTo>
                <a:cubicBezTo>
                  <a:pt x="911225" y="27517"/>
                  <a:pt x="913955" y="30543"/>
                  <a:pt x="917575" y="31750"/>
                </a:cubicBezTo>
                <a:lnTo>
                  <a:pt x="936625" y="38100"/>
                </a:lnTo>
                <a:cubicBezTo>
                  <a:pt x="939800" y="39158"/>
                  <a:pt x="943365" y="39419"/>
                  <a:pt x="946150" y="41275"/>
                </a:cubicBezTo>
                <a:lnTo>
                  <a:pt x="955675" y="47625"/>
                </a:lnTo>
                <a:cubicBezTo>
                  <a:pt x="970492" y="69850"/>
                  <a:pt x="962025" y="62442"/>
                  <a:pt x="977900" y="73025"/>
                </a:cubicBezTo>
                <a:cubicBezTo>
                  <a:pt x="980017" y="76200"/>
                  <a:pt x="981378" y="80037"/>
                  <a:pt x="984250" y="82550"/>
                </a:cubicBezTo>
                <a:lnTo>
                  <a:pt x="1012825" y="101600"/>
                </a:lnTo>
                <a:lnTo>
                  <a:pt x="1022350" y="107950"/>
                </a:lnTo>
                <a:lnTo>
                  <a:pt x="1031875" y="114300"/>
                </a:lnTo>
                <a:cubicBezTo>
                  <a:pt x="1046077" y="135602"/>
                  <a:pt x="1029347" y="114731"/>
                  <a:pt x="1047750" y="127000"/>
                </a:cubicBezTo>
                <a:cubicBezTo>
                  <a:pt x="1062704" y="136969"/>
                  <a:pt x="1051218" y="135950"/>
                  <a:pt x="1066800" y="142875"/>
                </a:cubicBezTo>
                <a:cubicBezTo>
                  <a:pt x="1072917" y="145593"/>
                  <a:pt x="1085850" y="149225"/>
                  <a:pt x="1085850" y="149225"/>
                </a:cubicBezTo>
                <a:cubicBezTo>
                  <a:pt x="1108075" y="148167"/>
                  <a:pt x="1130411" y="148507"/>
                  <a:pt x="1152525" y="146050"/>
                </a:cubicBezTo>
                <a:cubicBezTo>
                  <a:pt x="1159178" y="145311"/>
                  <a:pt x="1164973" y="140800"/>
                  <a:pt x="1171575" y="139700"/>
                </a:cubicBezTo>
                <a:lnTo>
                  <a:pt x="1190625" y="136525"/>
                </a:lnTo>
                <a:lnTo>
                  <a:pt x="1238250" y="139700"/>
                </a:lnTo>
                <a:cubicBezTo>
                  <a:pt x="1270561" y="142285"/>
                  <a:pt x="1260781" y="139802"/>
                  <a:pt x="1279525" y="146050"/>
                </a:cubicBezTo>
                <a:lnTo>
                  <a:pt x="1295400" y="193675"/>
                </a:lnTo>
                <a:lnTo>
                  <a:pt x="1298575" y="203200"/>
                </a:lnTo>
                <a:cubicBezTo>
                  <a:pt x="1299633" y="206375"/>
                  <a:pt x="1299894" y="209940"/>
                  <a:pt x="1301750" y="212725"/>
                </a:cubicBezTo>
                <a:cubicBezTo>
                  <a:pt x="1303867" y="215900"/>
                  <a:pt x="1306393" y="218837"/>
                  <a:pt x="1308100" y="222250"/>
                </a:cubicBezTo>
                <a:cubicBezTo>
                  <a:pt x="1309597" y="225243"/>
                  <a:pt x="1309778" y="228782"/>
                  <a:pt x="1311275" y="231775"/>
                </a:cubicBezTo>
                <a:cubicBezTo>
                  <a:pt x="1312982" y="235188"/>
                  <a:pt x="1315090" y="238448"/>
                  <a:pt x="1317625" y="241300"/>
                </a:cubicBezTo>
                <a:cubicBezTo>
                  <a:pt x="1323591" y="248012"/>
                  <a:pt x="1336675" y="260350"/>
                  <a:pt x="1336675" y="260350"/>
                </a:cubicBezTo>
                <a:cubicBezTo>
                  <a:pt x="1342856" y="278893"/>
                  <a:pt x="1335014" y="261864"/>
                  <a:pt x="1349375" y="276225"/>
                </a:cubicBezTo>
                <a:cubicBezTo>
                  <a:pt x="1370542" y="297392"/>
                  <a:pt x="1339850" y="275167"/>
                  <a:pt x="1365250" y="292100"/>
                </a:cubicBezTo>
                <a:cubicBezTo>
                  <a:pt x="1375470" y="322761"/>
                  <a:pt x="1359082" y="275091"/>
                  <a:pt x="1374775" y="314325"/>
                </a:cubicBezTo>
                <a:cubicBezTo>
                  <a:pt x="1377261" y="320540"/>
                  <a:pt x="1379008" y="327025"/>
                  <a:pt x="1381125" y="333375"/>
                </a:cubicBezTo>
                <a:lnTo>
                  <a:pt x="1387475" y="352425"/>
                </a:lnTo>
                <a:cubicBezTo>
                  <a:pt x="1388533" y="355600"/>
                  <a:pt x="1389838" y="358703"/>
                  <a:pt x="1390650" y="361950"/>
                </a:cubicBezTo>
                <a:cubicBezTo>
                  <a:pt x="1391708" y="366183"/>
                  <a:pt x="1392626" y="370454"/>
                  <a:pt x="1393825" y="374650"/>
                </a:cubicBezTo>
                <a:cubicBezTo>
                  <a:pt x="1396179" y="382890"/>
                  <a:pt x="1402519" y="400831"/>
                  <a:pt x="1409700" y="403225"/>
                </a:cubicBezTo>
                <a:lnTo>
                  <a:pt x="1438275" y="412750"/>
                </a:lnTo>
                <a:lnTo>
                  <a:pt x="1447800" y="415925"/>
                </a:lnTo>
                <a:cubicBezTo>
                  <a:pt x="1449917" y="419100"/>
                  <a:pt x="1450914" y="423428"/>
                  <a:pt x="1454150" y="425450"/>
                </a:cubicBezTo>
                <a:cubicBezTo>
                  <a:pt x="1459826" y="428998"/>
                  <a:pt x="1473200" y="431800"/>
                  <a:pt x="1473200" y="431800"/>
                </a:cubicBezTo>
                <a:cubicBezTo>
                  <a:pt x="1479550" y="430742"/>
                  <a:pt x="1485877" y="429535"/>
                  <a:pt x="1492250" y="428625"/>
                </a:cubicBezTo>
                <a:cubicBezTo>
                  <a:pt x="1500697" y="427418"/>
                  <a:pt x="1509255" y="426976"/>
                  <a:pt x="1517650" y="425450"/>
                </a:cubicBezTo>
                <a:cubicBezTo>
                  <a:pt x="1530191" y="423170"/>
                  <a:pt x="1525079" y="421735"/>
                  <a:pt x="1536700" y="415925"/>
                </a:cubicBezTo>
                <a:cubicBezTo>
                  <a:pt x="1546397" y="411077"/>
                  <a:pt x="1550544" y="412750"/>
                  <a:pt x="1562100" y="412750"/>
                </a:cubicBezTo>
              </a:path>
            </a:pathLst>
          </a:custGeom>
          <a:ln w="6350" cmpd="sng">
            <a:solidFill>
              <a:srgbClr val="FFFFFF"/>
            </a:solidFill>
            <a:prstDash val="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9042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58</Words>
  <Application>Microsoft Macintosh PowerPoint</Application>
  <PresentationFormat>A4 Paper (210x297 mm)</PresentationFormat>
  <Paragraphs>2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ept. de Pathologi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y Palmer</dc:creator>
  <cp:lastModifiedBy>Gaby Palmer</cp:lastModifiedBy>
  <cp:revision>41</cp:revision>
  <dcterms:created xsi:type="dcterms:W3CDTF">2019-06-06T13:32:21Z</dcterms:created>
  <dcterms:modified xsi:type="dcterms:W3CDTF">2019-10-10T11:53:59Z</dcterms:modified>
</cp:coreProperties>
</file>